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380"/>
    <p:restoredTop sz="94660"/>
  </p:normalViewPr>
  <p:slideViewPr>
    <p:cSldViewPr>
      <p:cViewPr>
        <p:scale>
          <a:sx n="81" d="100"/>
          <a:sy n="81" d="100"/>
        </p:scale>
        <p:origin x="-834" y="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idont\Documents\PhD\EJP%20manuscript\EJP%20methylation%20BMI%20correlation%20cv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idont\Documents\PhD\EJP%20manuscript\EJP%20methylation%20BMI%20correlation%20cv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idont\Documents\PhD\EJP%20manuscript\EJP%20methylation%20BMI%20correlation%20cv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rtl="0">
              <a:defRPr sz="1600"/>
            </a:pPr>
            <a:r>
              <a:rPr lang="en-US" sz="1600"/>
              <a:t>Methylation and BMI - all</a:t>
            </a:r>
          </a:p>
        </c:rich>
      </c:tx>
      <c:layout>
        <c:manualLayout>
          <c:xMode val="edge"/>
          <c:yMode val="edge"/>
          <c:x val="0.26630565823093288"/>
          <c:y val="2.7777777777777776E-2"/>
        </c:manualLayout>
      </c:layout>
      <c:overlay val="1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dispRSqr val="0"/>
            <c:dispEq val="0"/>
          </c:trendline>
          <c:xVal>
            <c:numRef>
              <c:f>'[SJ database FTO methylation analysis2.xlsx]age,lym'!$D$2:$D$930</c:f>
              <c:numCache>
                <c:formatCode>General</c:formatCode>
                <c:ptCount val="929"/>
                <c:pt idx="0">
                  <c:v>32.43</c:v>
                </c:pt>
                <c:pt idx="1">
                  <c:v>30.11</c:v>
                </c:pt>
                <c:pt idx="2">
                  <c:v>28.43</c:v>
                </c:pt>
                <c:pt idx="3">
                  <c:v>26.66</c:v>
                </c:pt>
                <c:pt idx="4">
                  <c:v>23.22</c:v>
                </c:pt>
                <c:pt idx="5">
                  <c:v>29.82</c:v>
                </c:pt>
                <c:pt idx="6">
                  <c:v>34.450000000000003</c:v>
                </c:pt>
                <c:pt idx="7">
                  <c:v>43.44</c:v>
                </c:pt>
                <c:pt idx="8">
                  <c:v>25.49</c:v>
                </c:pt>
                <c:pt idx="9">
                  <c:v>21.14</c:v>
                </c:pt>
                <c:pt idx="10">
                  <c:v>29.22</c:v>
                </c:pt>
                <c:pt idx="11">
                  <c:v>28.76</c:v>
                </c:pt>
                <c:pt idx="12">
                  <c:v>30.15</c:v>
                </c:pt>
                <c:pt idx="13">
                  <c:v>18.04</c:v>
                </c:pt>
                <c:pt idx="14">
                  <c:v>18.97</c:v>
                </c:pt>
                <c:pt idx="15">
                  <c:v>27.02</c:v>
                </c:pt>
                <c:pt idx="16">
                  <c:v>32.14</c:v>
                </c:pt>
                <c:pt idx="17">
                  <c:v>37.299999999999997</c:v>
                </c:pt>
                <c:pt idx="18">
                  <c:v>31.78</c:v>
                </c:pt>
                <c:pt idx="19">
                  <c:v>27.79</c:v>
                </c:pt>
                <c:pt idx="20">
                  <c:v>22.22</c:v>
                </c:pt>
                <c:pt idx="21">
                  <c:v>25.39</c:v>
                </c:pt>
                <c:pt idx="22">
                  <c:v>32.67</c:v>
                </c:pt>
                <c:pt idx="23">
                  <c:v>25.76</c:v>
                </c:pt>
                <c:pt idx="24">
                  <c:v>33.770000000000003</c:v>
                </c:pt>
                <c:pt idx="25">
                  <c:v>24.31</c:v>
                </c:pt>
                <c:pt idx="26">
                  <c:v>26.89</c:v>
                </c:pt>
                <c:pt idx="27">
                  <c:v>27.39</c:v>
                </c:pt>
                <c:pt idx="28">
                  <c:v>22.31</c:v>
                </c:pt>
                <c:pt idx="29">
                  <c:v>28.5</c:v>
                </c:pt>
                <c:pt idx="30">
                  <c:v>24.99</c:v>
                </c:pt>
                <c:pt idx="31">
                  <c:v>26.37</c:v>
                </c:pt>
                <c:pt idx="32">
                  <c:v>26.41</c:v>
                </c:pt>
                <c:pt idx="33">
                  <c:v>30.92</c:v>
                </c:pt>
                <c:pt idx="34">
                  <c:v>25.59</c:v>
                </c:pt>
                <c:pt idx="35">
                  <c:v>42.08</c:v>
                </c:pt>
                <c:pt idx="36">
                  <c:v>23.92</c:v>
                </c:pt>
                <c:pt idx="37">
                  <c:v>24.89</c:v>
                </c:pt>
                <c:pt idx="38">
                  <c:v>30.38</c:v>
                </c:pt>
                <c:pt idx="39">
                  <c:v>28</c:v>
                </c:pt>
                <c:pt idx="40">
                  <c:v>27.98</c:v>
                </c:pt>
                <c:pt idx="41">
                  <c:v>32.880000000000003</c:v>
                </c:pt>
                <c:pt idx="42">
                  <c:v>26.75</c:v>
                </c:pt>
                <c:pt idx="43">
                  <c:v>18.27</c:v>
                </c:pt>
                <c:pt idx="44">
                  <c:v>20.85</c:v>
                </c:pt>
                <c:pt idx="45">
                  <c:v>33.11</c:v>
                </c:pt>
                <c:pt idx="46">
                  <c:v>28.99</c:v>
                </c:pt>
                <c:pt idx="47">
                  <c:v>23.05</c:v>
                </c:pt>
                <c:pt idx="48">
                  <c:v>33.35</c:v>
                </c:pt>
                <c:pt idx="49">
                  <c:v>28.36</c:v>
                </c:pt>
                <c:pt idx="50">
                  <c:v>28.38</c:v>
                </c:pt>
                <c:pt idx="51">
                  <c:v>23.16</c:v>
                </c:pt>
                <c:pt idx="52">
                  <c:v>34.24</c:v>
                </c:pt>
                <c:pt idx="53">
                  <c:v>42.46</c:v>
                </c:pt>
                <c:pt idx="54">
                  <c:v>19.72</c:v>
                </c:pt>
                <c:pt idx="55">
                  <c:v>31.27</c:v>
                </c:pt>
                <c:pt idx="56">
                  <c:v>30.33</c:v>
                </c:pt>
                <c:pt idx="57">
                  <c:v>25.37</c:v>
                </c:pt>
                <c:pt idx="58">
                  <c:v>26.43</c:v>
                </c:pt>
                <c:pt idx="59">
                  <c:v>22.66</c:v>
                </c:pt>
                <c:pt idx="60">
                  <c:v>23.85</c:v>
                </c:pt>
                <c:pt idx="61">
                  <c:v>19.54</c:v>
                </c:pt>
                <c:pt idx="62">
                  <c:v>19.03</c:v>
                </c:pt>
                <c:pt idx="63">
                  <c:v>24.54</c:v>
                </c:pt>
                <c:pt idx="64">
                  <c:v>21.21</c:v>
                </c:pt>
                <c:pt idx="65">
                  <c:v>28.61</c:v>
                </c:pt>
                <c:pt idx="66">
                  <c:v>40.46</c:v>
                </c:pt>
                <c:pt idx="67">
                  <c:v>23.46</c:v>
                </c:pt>
                <c:pt idx="68">
                  <c:v>25.84</c:v>
                </c:pt>
                <c:pt idx="69">
                  <c:v>24.8</c:v>
                </c:pt>
                <c:pt idx="70">
                  <c:v>27.51</c:v>
                </c:pt>
                <c:pt idx="71">
                  <c:v>26.24</c:v>
                </c:pt>
                <c:pt idx="72">
                  <c:v>26.71</c:v>
                </c:pt>
                <c:pt idx="73">
                  <c:v>24.89</c:v>
                </c:pt>
                <c:pt idx="74">
                  <c:v>28.63</c:v>
                </c:pt>
                <c:pt idx="75">
                  <c:v>19.96</c:v>
                </c:pt>
                <c:pt idx="76">
                  <c:v>44.3</c:v>
                </c:pt>
                <c:pt idx="77">
                  <c:v>27.93</c:v>
                </c:pt>
                <c:pt idx="78">
                  <c:v>27.16</c:v>
                </c:pt>
                <c:pt idx="79">
                  <c:v>24.62</c:v>
                </c:pt>
                <c:pt idx="80">
                  <c:v>36.75</c:v>
                </c:pt>
                <c:pt idx="81">
                  <c:v>22.97</c:v>
                </c:pt>
                <c:pt idx="82">
                  <c:v>20.62</c:v>
                </c:pt>
                <c:pt idx="83">
                  <c:v>21.6</c:v>
                </c:pt>
                <c:pt idx="84">
                  <c:v>26.31</c:v>
                </c:pt>
                <c:pt idx="85">
                  <c:v>29.62</c:v>
                </c:pt>
                <c:pt idx="86">
                  <c:v>39.47</c:v>
                </c:pt>
                <c:pt idx="87">
                  <c:v>29.58</c:v>
                </c:pt>
                <c:pt idx="88">
                  <c:v>19.600000000000001</c:v>
                </c:pt>
                <c:pt idx="89">
                  <c:v>22.91</c:v>
                </c:pt>
                <c:pt idx="90">
                  <c:v>26.12</c:v>
                </c:pt>
                <c:pt idx="91">
                  <c:v>25.3</c:v>
                </c:pt>
                <c:pt idx="92">
                  <c:v>30.12</c:v>
                </c:pt>
                <c:pt idx="93">
                  <c:v>31.75</c:v>
                </c:pt>
                <c:pt idx="94">
                  <c:v>35.28</c:v>
                </c:pt>
                <c:pt idx="95">
                  <c:v>20.93</c:v>
                </c:pt>
                <c:pt idx="96">
                  <c:v>23.01</c:v>
                </c:pt>
                <c:pt idx="97">
                  <c:v>28.69</c:v>
                </c:pt>
                <c:pt idx="98">
                  <c:v>22.76</c:v>
                </c:pt>
                <c:pt idx="99">
                  <c:v>27.81</c:v>
                </c:pt>
                <c:pt idx="100">
                  <c:v>28.33</c:v>
                </c:pt>
                <c:pt idx="101">
                  <c:v>28.56</c:v>
                </c:pt>
                <c:pt idx="102">
                  <c:v>31.82</c:v>
                </c:pt>
                <c:pt idx="103">
                  <c:v>21.47</c:v>
                </c:pt>
                <c:pt idx="104">
                  <c:v>24.62</c:v>
                </c:pt>
                <c:pt idx="105">
                  <c:v>23.4</c:v>
                </c:pt>
                <c:pt idx="106">
                  <c:v>20.5</c:v>
                </c:pt>
                <c:pt idx="107">
                  <c:v>21.23</c:v>
                </c:pt>
                <c:pt idx="108">
                  <c:v>33.299999999999997</c:v>
                </c:pt>
                <c:pt idx="109">
                  <c:v>34.42</c:v>
                </c:pt>
                <c:pt idx="110">
                  <c:v>24.54</c:v>
                </c:pt>
                <c:pt idx="111">
                  <c:v>39.43</c:v>
                </c:pt>
                <c:pt idx="112">
                  <c:v>22.48</c:v>
                </c:pt>
                <c:pt idx="113">
                  <c:v>32.869999999999997</c:v>
                </c:pt>
                <c:pt idx="114">
                  <c:v>24.32</c:v>
                </c:pt>
                <c:pt idx="115">
                  <c:v>36.25</c:v>
                </c:pt>
                <c:pt idx="116">
                  <c:v>27.71</c:v>
                </c:pt>
                <c:pt idx="117">
                  <c:v>21.2</c:v>
                </c:pt>
                <c:pt idx="118">
                  <c:v>26.99</c:v>
                </c:pt>
                <c:pt idx="119">
                  <c:v>26.45</c:v>
                </c:pt>
                <c:pt idx="120">
                  <c:v>23.33</c:v>
                </c:pt>
                <c:pt idx="121">
                  <c:v>24.62</c:v>
                </c:pt>
                <c:pt idx="122">
                  <c:v>18.43</c:v>
                </c:pt>
                <c:pt idx="123">
                  <c:v>28.77</c:v>
                </c:pt>
                <c:pt idx="124">
                  <c:v>29.48</c:v>
                </c:pt>
                <c:pt idx="125">
                  <c:v>25.19</c:v>
                </c:pt>
                <c:pt idx="126">
                  <c:v>25.8</c:v>
                </c:pt>
                <c:pt idx="127">
                  <c:v>24.72</c:v>
                </c:pt>
                <c:pt idx="128">
                  <c:v>27.12</c:v>
                </c:pt>
                <c:pt idx="129">
                  <c:v>24.92</c:v>
                </c:pt>
                <c:pt idx="130">
                  <c:v>27.04</c:v>
                </c:pt>
                <c:pt idx="131">
                  <c:v>28.7</c:v>
                </c:pt>
                <c:pt idx="132">
                  <c:v>31.4</c:v>
                </c:pt>
                <c:pt idx="133">
                  <c:v>25.15</c:v>
                </c:pt>
                <c:pt idx="134">
                  <c:v>43.36</c:v>
                </c:pt>
                <c:pt idx="135">
                  <c:v>19.64</c:v>
                </c:pt>
                <c:pt idx="136">
                  <c:v>31.79</c:v>
                </c:pt>
                <c:pt idx="137">
                  <c:v>31.8</c:v>
                </c:pt>
                <c:pt idx="138">
                  <c:v>34.79</c:v>
                </c:pt>
                <c:pt idx="139">
                  <c:v>31.82</c:v>
                </c:pt>
                <c:pt idx="140">
                  <c:v>26.63</c:v>
                </c:pt>
                <c:pt idx="141">
                  <c:v>22.64</c:v>
                </c:pt>
                <c:pt idx="142">
                  <c:v>20.87</c:v>
                </c:pt>
                <c:pt idx="143">
                  <c:v>23.91</c:v>
                </c:pt>
                <c:pt idx="144">
                  <c:v>24.37</c:v>
                </c:pt>
                <c:pt idx="145">
                  <c:v>18.87</c:v>
                </c:pt>
                <c:pt idx="146">
                  <c:v>32.28</c:v>
                </c:pt>
                <c:pt idx="147">
                  <c:v>27.39</c:v>
                </c:pt>
                <c:pt idx="148">
                  <c:v>32.53</c:v>
                </c:pt>
                <c:pt idx="149">
                  <c:v>26.39</c:v>
                </c:pt>
                <c:pt idx="150">
                  <c:v>30.94</c:v>
                </c:pt>
                <c:pt idx="151">
                  <c:v>26.31</c:v>
                </c:pt>
                <c:pt idx="152">
                  <c:v>24.13</c:v>
                </c:pt>
                <c:pt idx="153">
                  <c:v>43.74</c:v>
                </c:pt>
                <c:pt idx="154">
                  <c:v>23.12</c:v>
                </c:pt>
                <c:pt idx="155">
                  <c:v>24.57</c:v>
                </c:pt>
                <c:pt idx="156">
                  <c:v>20.92</c:v>
                </c:pt>
                <c:pt idx="157">
                  <c:v>25.93</c:v>
                </c:pt>
                <c:pt idx="158">
                  <c:v>28.05</c:v>
                </c:pt>
                <c:pt idx="159">
                  <c:v>32.26</c:v>
                </c:pt>
                <c:pt idx="160">
                  <c:v>28.59</c:v>
                </c:pt>
                <c:pt idx="161">
                  <c:v>42.66</c:v>
                </c:pt>
                <c:pt idx="162">
                  <c:v>35.71</c:v>
                </c:pt>
                <c:pt idx="163">
                  <c:v>20.99</c:v>
                </c:pt>
                <c:pt idx="164">
                  <c:v>20.32</c:v>
                </c:pt>
                <c:pt idx="165">
                  <c:v>45.1</c:v>
                </c:pt>
                <c:pt idx="166">
                  <c:v>18.010000000000002</c:v>
                </c:pt>
                <c:pt idx="167">
                  <c:v>27.35</c:v>
                </c:pt>
                <c:pt idx="168">
                  <c:v>22.92</c:v>
                </c:pt>
                <c:pt idx="169">
                  <c:v>36.68</c:v>
                </c:pt>
                <c:pt idx="170">
                  <c:v>27.96</c:v>
                </c:pt>
                <c:pt idx="171">
                  <c:v>40.31</c:v>
                </c:pt>
                <c:pt idx="172">
                  <c:v>24.51</c:v>
                </c:pt>
                <c:pt idx="173">
                  <c:v>30.97</c:v>
                </c:pt>
                <c:pt idx="174">
                  <c:v>25</c:v>
                </c:pt>
                <c:pt idx="175">
                  <c:v>37.270000000000003</c:v>
                </c:pt>
                <c:pt idx="176">
                  <c:v>29.06</c:v>
                </c:pt>
                <c:pt idx="177">
                  <c:v>30.44</c:v>
                </c:pt>
                <c:pt idx="178">
                  <c:v>27.76</c:v>
                </c:pt>
                <c:pt idx="179">
                  <c:v>20.07</c:v>
                </c:pt>
                <c:pt idx="180">
                  <c:v>22.8</c:v>
                </c:pt>
                <c:pt idx="181">
                  <c:v>19.899999999999999</c:v>
                </c:pt>
                <c:pt idx="182">
                  <c:v>30.71</c:v>
                </c:pt>
                <c:pt idx="183">
                  <c:v>32.799999999999997</c:v>
                </c:pt>
                <c:pt idx="184">
                  <c:v>39.35</c:v>
                </c:pt>
                <c:pt idx="185">
                  <c:v>29.21</c:v>
                </c:pt>
                <c:pt idx="186">
                  <c:v>28.08</c:v>
                </c:pt>
                <c:pt idx="187">
                  <c:v>25.67</c:v>
                </c:pt>
                <c:pt idx="188">
                  <c:v>23.28</c:v>
                </c:pt>
                <c:pt idx="189">
                  <c:v>35.659999999999997</c:v>
                </c:pt>
                <c:pt idx="190">
                  <c:v>27.49</c:v>
                </c:pt>
                <c:pt idx="191">
                  <c:v>32.590000000000003</c:v>
                </c:pt>
                <c:pt idx="192">
                  <c:v>32.090000000000003</c:v>
                </c:pt>
                <c:pt idx="193">
                  <c:v>27.86</c:v>
                </c:pt>
                <c:pt idx="194">
                  <c:v>37.869999999999997</c:v>
                </c:pt>
                <c:pt idx="195">
                  <c:v>18.86</c:v>
                </c:pt>
                <c:pt idx="196">
                  <c:v>40.06</c:v>
                </c:pt>
                <c:pt idx="197">
                  <c:v>26.13</c:v>
                </c:pt>
                <c:pt idx="198">
                  <c:v>22.87</c:v>
                </c:pt>
                <c:pt idx="199">
                  <c:v>16.600000000000001</c:v>
                </c:pt>
                <c:pt idx="200">
                  <c:v>24.45</c:v>
                </c:pt>
                <c:pt idx="201">
                  <c:v>28.96</c:v>
                </c:pt>
                <c:pt idx="202">
                  <c:v>34</c:v>
                </c:pt>
                <c:pt idx="203">
                  <c:v>26.54</c:v>
                </c:pt>
                <c:pt idx="204">
                  <c:v>29.74</c:v>
                </c:pt>
                <c:pt idx="205">
                  <c:v>34.78</c:v>
                </c:pt>
                <c:pt idx="206">
                  <c:v>24.78</c:v>
                </c:pt>
                <c:pt idx="207">
                  <c:v>20.3</c:v>
                </c:pt>
                <c:pt idx="208">
                  <c:v>28.92</c:v>
                </c:pt>
                <c:pt idx="209">
                  <c:v>26.07</c:v>
                </c:pt>
                <c:pt idx="210">
                  <c:v>31.5</c:v>
                </c:pt>
                <c:pt idx="211">
                  <c:v>27.64</c:v>
                </c:pt>
                <c:pt idx="212">
                  <c:v>33.86</c:v>
                </c:pt>
                <c:pt idx="213">
                  <c:v>28.23</c:v>
                </c:pt>
                <c:pt idx="214">
                  <c:v>27.5</c:v>
                </c:pt>
                <c:pt idx="215">
                  <c:v>33.29</c:v>
                </c:pt>
                <c:pt idx="216">
                  <c:v>26.42</c:v>
                </c:pt>
                <c:pt idx="217">
                  <c:v>36.979999999999997</c:v>
                </c:pt>
                <c:pt idx="218">
                  <c:v>20.68</c:v>
                </c:pt>
                <c:pt idx="219">
                  <c:v>34.200000000000003</c:v>
                </c:pt>
                <c:pt idx="220">
                  <c:v>24.94</c:v>
                </c:pt>
                <c:pt idx="221">
                  <c:v>29.37</c:v>
                </c:pt>
                <c:pt idx="222">
                  <c:v>25.55</c:v>
                </c:pt>
                <c:pt idx="223">
                  <c:v>24.41</c:v>
                </c:pt>
                <c:pt idx="224">
                  <c:v>26.39</c:v>
                </c:pt>
                <c:pt idx="225">
                  <c:v>38.14</c:v>
                </c:pt>
                <c:pt idx="226">
                  <c:v>22.49</c:v>
                </c:pt>
                <c:pt idx="227">
                  <c:v>34.53</c:v>
                </c:pt>
                <c:pt idx="228">
                  <c:v>30.18</c:v>
                </c:pt>
                <c:pt idx="229">
                  <c:v>22.6</c:v>
                </c:pt>
                <c:pt idx="230">
                  <c:v>23.08</c:v>
                </c:pt>
                <c:pt idx="231">
                  <c:v>24.46</c:v>
                </c:pt>
                <c:pt idx="232">
                  <c:v>27.16</c:v>
                </c:pt>
                <c:pt idx="233">
                  <c:v>18</c:v>
                </c:pt>
                <c:pt idx="234">
                  <c:v>27.4</c:v>
                </c:pt>
                <c:pt idx="235">
                  <c:v>24.33</c:v>
                </c:pt>
                <c:pt idx="236">
                  <c:v>34.51</c:v>
                </c:pt>
                <c:pt idx="237">
                  <c:v>17.670000000000002</c:v>
                </c:pt>
                <c:pt idx="238">
                  <c:v>28.35</c:v>
                </c:pt>
                <c:pt idx="239">
                  <c:v>27.9</c:v>
                </c:pt>
                <c:pt idx="240">
                  <c:v>25.62</c:v>
                </c:pt>
                <c:pt idx="241">
                  <c:v>29.31</c:v>
                </c:pt>
                <c:pt idx="242">
                  <c:v>21.17</c:v>
                </c:pt>
                <c:pt idx="243">
                  <c:v>25.65</c:v>
                </c:pt>
                <c:pt idx="244">
                  <c:v>20.72</c:v>
                </c:pt>
                <c:pt idx="245">
                  <c:v>20.66</c:v>
                </c:pt>
                <c:pt idx="246">
                  <c:v>27.39</c:v>
                </c:pt>
                <c:pt idx="247">
                  <c:v>33.08</c:v>
                </c:pt>
                <c:pt idx="248">
                  <c:v>28.76</c:v>
                </c:pt>
                <c:pt idx="249">
                  <c:v>25.11</c:v>
                </c:pt>
                <c:pt idx="250">
                  <c:v>28.97</c:v>
                </c:pt>
                <c:pt idx="251">
                  <c:v>29.97</c:v>
                </c:pt>
                <c:pt idx="252">
                  <c:v>32.159999999999997</c:v>
                </c:pt>
                <c:pt idx="253">
                  <c:v>21.08</c:v>
                </c:pt>
                <c:pt idx="254">
                  <c:v>23.79</c:v>
                </c:pt>
                <c:pt idx="255">
                  <c:v>27.9</c:v>
                </c:pt>
                <c:pt idx="256">
                  <c:v>26.83</c:v>
                </c:pt>
                <c:pt idx="257">
                  <c:v>18.760000000000002</c:v>
                </c:pt>
                <c:pt idx="258">
                  <c:v>23.1</c:v>
                </c:pt>
                <c:pt idx="259">
                  <c:v>27.32</c:v>
                </c:pt>
                <c:pt idx="260">
                  <c:v>27.27</c:v>
                </c:pt>
                <c:pt idx="261">
                  <c:v>26.73</c:v>
                </c:pt>
                <c:pt idx="262">
                  <c:v>26.89</c:v>
                </c:pt>
                <c:pt idx="263">
                  <c:v>22.59</c:v>
                </c:pt>
                <c:pt idx="264">
                  <c:v>41.28</c:v>
                </c:pt>
                <c:pt idx="265">
                  <c:v>39.76</c:v>
                </c:pt>
                <c:pt idx="266">
                  <c:v>25.11</c:v>
                </c:pt>
                <c:pt idx="267">
                  <c:v>23.66</c:v>
                </c:pt>
                <c:pt idx="268">
                  <c:v>26.11</c:v>
                </c:pt>
                <c:pt idx="269">
                  <c:v>38.36</c:v>
                </c:pt>
                <c:pt idx="270">
                  <c:v>29.97</c:v>
                </c:pt>
                <c:pt idx="271">
                  <c:v>19.57</c:v>
                </c:pt>
                <c:pt idx="272">
                  <c:v>23.33</c:v>
                </c:pt>
                <c:pt idx="273">
                  <c:v>25.24</c:v>
                </c:pt>
                <c:pt idx="274">
                  <c:v>33.97</c:v>
                </c:pt>
                <c:pt idx="275">
                  <c:v>35.78</c:v>
                </c:pt>
                <c:pt idx="276">
                  <c:v>25.24</c:v>
                </c:pt>
                <c:pt idx="277">
                  <c:v>30.08</c:v>
                </c:pt>
                <c:pt idx="278">
                  <c:v>28.24</c:v>
                </c:pt>
                <c:pt idx="279">
                  <c:v>34.54</c:v>
                </c:pt>
                <c:pt idx="280">
                  <c:v>29</c:v>
                </c:pt>
                <c:pt idx="281">
                  <c:v>25.81</c:v>
                </c:pt>
                <c:pt idx="282">
                  <c:v>25</c:v>
                </c:pt>
                <c:pt idx="283">
                  <c:v>23.03</c:v>
                </c:pt>
                <c:pt idx="284">
                  <c:v>26.96</c:v>
                </c:pt>
                <c:pt idx="285">
                  <c:v>31.73</c:v>
                </c:pt>
                <c:pt idx="286">
                  <c:v>24.39</c:v>
                </c:pt>
                <c:pt idx="287">
                  <c:v>24.38</c:v>
                </c:pt>
                <c:pt idx="288">
                  <c:v>34.75</c:v>
                </c:pt>
                <c:pt idx="289">
                  <c:v>26.17</c:v>
                </c:pt>
                <c:pt idx="290">
                  <c:v>23.55</c:v>
                </c:pt>
                <c:pt idx="291">
                  <c:v>25.84</c:v>
                </c:pt>
                <c:pt idx="292">
                  <c:v>28.5</c:v>
                </c:pt>
                <c:pt idx="293">
                  <c:v>32.590000000000003</c:v>
                </c:pt>
                <c:pt idx="294">
                  <c:v>37.53</c:v>
                </c:pt>
                <c:pt idx="295">
                  <c:v>23.32</c:v>
                </c:pt>
                <c:pt idx="296">
                  <c:v>31.28</c:v>
                </c:pt>
                <c:pt idx="297">
                  <c:v>28.37</c:v>
                </c:pt>
                <c:pt idx="298">
                  <c:v>28.16</c:v>
                </c:pt>
                <c:pt idx="299">
                  <c:v>35.9</c:v>
                </c:pt>
                <c:pt idx="300">
                  <c:v>30.84</c:v>
                </c:pt>
                <c:pt idx="301">
                  <c:v>29.03</c:v>
                </c:pt>
                <c:pt idx="302">
                  <c:v>28.35</c:v>
                </c:pt>
                <c:pt idx="303">
                  <c:v>34.82</c:v>
                </c:pt>
                <c:pt idx="304">
                  <c:v>34.28</c:v>
                </c:pt>
                <c:pt idx="305">
                  <c:v>33.07</c:v>
                </c:pt>
                <c:pt idx="306">
                  <c:v>24.52</c:v>
                </c:pt>
                <c:pt idx="307">
                  <c:v>25.72</c:v>
                </c:pt>
                <c:pt idx="308">
                  <c:v>23.36</c:v>
                </c:pt>
                <c:pt idx="309">
                  <c:v>33.47</c:v>
                </c:pt>
                <c:pt idx="310">
                  <c:v>25.66</c:v>
                </c:pt>
                <c:pt idx="311">
                  <c:v>31.08</c:v>
                </c:pt>
                <c:pt idx="312">
                  <c:v>39.53</c:v>
                </c:pt>
                <c:pt idx="313">
                  <c:v>30.19</c:v>
                </c:pt>
                <c:pt idx="314">
                  <c:v>32.06</c:v>
                </c:pt>
                <c:pt idx="315">
                  <c:v>27.98</c:v>
                </c:pt>
                <c:pt idx="316">
                  <c:v>36.78</c:v>
                </c:pt>
                <c:pt idx="317">
                  <c:v>26.76</c:v>
                </c:pt>
                <c:pt idx="318">
                  <c:v>18.760000000000002</c:v>
                </c:pt>
                <c:pt idx="319">
                  <c:v>28.41</c:v>
                </c:pt>
                <c:pt idx="320">
                  <c:v>32.33</c:v>
                </c:pt>
                <c:pt idx="321">
                  <c:v>27.88</c:v>
                </c:pt>
                <c:pt idx="322">
                  <c:v>26.51</c:v>
                </c:pt>
                <c:pt idx="323">
                  <c:v>31.99</c:v>
                </c:pt>
                <c:pt idx="324">
                  <c:v>27.74</c:v>
                </c:pt>
                <c:pt idx="325">
                  <c:v>22.37</c:v>
                </c:pt>
                <c:pt idx="326">
                  <c:v>29.69</c:v>
                </c:pt>
                <c:pt idx="327">
                  <c:v>27.16</c:v>
                </c:pt>
                <c:pt idx="328">
                  <c:v>44.94</c:v>
                </c:pt>
                <c:pt idx="329">
                  <c:v>40.94</c:v>
                </c:pt>
                <c:pt idx="330">
                  <c:v>33.06</c:v>
                </c:pt>
                <c:pt idx="331">
                  <c:v>27.46</c:v>
                </c:pt>
                <c:pt idx="332">
                  <c:v>24.58</c:v>
                </c:pt>
                <c:pt idx="333">
                  <c:v>31.52</c:v>
                </c:pt>
                <c:pt idx="334">
                  <c:v>33.380000000000003</c:v>
                </c:pt>
                <c:pt idx="335">
                  <c:v>44.72</c:v>
                </c:pt>
                <c:pt idx="336">
                  <c:v>28.86</c:v>
                </c:pt>
                <c:pt idx="337">
                  <c:v>30.22</c:v>
                </c:pt>
                <c:pt idx="338">
                  <c:v>29.14</c:v>
                </c:pt>
                <c:pt idx="339">
                  <c:v>26.7</c:v>
                </c:pt>
                <c:pt idx="340">
                  <c:v>41.59</c:v>
                </c:pt>
                <c:pt idx="341">
                  <c:v>30.17</c:v>
                </c:pt>
                <c:pt idx="342">
                  <c:v>28.45</c:v>
                </c:pt>
                <c:pt idx="343">
                  <c:v>32.61</c:v>
                </c:pt>
                <c:pt idx="344">
                  <c:v>28.76</c:v>
                </c:pt>
                <c:pt idx="345">
                  <c:v>45.34</c:v>
                </c:pt>
                <c:pt idx="346">
                  <c:v>29.83</c:v>
                </c:pt>
                <c:pt idx="347">
                  <c:v>31.07</c:v>
                </c:pt>
                <c:pt idx="348">
                  <c:v>22.79</c:v>
                </c:pt>
                <c:pt idx="349">
                  <c:v>28.99</c:v>
                </c:pt>
                <c:pt idx="350">
                  <c:v>29.22</c:v>
                </c:pt>
                <c:pt idx="351">
                  <c:v>33</c:v>
                </c:pt>
                <c:pt idx="352">
                  <c:v>32.64</c:v>
                </c:pt>
                <c:pt idx="353">
                  <c:v>25.82</c:v>
                </c:pt>
                <c:pt idx="354">
                  <c:v>35.96</c:v>
                </c:pt>
                <c:pt idx="355">
                  <c:v>27.15</c:v>
                </c:pt>
                <c:pt idx="356">
                  <c:v>31.79</c:v>
                </c:pt>
                <c:pt idx="357">
                  <c:v>29.32</c:v>
                </c:pt>
                <c:pt idx="358">
                  <c:v>29.66</c:v>
                </c:pt>
                <c:pt idx="359">
                  <c:v>30.66</c:v>
                </c:pt>
                <c:pt idx="360">
                  <c:v>51.13</c:v>
                </c:pt>
                <c:pt idx="361">
                  <c:v>31.56</c:v>
                </c:pt>
                <c:pt idx="362">
                  <c:v>34.5</c:v>
                </c:pt>
                <c:pt idx="363">
                  <c:v>28.21</c:v>
                </c:pt>
                <c:pt idx="364">
                  <c:v>28.18</c:v>
                </c:pt>
                <c:pt idx="365">
                  <c:v>27.94</c:v>
                </c:pt>
                <c:pt idx="366">
                  <c:v>30.3</c:v>
                </c:pt>
                <c:pt idx="367">
                  <c:v>26.75</c:v>
                </c:pt>
                <c:pt idx="368">
                  <c:v>25.15</c:v>
                </c:pt>
                <c:pt idx="369">
                  <c:v>31.94</c:v>
                </c:pt>
                <c:pt idx="370">
                  <c:v>26.98</c:v>
                </c:pt>
                <c:pt idx="371">
                  <c:v>28.78</c:v>
                </c:pt>
                <c:pt idx="372">
                  <c:v>23.75</c:v>
                </c:pt>
                <c:pt idx="373">
                  <c:v>27.54</c:v>
                </c:pt>
                <c:pt idx="374">
                  <c:v>35.380000000000003</c:v>
                </c:pt>
                <c:pt idx="375">
                  <c:v>27.76</c:v>
                </c:pt>
                <c:pt idx="376">
                  <c:v>34.75</c:v>
                </c:pt>
                <c:pt idx="377">
                  <c:v>31.71</c:v>
                </c:pt>
                <c:pt idx="378">
                  <c:v>26.29</c:v>
                </c:pt>
                <c:pt idx="379">
                  <c:v>37.119999999999997</c:v>
                </c:pt>
                <c:pt idx="380">
                  <c:v>24.58</c:v>
                </c:pt>
                <c:pt idx="381">
                  <c:v>23.93</c:v>
                </c:pt>
                <c:pt idx="382">
                  <c:v>35.450000000000003</c:v>
                </c:pt>
                <c:pt idx="383">
                  <c:v>33.979999999999997</c:v>
                </c:pt>
                <c:pt idx="384">
                  <c:v>26.07</c:v>
                </c:pt>
                <c:pt idx="385">
                  <c:v>20.3</c:v>
                </c:pt>
                <c:pt idx="386">
                  <c:v>35.79</c:v>
                </c:pt>
                <c:pt idx="387">
                  <c:v>27.9</c:v>
                </c:pt>
                <c:pt idx="388">
                  <c:v>17.04</c:v>
                </c:pt>
                <c:pt idx="389">
                  <c:v>24.99</c:v>
                </c:pt>
                <c:pt idx="390">
                  <c:v>28.73</c:v>
                </c:pt>
                <c:pt idx="391">
                  <c:v>40.15</c:v>
                </c:pt>
                <c:pt idx="392">
                  <c:v>30.19</c:v>
                </c:pt>
                <c:pt idx="393">
                  <c:v>34.89</c:v>
                </c:pt>
                <c:pt idx="394">
                  <c:v>33.19</c:v>
                </c:pt>
                <c:pt idx="395">
                  <c:v>29.26</c:v>
                </c:pt>
                <c:pt idx="396">
                  <c:v>25.38</c:v>
                </c:pt>
                <c:pt idx="397">
                  <c:v>35.6</c:v>
                </c:pt>
                <c:pt idx="398">
                  <c:v>25.56</c:v>
                </c:pt>
                <c:pt idx="399">
                  <c:v>26.76</c:v>
                </c:pt>
                <c:pt idx="400">
                  <c:v>27.84</c:v>
                </c:pt>
                <c:pt idx="401">
                  <c:v>26.29</c:v>
                </c:pt>
                <c:pt idx="402">
                  <c:v>24.09</c:v>
                </c:pt>
                <c:pt idx="403">
                  <c:v>30.73</c:v>
                </c:pt>
                <c:pt idx="404">
                  <c:v>30.33</c:v>
                </c:pt>
                <c:pt idx="405">
                  <c:v>25.06</c:v>
                </c:pt>
                <c:pt idx="406">
                  <c:v>24.03</c:v>
                </c:pt>
                <c:pt idx="407">
                  <c:v>26.91</c:v>
                </c:pt>
                <c:pt idx="408">
                  <c:v>33.130000000000003</c:v>
                </c:pt>
                <c:pt idx="409">
                  <c:v>26.38</c:v>
                </c:pt>
                <c:pt idx="410">
                  <c:v>32.61</c:v>
                </c:pt>
                <c:pt idx="411">
                  <c:v>29.58</c:v>
                </c:pt>
                <c:pt idx="412">
                  <c:v>26.13</c:v>
                </c:pt>
                <c:pt idx="413">
                  <c:v>30.15</c:v>
                </c:pt>
                <c:pt idx="414">
                  <c:v>32.450000000000003</c:v>
                </c:pt>
                <c:pt idx="415">
                  <c:v>27.47</c:v>
                </c:pt>
                <c:pt idx="416">
                  <c:v>26.63</c:v>
                </c:pt>
                <c:pt idx="417">
                  <c:v>25.34</c:v>
                </c:pt>
                <c:pt idx="418">
                  <c:v>32.229999999999997</c:v>
                </c:pt>
                <c:pt idx="419">
                  <c:v>28.41</c:v>
                </c:pt>
                <c:pt idx="420">
                  <c:v>28.89</c:v>
                </c:pt>
                <c:pt idx="421">
                  <c:v>26.63</c:v>
                </c:pt>
                <c:pt idx="422">
                  <c:v>37.24</c:v>
                </c:pt>
                <c:pt idx="423">
                  <c:v>23.39</c:v>
                </c:pt>
                <c:pt idx="424">
                  <c:v>24.24</c:v>
                </c:pt>
                <c:pt idx="425">
                  <c:v>31.12</c:v>
                </c:pt>
                <c:pt idx="426">
                  <c:v>27.19</c:v>
                </c:pt>
                <c:pt idx="427">
                  <c:v>19.940000000000001</c:v>
                </c:pt>
                <c:pt idx="428">
                  <c:v>23.52</c:v>
                </c:pt>
                <c:pt idx="429">
                  <c:v>40.71</c:v>
                </c:pt>
                <c:pt idx="430">
                  <c:v>24.53</c:v>
                </c:pt>
                <c:pt idx="431">
                  <c:v>20.56</c:v>
                </c:pt>
                <c:pt idx="432">
                  <c:v>19.2</c:v>
                </c:pt>
                <c:pt idx="433">
                  <c:v>28.56</c:v>
                </c:pt>
                <c:pt idx="434">
                  <c:v>26.5</c:v>
                </c:pt>
                <c:pt idx="435">
                  <c:v>23.15</c:v>
                </c:pt>
                <c:pt idx="436">
                  <c:v>19.41</c:v>
                </c:pt>
                <c:pt idx="437">
                  <c:v>31.01</c:v>
                </c:pt>
                <c:pt idx="438">
                  <c:v>21.67</c:v>
                </c:pt>
                <c:pt idx="439">
                  <c:v>36.24</c:v>
                </c:pt>
                <c:pt idx="440">
                  <c:v>21.96</c:v>
                </c:pt>
                <c:pt idx="441">
                  <c:v>30.49</c:v>
                </c:pt>
                <c:pt idx="442">
                  <c:v>28.55</c:v>
                </c:pt>
                <c:pt idx="443">
                  <c:v>21.77</c:v>
                </c:pt>
                <c:pt idx="444">
                  <c:v>30.3</c:v>
                </c:pt>
                <c:pt idx="445">
                  <c:v>23.84</c:v>
                </c:pt>
                <c:pt idx="446">
                  <c:v>33.909999999999997</c:v>
                </c:pt>
                <c:pt idx="447">
                  <c:v>22.58</c:v>
                </c:pt>
                <c:pt idx="448">
                  <c:v>30.27</c:v>
                </c:pt>
                <c:pt idx="449">
                  <c:v>27.71</c:v>
                </c:pt>
                <c:pt idx="450">
                  <c:v>30.26</c:v>
                </c:pt>
                <c:pt idx="451">
                  <c:v>30.16</c:v>
                </c:pt>
                <c:pt idx="452">
                  <c:v>20.87</c:v>
                </c:pt>
                <c:pt idx="453">
                  <c:v>20.99</c:v>
                </c:pt>
                <c:pt idx="454">
                  <c:v>29.15</c:v>
                </c:pt>
                <c:pt idx="455">
                  <c:v>29.61</c:v>
                </c:pt>
                <c:pt idx="456">
                  <c:v>23.7</c:v>
                </c:pt>
                <c:pt idx="457">
                  <c:v>28.09</c:v>
                </c:pt>
                <c:pt idx="458">
                  <c:v>27.29</c:v>
                </c:pt>
                <c:pt idx="459">
                  <c:v>29.16</c:v>
                </c:pt>
                <c:pt idx="460">
                  <c:v>29.73</c:v>
                </c:pt>
                <c:pt idx="461">
                  <c:v>32.46</c:v>
                </c:pt>
                <c:pt idx="462">
                  <c:v>38.69</c:v>
                </c:pt>
                <c:pt idx="463">
                  <c:v>32.72</c:v>
                </c:pt>
                <c:pt idx="464">
                  <c:v>35.46</c:v>
                </c:pt>
                <c:pt idx="465">
                  <c:v>26.22</c:v>
                </c:pt>
                <c:pt idx="466">
                  <c:v>39.11</c:v>
                </c:pt>
                <c:pt idx="467">
                  <c:v>24.81</c:v>
                </c:pt>
                <c:pt idx="468">
                  <c:v>27.61</c:v>
                </c:pt>
                <c:pt idx="469">
                  <c:v>27.11</c:v>
                </c:pt>
                <c:pt idx="470">
                  <c:v>29.19</c:v>
                </c:pt>
                <c:pt idx="471">
                  <c:v>26.27</c:v>
                </c:pt>
                <c:pt idx="472">
                  <c:v>31.49</c:v>
                </c:pt>
                <c:pt idx="473">
                  <c:v>24.22</c:v>
                </c:pt>
                <c:pt idx="474">
                  <c:v>36.14</c:v>
                </c:pt>
                <c:pt idx="475">
                  <c:v>36.83</c:v>
                </c:pt>
                <c:pt idx="476">
                  <c:v>35.57</c:v>
                </c:pt>
                <c:pt idx="477">
                  <c:v>34.64</c:v>
                </c:pt>
                <c:pt idx="478">
                  <c:v>38.56</c:v>
                </c:pt>
                <c:pt idx="479">
                  <c:v>23.61</c:v>
                </c:pt>
                <c:pt idx="480">
                  <c:v>35.270000000000003</c:v>
                </c:pt>
                <c:pt idx="481">
                  <c:v>34.909999999999997</c:v>
                </c:pt>
                <c:pt idx="482">
                  <c:v>36.04</c:v>
                </c:pt>
                <c:pt idx="483">
                  <c:v>42.38</c:v>
                </c:pt>
                <c:pt idx="484">
                  <c:v>34.19</c:v>
                </c:pt>
                <c:pt idx="485">
                  <c:v>26.71</c:v>
                </c:pt>
                <c:pt idx="486">
                  <c:v>30.31</c:v>
                </c:pt>
                <c:pt idx="487">
                  <c:v>29.69</c:v>
                </c:pt>
                <c:pt idx="488">
                  <c:v>18.05</c:v>
                </c:pt>
                <c:pt idx="489">
                  <c:v>28.32</c:v>
                </c:pt>
                <c:pt idx="490">
                  <c:v>19.68</c:v>
                </c:pt>
                <c:pt idx="491">
                  <c:v>41.51</c:v>
                </c:pt>
                <c:pt idx="492">
                  <c:v>27.46</c:v>
                </c:pt>
                <c:pt idx="493">
                  <c:v>34.04</c:v>
                </c:pt>
                <c:pt idx="494">
                  <c:v>29.45</c:v>
                </c:pt>
                <c:pt idx="495">
                  <c:v>24.24</c:v>
                </c:pt>
                <c:pt idx="496">
                  <c:v>29.04</c:v>
                </c:pt>
                <c:pt idx="497">
                  <c:v>27.86</c:v>
                </c:pt>
                <c:pt idx="498">
                  <c:v>36.67</c:v>
                </c:pt>
                <c:pt idx="499">
                  <c:v>38.479999999999997</c:v>
                </c:pt>
                <c:pt idx="500">
                  <c:v>25.17</c:v>
                </c:pt>
                <c:pt idx="501">
                  <c:v>32.21</c:v>
                </c:pt>
                <c:pt idx="502">
                  <c:v>46.77</c:v>
                </c:pt>
                <c:pt idx="503">
                  <c:v>39.840000000000003</c:v>
                </c:pt>
                <c:pt idx="504">
                  <c:v>29.88</c:v>
                </c:pt>
                <c:pt idx="505">
                  <c:v>29.78</c:v>
                </c:pt>
                <c:pt idx="506">
                  <c:v>31.89</c:v>
                </c:pt>
                <c:pt idx="507">
                  <c:v>35.450000000000003</c:v>
                </c:pt>
                <c:pt idx="508">
                  <c:v>39.840000000000003</c:v>
                </c:pt>
                <c:pt idx="509">
                  <c:v>35.71</c:v>
                </c:pt>
                <c:pt idx="510">
                  <c:v>26.21</c:v>
                </c:pt>
                <c:pt idx="511">
                  <c:v>30.55</c:v>
                </c:pt>
                <c:pt idx="512">
                  <c:v>40.43</c:v>
                </c:pt>
                <c:pt idx="513">
                  <c:v>33.06</c:v>
                </c:pt>
                <c:pt idx="514">
                  <c:v>36.64</c:v>
                </c:pt>
                <c:pt idx="515">
                  <c:v>28.52</c:v>
                </c:pt>
                <c:pt idx="516">
                  <c:v>33.07</c:v>
                </c:pt>
                <c:pt idx="517">
                  <c:v>25.61</c:v>
                </c:pt>
                <c:pt idx="518">
                  <c:v>23.21</c:v>
                </c:pt>
                <c:pt idx="519">
                  <c:v>29.55</c:v>
                </c:pt>
                <c:pt idx="520">
                  <c:v>26.98</c:v>
                </c:pt>
                <c:pt idx="521">
                  <c:v>23.31</c:v>
                </c:pt>
                <c:pt idx="522">
                  <c:v>31.4</c:v>
                </c:pt>
                <c:pt idx="523">
                  <c:v>33.909999999999997</c:v>
                </c:pt>
                <c:pt idx="524">
                  <c:v>31.33</c:v>
                </c:pt>
                <c:pt idx="525">
                  <c:v>29.82</c:v>
                </c:pt>
                <c:pt idx="526">
                  <c:v>28.89</c:v>
                </c:pt>
                <c:pt idx="527">
                  <c:v>37.020000000000003</c:v>
                </c:pt>
                <c:pt idx="528">
                  <c:v>35.520000000000003</c:v>
                </c:pt>
                <c:pt idx="529">
                  <c:v>27.6</c:v>
                </c:pt>
                <c:pt idx="530">
                  <c:v>44.67</c:v>
                </c:pt>
                <c:pt idx="531">
                  <c:v>26.27</c:v>
                </c:pt>
                <c:pt idx="532">
                  <c:v>24.87</c:v>
                </c:pt>
                <c:pt idx="533">
                  <c:v>28.81</c:v>
                </c:pt>
                <c:pt idx="534">
                  <c:v>37.01</c:v>
                </c:pt>
                <c:pt idx="535">
                  <c:v>39.11</c:v>
                </c:pt>
                <c:pt idx="536">
                  <c:v>26.38</c:v>
                </c:pt>
                <c:pt idx="537">
                  <c:v>33.369999999999997</c:v>
                </c:pt>
                <c:pt idx="538">
                  <c:v>32.47</c:v>
                </c:pt>
                <c:pt idx="539">
                  <c:v>34.46</c:v>
                </c:pt>
                <c:pt idx="540">
                  <c:v>32.65</c:v>
                </c:pt>
                <c:pt idx="541">
                  <c:v>32.51</c:v>
                </c:pt>
                <c:pt idx="542">
                  <c:v>37.049999999999997</c:v>
                </c:pt>
                <c:pt idx="543">
                  <c:v>26.64</c:v>
                </c:pt>
                <c:pt idx="544">
                  <c:v>31.95</c:v>
                </c:pt>
                <c:pt idx="545">
                  <c:v>26.85</c:v>
                </c:pt>
                <c:pt idx="546">
                  <c:v>26.6</c:v>
                </c:pt>
                <c:pt idx="547">
                  <c:v>32.630000000000003</c:v>
                </c:pt>
                <c:pt idx="548">
                  <c:v>29.48</c:v>
                </c:pt>
                <c:pt idx="549">
                  <c:v>26.63</c:v>
                </c:pt>
                <c:pt idx="550">
                  <c:v>30.89</c:v>
                </c:pt>
                <c:pt idx="551">
                  <c:v>30.68</c:v>
                </c:pt>
                <c:pt idx="552">
                  <c:v>29.2</c:v>
                </c:pt>
                <c:pt idx="553">
                  <c:v>22.7</c:v>
                </c:pt>
                <c:pt idx="554">
                  <c:v>30.06</c:v>
                </c:pt>
                <c:pt idx="555">
                  <c:v>31.25</c:v>
                </c:pt>
                <c:pt idx="556">
                  <c:v>29.42</c:v>
                </c:pt>
                <c:pt idx="557">
                  <c:v>36.71</c:v>
                </c:pt>
                <c:pt idx="558">
                  <c:v>22.47</c:v>
                </c:pt>
                <c:pt idx="559">
                  <c:v>38.1</c:v>
                </c:pt>
                <c:pt idx="560">
                  <c:v>42.82</c:v>
                </c:pt>
                <c:pt idx="561">
                  <c:v>24.35</c:v>
                </c:pt>
                <c:pt idx="562">
                  <c:v>30.44</c:v>
                </c:pt>
                <c:pt idx="563">
                  <c:v>33.869999999999997</c:v>
                </c:pt>
                <c:pt idx="564">
                  <c:v>32.29</c:v>
                </c:pt>
                <c:pt idx="565">
                  <c:v>20.54</c:v>
                </c:pt>
                <c:pt idx="566">
                  <c:v>29.52</c:v>
                </c:pt>
                <c:pt idx="567">
                  <c:v>38</c:v>
                </c:pt>
                <c:pt idx="568">
                  <c:v>39.369999999999997</c:v>
                </c:pt>
                <c:pt idx="569">
                  <c:v>34.479999999999997</c:v>
                </c:pt>
                <c:pt idx="570">
                  <c:v>26.64</c:v>
                </c:pt>
                <c:pt idx="571">
                  <c:v>31.39</c:v>
                </c:pt>
                <c:pt idx="572">
                  <c:v>34.82</c:v>
                </c:pt>
                <c:pt idx="573">
                  <c:v>40.69</c:v>
                </c:pt>
                <c:pt idx="574">
                  <c:v>29.2</c:v>
                </c:pt>
                <c:pt idx="575">
                  <c:v>24.76</c:v>
                </c:pt>
                <c:pt idx="576">
                  <c:v>34.630000000000003</c:v>
                </c:pt>
                <c:pt idx="577">
                  <c:v>27.52</c:v>
                </c:pt>
                <c:pt idx="578">
                  <c:v>21.46</c:v>
                </c:pt>
                <c:pt idx="579">
                  <c:v>18.71</c:v>
                </c:pt>
                <c:pt idx="580">
                  <c:v>27.67</c:v>
                </c:pt>
                <c:pt idx="581">
                  <c:v>32.31</c:v>
                </c:pt>
                <c:pt idx="582">
                  <c:v>24.3</c:v>
                </c:pt>
                <c:pt idx="583">
                  <c:v>28.78</c:v>
                </c:pt>
                <c:pt idx="584">
                  <c:v>27.78</c:v>
                </c:pt>
                <c:pt idx="585">
                  <c:v>29.35</c:v>
                </c:pt>
                <c:pt idx="586">
                  <c:v>35</c:v>
                </c:pt>
                <c:pt idx="587">
                  <c:v>26.93</c:v>
                </c:pt>
                <c:pt idx="588">
                  <c:v>28.72</c:v>
                </c:pt>
                <c:pt idx="589">
                  <c:v>31.13</c:v>
                </c:pt>
                <c:pt idx="590">
                  <c:v>32.880000000000003</c:v>
                </c:pt>
                <c:pt idx="591">
                  <c:v>39.75</c:v>
                </c:pt>
                <c:pt idx="592">
                  <c:v>26.44</c:v>
                </c:pt>
                <c:pt idx="593">
                  <c:v>30.61</c:v>
                </c:pt>
                <c:pt idx="594">
                  <c:v>37.65</c:v>
                </c:pt>
                <c:pt idx="595">
                  <c:v>31.01</c:v>
                </c:pt>
                <c:pt idx="596">
                  <c:v>26.22</c:v>
                </c:pt>
                <c:pt idx="597">
                  <c:v>25.35</c:v>
                </c:pt>
                <c:pt idx="598">
                  <c:v>24.35</c:v>
                </c:pt>
                <c:pt idx="599">
                  <c:v>27.75</c:v>
                </c:pt>
                <c:pt idx="600">
                  <c:v>31.94</c:v>
                </c:pt>
                <c:pt idx="601">
                  <c:v>34.4</c:v>
                </c:pt>
                <c:pt idx="602">
                  <c:v>33.200000000000003</c:v>
                </c:pt>
                <c:pt idx="603">
                  <c:v>28.4</c:v>
                </c:pt>
                <c:pt idx="604">
                  <c:v>30.93</c:v>
                </c:pt>
                <c:pt idx="605">
                  <c:v>32.42</c:v>
                </c:pt>
                <c:pt idx="606">
                  <c:v>30.52</c:v>
                </c:pt>
                <c:pt idx="607">
                  <c:v>28.29</c:v>
                </c:pt>
                <c:pt idx="608">
                  <c:v>34.090000000000003</c:v>
                </c:pt>
                <c:pt idx="609">
                  <c:v>39.840000000000003</c:v>
                </c:pt>
                <c:pt idx="610">
                  <c:v>29.55</c:v>
                </c:pt>
                <c:pt idx="611">
                  <c:v>37.39</c:v>
                </c:pt>
                <c:pt idx="612">
                  <c:v>29.02</c:v>
                </c:pt>
                <c:pt idx="613">
                  <c:v>24.06</c:v>
                </c:pt>
                <c:pt idx="614">
                  <c:v>29.78</c:v>
                </c:pt>
                <c:pt idx="615">
                  <c:v>26.16</c:v>
                </c:pt>
                <c:pt idx="616">
                  <c:v>23.61</c:v>
                </c:pt>
                <c:pt idx="617">
                  <c:v>28.56</c:v>
                </c:pt>
                <c:pt idx="618">
                  <c:v>35.86</c:v>
                </c:pt>
                <c:pt idx="619">
                  <c:v>26.17</c:v>
                </c:pt>
                <c:pt idx="620">
                  <c:v>27.62</c:v>
                </c:pt>
                <c:pt idx="621">
                  <c:v>30.88</c:v>
                </c:pt>
                <c:pt idx="622">
                  <c:v>26.41</c:v>
                </c:pt>
                <c:pt idx="623">
                  <c:v>32.67</c:v>
                </c:pt>
                <c:pt idx="624">
                  <c:v>34.29</c:v>
                </c:pt>
                <c:pt idx="625">
                  <c:v>58.19</c:v>
                </c:pt>
                <c:pt idx="626">
                  <c:v>31.4</c:v>
                </c:pt>
                <c:pt idx="627">
                  <c:v>25.83</c:v>
                </c:pt>
                <c:pt idx="628">
                  <c:v>35.65</c:v>
                </c:pt>
                <c:pt idx="629">
                  <c:v>34.74</c:v>
                </c:pt>
                <c:pt idx="630">
                  <c:v>33.74</c:v>
                </c:pt>
                <c:pt idx="631">
                  <c:v>28.88</c:v>
                </c:pt>
                <c:pt idx="632">
                  <c:v>29.9</c:v>
                </c:pt>
                <c:pt idx="633">
                  <c:v>29.5</c:v>
                </c:pt>
                <c:pt idx="634">
                  <c:v>34.57</c:v>
                </c:pt>
                <c:pt idx="635">
                  <c:v>33.130000000000003</c:v>
                </c:pt>
                <c:pt idx="636">
                  <c:v>35.22</c:v>
                </c:pt>
                <c:pt idx="637">
                  <c:v>30.82</c:v>
                </c:pt>
                <c:pt idx="638">
                  <c:v>23.29</c:v>
                </c:pt>
                <c:pt idx="639">
                  <c:v>29.24</c:v>
                </c:pt>
                <c:pt idx="640">
                  <c:v>23.4</c:v>
                </c:pt>
                <c:pt idx="641">
                  <c:v>31.88</c:v>
                </c:pt>
                <c:pt idx="642">
                  <c:v>21.97</c:v>
                </c:pt>
                <c:pt idx="643">
                  <c:v>26.15</c:v>
                </c:pt>
                <c:pt idx="644">
                  <c:v>25.44</c:v>
                </c:pt>
                <c:pt idx="645">
                  <c:v>30.22</c:v>
                </c:pt>
                <c:pt idx="646">
                  <c:v>24.43</c:v>
                </c:pt>
                <c:pt idx="647">
                  <c:v>41.75</c:v>
                </c:pt>
                <c:pt idx="648">
                  <c:v>36.67</c:v>
                </c:pt>
                <c:pt idx="649">
                  <c:v>31.06</c:v>
                </c:pt>
                <c:pt idx="650">
                  <c:v>26.91</c:v>
                </c:pt>
                <c:pt idx="651">
                  <c:v>46.64</c:v>
                </c:pt>
                <c:pt idx="652">
                  <c:v>31.54</c:v>
                </c:pt>
                <c:pt idx="653">
                  <c:v>32.03</c:v>
                </c:pt>
                <c:pt idx="654">
                  <c:v>29.47</c:v>
                </c:pt>
                <c:pt idx="655">
                  <c:v>25.22</c:v>
                </c:pt>
                <c:pt idx="656">
                  <c:v>22.08</c:v>
                </c:pt>
                <c:pt idx="657">
                  <c:v>35.33</c:v>
                </c:pt>
                <c:pt idx="658">
                  <c:v>22.13</c:v>
                </c:pt>
                <c:pt idx="659">
                  <c:v>29.4</c:v>
                </c:pt>
                <c:pt idx="660">
                  <c:v>28.49</c:v>
                </c:pt>
                <c:pt idx="661">
                  <c:v>24.96</c:v>
                </c:pt>
                <c:pt idx="662">
                  <c:v>30.28</c:v>
                </c:pt>
                <c:pt idx="663">
                  <c:v>34.54</c:v>
                </c:pt>
                <c:pt idx="664">
                  <c:v>32.47</c:v>
                </c:pt>
                <c:pt idx="665">
                  <c:v>30.72</c:v>
                </c:pt>
                <c:pt idx="666">
                  <c:v>26.1</c:v>
                </c:pt>
                <c:pt idx="667">
                  <c:v>33.18</c:v>
                </c:pt>
                <c:pt idx="668">
                  <c:v>26.39</c:v>
                </c:pt>
                <c:pt idx="669">
                  <c:v>21.4</c:v>
                </c:pt>
                <c:pt idx="670">
                  <c:v>30.53</c:v>
                </c:pt>
                <c:pt idx="671">
                  <c:v>29.94</c:v>
                </c:pt>
                <c:pt idx="672">
                  <c:v>28.05</c:v>
                </c:pt>
                <c:pt idx="673">
                  <c:v>23.43</c:v>
                </c:pt>
                <c:pt idx="674">
                  <c:v>34.76</c:v>
                </c:pt>
                <c:pt idx="675">
                  <c:v>29.61</c:v>
                </c:pt>
                <c:pt idx="676">
                  <c:v>26.13</c:v>
                </c:pt>
                <c:pt idx="677">
                  <c:v>37.270000000000003</c:v>
                </c:pt>
                <c:pt idx="678">
                  <c:v>29.66</c:v>
                </c:pt>
                <c:pt idx="679">
                  <c:v>29.61</c:v>
                </c:pt>
                <c:pt idx="680">
                  <c:v>38.56</c:v>
                </c:pt>
                <c:pt idx="681">
                  <c:v>29.2</c:v>
                </c:pt>
                <c:pt idx="682">
                  <c:v>28.31</c:v>
                </c:pt>
                <c:pt idx="683">
                  <c:v>32.840000000000003</c:v>
                </c:pt>
                <c:pt idx="684">
                  <c:v>34.65</c:v>
                </c:pt>
                <c:pt idx="685">
                  <c:v>32.25</c:v>
                </c:pt>
                <c:pt idx="686">
                  <c:v>31.43</c:v>
                </c:pt>
                <c:pt idx="687">
                  <c:v>26.57</c:v>
                </c:pt>
                <c:pt idx="688">
                  <c:v>55.39</c:v>
                </c:pt>
                <c:pt idx="689">
                  <c:v>33.17</c:v>
                </c:pt>
                <c:pt idx="690">
                  <c:v>28.28</c:v>
                </c:pt>
                <c:pt idx="691">
                  <c:v>32.78</c:v>
                </c:pt>
                <c:pt idx="692">
                  <c:v>37.06</c:v>
                </c:pt>
                <c:pt idx="693">
                  <c:v>29.11</c:v>
                </c:pt>
                <c:pt idx="694">
                  <c:v>26.72</c:v>
                </c:pt>
                <c:pt idx="695">
                  <c:v>29.1</c:v>
                </c:pt>
                <c:pt idx="696">
                  <c:v>26.47</c:v>
                </c:pt>
                <c:pt idx="697">
                  <c:v>33.229999999999997</c:v>
                </c:pt>
                <c:pt idx="698">
                  <c:v>25.5</c:v>
                </c:pt>
                <c:pt idx="699">
                  <c:v>26.72</c:v>
                </c:pt>
                <c:pt idx="700">
                  <c:v>28.23</c:v>
                </c:pt>
                <c:pt idx="701">
                  <c:v>26.84</c:v>
                </c:pt>
                <c:pt idx="702">
                  <c:v>30.36</c:v>
                </c:pt>
                <c:pt idx="703">
                  <c:v>30.01</c:v>
                </c:pt>
                <c:pt idx="704">
                  <c:v>30.64</c:v>
                </c:pt>
                <c:pt idx="705">
                  <c:v>33.979999999999997</c:v>
                </c:pt>
                <c:pt idx="706">
                  <c:v>33.6</c:v>
                </c:pt>
                <c:pt idx="707">
                  <c:v>25.39</c:v>
                </c:pt>
                <c:pt idx="708">
                  <c:v>25.9</c:v>
                </c:pt>
                <c:pt idx="709">
                  <c:v>33.15</c:v>
                </c:pt>
                <c:pt idx="710">
                  <c:v>21.36</c:v>
                </c:pt>
                <c:pt idx="711">
                  <c:v>34.83</c:v>
                </c:pt>
                <c:pt idx="712">
                  <c:v>35.729999999999997</c:v>
                </c:pt>
                <c:pt idx="713">
                  <c:v>37.86</c:v>
                </c:pt>
                <c:pt idx="714">
                  <c:v>26.1</c:v>
                </c:pt>
                <c:pt idx="715">
                  <c:v>29.25</c:v>
                </c:pt>
                <c:pt idx="716">
                  <c:v>31.78</c:v>
                </c:pt>
                <c:pt idx="717">
                  <c:v>27.06</c:v>
                </c:pt>
                <c:pt idx="718">
                  <c:v>36.5</c:v>
                </c:pt>
                <c:pt idx="719">
                  <c:v>31.1</c:v>
                </c:pt>
                <c:pt idx="720">
                  <c:v>21.98</c:v>
                </c:pt>
                <c:pt idx="721">
                  <c:v>30.67</c:v>
                </c:pt>
                <c:pt idx="722">
                  <c:v>30.51</c:v>
                </c:pt>
                <c:pt idx="723">
                  <c:v>30.06</c:v>
                </c:pt>
                <c:pt idx="725">
                  <c:v>31.95</c:v>
                </c:pt>
                <c:pt idx="726">
                  <c:v>32.54</c:v>
                </c:pt>
                <c:pt idx="727">
                  <c:v>29.46</c:v>
                </c:pt>
                <c:pt idx="728">
                  <c:v>35.06</c:v>
                </c:pt>
                <c:pt idx="729">
                  <c:v>29.38</c:v>
                </c:pt>
                <c:pt idx="730">
                  <c:v>42.14</c:v>
                </c:pt>
                <c:pt idx="731">
                  <c:v>34.07</c:v>
                </c:pt>
                <c:pt idx="732">
                  <c:v>32.950000000000003</c:v>
                </c:pt>
                <c:pt idx="733">
                  <c:v>38.14</c:v>
                </c:pt>
                <c:pt idx="734">
                  <c:v>25.25</c:v>
                </c:pt>
                <c:pt idx="735">
                  <c:v>39.450000000000003</c:v>
                </c:pt>
                <c:pt idx="736">
                  <c:v>33.409999999999997</c:v>
                </c:pt>
                <c:pt idx="737">
                  <c:v>34.53</c:v>
                </c:pt>
                <c:pt idx="738">
                  <c:v>24.66</c:v>
                </c:pt>
                <c:pt idx="739">
                  <c:v>24.34</c:v>
                </c:pt>
                <c:pt idx="740">
                  <c:v>31.44</c:v>
                </c:pt>
                <c:pt idx="741">
                  <c:v>35.17</c:v>
                </c:pt>
                <c:pt idx="742">
                  <c:v>21.46</c:v>
                </c:pt>
                <c:pt idx="743">
                  <c:v>51.27</c:v>
                </c:pt>
                <c:pt idx="744">
                  <c:v>41.45</c:v>
                </c:pt>
                <c:pt idx="745">
                  <c:v>34.1</c:v>
                </c:pt>
                <c:pt idx="746">
                  <c:v>46.4</c:v>
                </c:pt>
                <c:pt idx="747">
                  <c:v>35.06</c:v>
                </c:pt>
                <c:pt idx="748">
                  <c:v>39.25</c:v>
                </c:pt>
                <c:pt idx="749">
                  <c:v>32.44</c:v>
                </c:pt>
                <c:pt idx="750">
                  <c:v>27.77</c:v>
                </c:pt>
                <c:pt idx="751">
                  <c:v>31.83</c:v>
                </c:pt>
                <c:pt idx="752">
                  <c:v>23.05</c:v>
                </c:pt>
                <c:pt idx="753">
                  <c:v>44.93</c:v>
                </c:pt>
                <c:pt idx="754">
                  <c:v>28.23</c:v>
                </c:pt>
                <c:pt idx="755">
                  <c:v>27.77</c:v>
                </c:pt>
                <c:pt idx="756">
                  <c:v>29.07</c:v>
                </c:pt>
                <c:pt idx="757">
                  <c:v>27.21</c:v>
                </c:pt>
                <c:pt idx="758">
                  <c:v>22.68</c:v>
                </c:pt>
                <c:pt idx="759">
                  <c:v>26.31</c:v>
                </c:pt>
                <c:pt idx="760">
                  <c:v>26.34</c:v>
                </c:pt>
                <c:pt idx="761">
                  <c:v>31.03</c:v>
                </c:pt>
                <c:pt idx="762">
                  <c:v>41.78</c:v>
                </c:pt>
                <c:pt idx="763">
                  <c:v>27.31</c:v>
                </c:pt>
                <c:pt idx="764">
                  <c:v>37.049999999999997</c:v>
                </c:pt>
                <c:pt idx="765">
                  <c:v>26.47</c:v>
                </c:pt>
                <c:pt idx="766">
                  <c:v>37.92</c:v>
                </c:pt>
                <c:pt idx="767">
                  <c:v>36.69</c:v>
                </c:pt>
                <c:pt idx="768">
                  <c:v>31.96</c:v>
                </c:pt>
                <c:pt idx="769">
                  <c:v>34.08</c:v>
                </c:pt>
                <c:pt idx="770">
                  <c:v>32.71</c:v>
                </c:pt>
                <c:pt idx="771">
                  <c:v>26.19</c:v>
                </c:pt>
                <c:pt idx="772">
                  <c:v>30.89</c:v>
                </c:pt>
                <c:pt idx="773">
                  <c:v>29</c:v>
                </c:pt>
                <c:pt idx="774">
                  <c:v>42.91</c:v>
                </c:pt>
                <c:pt idx="775">
                  <c:v>37.1</c:v>
                </c:pt>
                <c:pt idx="776">
                  <c:v>27.01</c:v>
                </c:pt>
                <c:pt idx="777">
                  <c:v>30.32</c:v>
                </c:pt>
                <c:pt idx="778">
                  <c:v>32.450000000000003</c:v>
                </c:pt>
                <c:pt idx="779">
                  <c:v>31.17</c:v>
                </c:pt>
                <c:pt idx="780">
                  <c:v>34.909999999999997</c:v>
                </c:pt>
                <c:pt idx="781">
                  <c:v>30.41</c:v>
                </c:pt>
                <c:pt idx="782">
                  <c:v>23.49</c:v>
                </c:pt>
                <c:pt idx="783">
                  <c:v>34.1</c:v>
                </c:pt>
                <c:pt idx="784">
                  <c:v>37.869999999999997</c:v>
                </c:pt>
                <c:pt idx="785">
                  <c:v>28.16</c:v>
                </c:pt>
                <c:pt idx="786">
                  <c:v>34.22</c:v>
                </c:pt>
                <c:pt idx="787">
                  <c:v>27.96</c:v>
                </c:pt>
                <c:pt idx="788">
                  <c:v>34.04</c:v>
                </c:pt>
                <c:pt idx="789">
                  <c:v>26.77</c:v>
                </c:pt>
                <c:pt idx="790">
                  <c:v>30.1</c:v>
                </c:pt>
                <c:pt idx="791">
                  <c:v>31.63</c:v>
                </c:pt>
                <c:pt idx="792">
                  <c:v>31.43</c:v>
                </c:pt>
                <c:pt idx="793">
                  <c:v>29.94</c:v>
                </c:pt>
                <c:pt idx="794">
                  <c:v>25.36</c:v>
                </c:pt>
                <c:pt idx="795">
                  <c:v>24.24</c:v>
                </c:pt>
                <c:pt idx="796">
                  <c:v>35.590000000000003</c:v>
                </c:pt>
                <c:pt idx="797">
                  <c:v>30.78</c:v>
                </c:pt>
                <c:pt idx="798">
                  <c:v>31.14</c:v>
                </c:pt>
                <c:pt idx="799">
                  <c:v>26.68</c:v>
                </c:pt>
                <c:pt idx="800">
                  <c:v>28.08</c:v>
                </c:pt>
                <c:pt idx="801">
                  <c:v>28.58</c:v>
                </c:pt>
                <c:pt idx="802">
                  <c:v>30.18</c:v>
                </c:pt>
                <c:pt idx="803">
                  <c:v>37.01</c:v>
                </c:pt>
                <c:pt idx="804">
                  <c:v>29.13</c:v>
                </c:pt>
                <c:pt idx="805">
                  <c:v>30.2</c:v>
                </c:pt>
                <c:pt idx="806">
                  <c:v>27.26</c:v>
                </c:pt>
                <c:pt idx="807">
                  <c:v>31.44</c:v>
                </c:pt>
                <c:pt idx="808">
                  <c:v>31.64</c:v>
                </c:pt>
                <c:pt idx="809">
                  <c:v>33.74</c:v>
                </c:pt>
                <c:pt idx="810">
                  <c:v>28.33</c:v>
                </c:pt>
                <c:pt idx="811">
                  <c:v>37.46</c:v>
                </c:pt>
                <c:pt idx="812">
                  <c:v>34.82</c:v>
                </c:pt>
                <c:pt idx="813">
                  <c:v>28.99</c:v>
                </c:pt>
                <c:pt idx="814">
                  <c:v>28.64</c:v>
                </c:pt>
                <c:pt idx="815">
                  <c:v>25.69</c:v>
                </c:pt>
                <c:pt idx="816">
                  <c:v>34.57</c:v>
                </c:pt>
                <c:pt idx="817">
                  <c:v>37.340000000000003</c:v>
                </c:pt>
                <c:pt idx="818">
                  <c:v>27.17</c:v>
                </c:pt>
                <c:pt idx="819">
                  <c:v>31.41</c:v>
                </c:pt>
                <c:pt idx="820">
                  <c:v>28.5</c:v>
                </c:pt>
                <c:pt idx="821">
                  <c:v>39.85</c:v>
                </c:pt>
                <c:pt idx="822">
                  <c:v>28.36</c:v>
                </c:pt>
                <c:pt idx="823">
                  <c:v>25.45</c:v>
                </c:pt>
                <c:pt idx="824">
                  <c:v>28.53</c:v>
                </c:pt>
                <c:pt idx="825">
                  <c:v>23.56</c:v>
                </c:pt>
                <c:pt idx="826">
                  <c:v>32.700000000000003</c:v>
                </c:pt>
                <c:pt idx="827">
                  <c:v>27.01</c:v>
                </c:pt>
                <c:pt idx="828">
                  <c:v>36.19</c:v>
                </c:pt>
                <c:pt idx="829">
                  <c:v>43.89</c:v>
                </c:pt>
                <c:pt idx="830">
                  <c:v>30.59</c:v>
                </c:pt>
                <c:pt idx="831">
                  <c:v>35.700000000000003</c:v>
                </c:pt>
                <c:pt idx="832">
                  <c:v>33.020000000000003</c:v>
                </c:pt>
                <c:pt idx="833">
                  <c:v>43.62</c:v>
                </c:pt>
                <c:pt idx="834">
                  <c:v>31.35</c:v>
                </c:pt>
                <c:pt idx="835">
                  <c:v>22.93</c:v>
                </c:pt>
                <c:pt idx="836">
                  <c:v>33.72</c:v>
                </c:pt>
                <c:pt idx="837">
                  <c:v>30.1</c:v>
                </c:pt>
                <c:pt idx="838">
                  <c:v>27.58</c:v>
                </c:pt>
                <c:pt idx="839">
                  <c:v>45.7</c:v>
                </c:pt>
                <c:pt idx="840">
                  <c:v>59.38</c:v>
                </c:pt>
                <c:pt idx="841">
                  <c:v>40.21</c:v>
                </c:pt>
                <c:pt idx="842">
                  <c:v>41.66</c:v>
                </c:pt>
                <c:pt idx="843">
                  <c:v>25.29</c:v>
                </c:pt>
                <c:pt idx="844">
                  <c:v>38.200000000000003</c:v>
                </c:pt>
                <c:pt idx="845">
                  <c:v>21.27</c:v>
                </c:pt>
                <c:pt idx="846">
                  <c:v>20.329999999999998</c:v>
                </c:pt>
                <c:pt idx="847">
                  <c:v>33.799999999999997</c:v>
                </c:pt>
                <c:pt idx="848">
                  <c:v>41.81</c:v>
                </c:pt>
                <c:pt idx="849">
                  <c:v>29.41</c:v>
                </c:pt>
                <c:pt idx="850">
                  <c:v>28.95</c:v>
                </c:pt>
                <c:pt idx="851">
                  <c:v>29.41</c:v>
                </c:pt>
                <c:pt idx="852">
                  <c:v>35.619999999999997</c:v>
                </c:pt>
                <c:pt idx="853">
                  <c:v>43.5</c:v>
                </c:pt>
                <c:pt idx="854">
                  <c:v>27.83</c:v>
                </c:pt>
                <c:pt idx="855">
                  <c:v>17.59</c:v>
                </c:pt>
                <c:pt idx="856">
                  <c:v>29.24</c:v>
                </c:pt>
                <c:pt idx="857">
                  <c:v>29.81</c:v>
                </c:pt>
                <c:pt idx="858">
                  <c:v>27.12</c:v>
                </c:pt>
                <c:pt idx="859">
                  <c:v>30.92</c:v>
                </c:pt>
                <c:pt idx="860">
                  <c:v>21.61</c:v>
                </c:pt>
                <c:pt idx="861">
                  <c:v>22.92</c:v>
                </c:pt>
                <c:pt idx="862">
                  <c:v>28.05</c:v>
                </c:pt>
                <c:pt idx="863">
                  <c:v>25.7</c:v>
                </c:pt>
                <c:pt idx="864">
                  <c:v>27.24</c:v>
                </c:pt>
                <c:pt idx="865">
                  <c:v>34.53</c:v>
                </c:pt>
                <c:pt idx="866">
                  <c:v>32.46</c:v>
                </c:pt>
                <c:pt idx="867">
                  <c:v>32.78</c:v>
                </c:pt>
                <c:pt idx="868">
                  <c:v>28.12</c:v>
                </c:pt>
                <c:pt idx="869">
                  <c:v>26.93</c:v>
                </c:pt>
                <c:pt idx="870">
                  <c:v>34.19</c:v>
                </c:pt>
                <c:pt idx="871">
                  <c:v>31.94</c:v>
                </c:pt>
                <c:pt idx="872">
                  <c:v>32.33</c:v>
                </c:pt>
                <c:pt idx="873">
                  <c:v>28.65</c:v>
                </c:pt>
                <c:pt idx="874">
                  <c:v>27.55</c:v>
                </c:pt>
                <c:pt idx="875">
                  <c:v>21.73</c:v>
                </c:pt>
                <c:pt idx="876">
                  <c:v>35.380000000000003</c:v>
                </c:pt>
                <c:pt idx="877">
                  <c:v>27.7</c:v>
                </c:pt>
                <c:pt idx="878">
                  <c:v>22.51</c:v>
                </c:pt>
                <c:pt idx="879">
                  <c:v>27.24</c:v>
                </c:pt>
                <c:pt idx="880">
                  <c:v>38.119999999999997</c:v>
                </c:pt>
                <c:pt idx="881">
                  <c:v>33.31</c:v>
                </c:pt>
                <c:pt idx="882">
                  <c:v>26.18</c:v>
                </c:pt>
                <c:pt idx="883">
                  <c:v>34.17</c:v>
                </c:pt>
                <c:pt idx="884">
                  <c:v>32.32</c:v>
                </c:pt>
                <c:pt idx="885">
                  <c:v>33.57</c:v>
                </c:pt>
                <c:pt idx="886">
                  <c:v>25.57</c:v>
                </c:pt>
                <c:pt idx="887">
                  <c:v>34.49</c:v>
                </c:pt>
                <c:pt idx="888">
                  <c:v>34.42</c:v>
                </c:pt>
                <c:pt idx="889">
                  <c:v>51.73</c:v>
                </c:pt>
                <c:pt idx="890">
                  <c:v>33.200000000000003</c:v>
                </c:pt>
                <c:pt idx="891">
                  <c:v>32.42</c:v>
                </c:pt>
                <c:pt idx="892">
                  <c:v>31.23</c:v>
                </c:pt>
                <c:pt idx="893">
                  <c:v>34.380000000000003</c:v>
                </c:pt>
                <c:pt idx="894">
                  <c:v>26.49</c:v>
                </c:pt>
                <c:pt idx="895">
                  <c:v>27.78</c:v>
                </c:pt>
                <c:pt idx="896">
                  <c:v>25.18</c:v>
                </c:pt>
                <c:pt idx="897">
                  <c:v>26.28</c:v>
                </c:pt>
                <c:pt idx="898">
                  <c:v>30.12</c:v>
                </c:pt>
                <c:pt idx="899">
                  <c:v>34.06</c:v>
                </c:pt>
                <c:pt idx="900">
                  <c:v>24</c:v>
                </c:pt>
                <c:pt idx="901">
                  <c:v>30.16</c:v>
                </c:pt>
                <c:pt idx="902">
                  <c:v>28.38</c:v>
                </c:pt>
                <c:pt idx="903">
                  <c:v>49.07</c:v>
                </c:pt>
                <c:pt idx="904">
                  <c:v>24.24</c:v>
                </c:pt>
                <c:pt idx="905">
                  <c:v>26.71</c:v>
                </c:pt>
                <c:pt idx="906">
                  <c:v>30.62</c:v>
                </c:pt>
                <c:pt idx="907">
                  <c:v>38.229999999999997</c:v>
                </c:pt>
                <c:pt idx="908">
                  <c:v>31.17</c:v>
                </c:pt>
                <c:pt idx="909">
                  <c:v>31.93</c:v>
                </c:pt>
                <c:pt idx="910">
                  <c:v>33.450000000000003</c:v>
                </c:pt>
                <c:pt idx="911">
                  <c:v>30.29</c:v>
                </c:pt>
                <c:pt idx="912">
                  <c:v>36.69</c:v>
                </c:pt>
                <c:pt idx="913">
                  <c:v>46.76</c:v>
                </c:pt>
                <c:pt idx="914">
                  <c:v>29.07</c:v>
                </c:pt>
                <c:pt idx="915">
                  <c:v>43.71</c:v>
                </c:pt>
                <c:pt idx="916">
                  <c:v>35.28</c:v>
                </c:pt>
                <c:pt idx="917">
                  <c:v>28.41</c:v>
                </c:pt>
                <c:pt idx="918">
                  <c:v>36.89</c:v>
                </c:pt>
                <c:pt idx="919">
                  <c:v>31.49</c:v>
                </c:pt>
                <c:pt idx="920">
                  <c:v>39.71</c:v>
                </c:pt>
                <c:pt idx="921">
                  <c:v>30.59</c:v>
                </c:pt>
                <c:pt idx="922">
                  <c:v>34.200000000000003</c:v>
                </c:pt>
                <c:pt idx="923">
                  <c:v>29.22</c:v>
                </c:pt>
                <c:pt idx="924">
                  <c:v>25.04</c:v>
                </c:pt>
                <c:pt idx="925">
                  <c:v>26.82</c:v>
                </c:pt>
                <c:pt idx="926">
                  <c:v>34.090000000000003</c:v>
                </c:pt>
                <c:pt idx="927">
                  <c:v>33.409999999999997</c:v>
                </c:pt>
                <c:pt idx="928">
                  <c:v>36.31</c:v>
                </c:pt>
              </c:numCache>
            </c:numRef>
          </c:xVal>
          <c:yVal>
            <c:numRef>
              <c:f>'[SJ database FTO methylation analysis2.xlsx]age,lym'!$K$2:$K$930</c:f>
              <c:numCache>
                <c:formatCode>0.0</c:formatCode>
                <c:ptCount val="929"/>
                <c:pt idx="0">
                  <c:v>54.628333969384734</c:v>
                </c:pt>
                <c:pt idx="1">
                  <c:v>31.224140921140648</c:v>
                </c:pt>
                <c:pt idx="2">
                  <c:v>28.628023352793999</c:v>
                </c:pt>
                <c:pt idx="3">
                  <c:v>32.741267021906452</c:v>
                </c:pt>
                <c:pt idx="4">
                  <c:v>39.377142440376332</c:v>
                </c:pt>
                <c:pt idx="5">
                  <c:v>40.045322110715439</c:v>
                </c:pt>
                <c:pt idx="6">
                  <c:v>35.254214060572842</c:v>
                </c:pt>
                <c:pt idx="7">
                  <c:v>28.620965590824216</c:v>
                </c:pt>
                <c:pt idx="8">
                  <c:v>35.598024885203046</c:v>
                </c:pt>
                <c:pt idx="9">
                  <c:v>38.511250530685409</c:v>
                </c:pt>
                <c:pt idx="10">
                  <c:v>21.465150993225397</c:v>
                </c:pt>
                <c:pt idx="11">
                  <c:v>38.104245481294662</c:v>
                </c:pt>
                <c:pt idx="12">
                  <c:v>47.777133303763343</c:v>
                </c:pt>
                <c:pt idx="13">
                  <c:v>37.599043205262369</c:v>
                </c:pt>
                <c:pt idx="14">
                  <c:v>39.511169513797633</c:v>
                </c:pt>
                <c:pt idx="15">
                  <c:v>37.371976465460889</c:v>
                </c:pt>
                <c:pt idx="16">
                  <c:v>23.561780890445224</c:v>
                </c:pt>
                <c:pt idx="17">
                  <c:v>38.307942612039639</c:v>
                </c:pt>
                <c:pt idx="18">
                  <c:v>34.731599865919648</c:v>
                </c:pt>
                <c:pt idx="19">
                  <c:v>47.619147091556172</c:v>
                </c:pt>
                <c:pt idx="20">
                  <c:v>42.288278182837921</c:v>
                </c:pt>
                <c:pt idx="21">
                  <c:v>33.67616069917684</c:v>
                </c:pt>
                <c:pt idx="22">
                  <c:v>37.606645711719807</c:v>
                </c:pt>
                <c:pt idx="23">
                  <c:v>25.856279382135661</c:v>
                </c:pt>
                <c:pt idx="24">
                  <c:v>39.956281342419956</c:v>
                </c:pt>
                <c:pt idx="25">
                  <c:v>39.612684351882393</c:v>
                </c:pt>
                <c:pt idx="26">
                  <c:v>43.135613489595798</c:v>
                </c:pt>
                <c:pt idx="27">
                  <c:v>29.126012040689226</c:v>
                </c:pt>
                <c:pt idx="28">
                  <c:v>41.046551555478075</c:v>
                </c:pt>
                <c:pt idx="29">
                  <c:v>39.394778754933874</c:v>
                </c:pt>
                <c:pt idx="30">
                  <c:v>31.538925352640749</c:v>
                </c:pt>
                <c:pt idx="31">
                  <c:v>33.363963641006457</c:v>
                </c:pt>
                <c:pt idx="32">
                  <c:v>25.91283863368669</c:v>
                </c:pt>
                <c:pt idx="33">
                  <c:v>29.117647058823529</c:v>
                </c:pt>
                <c:pt idx="34">
                  <c:v>37.18004338394794</c:v>
                </c:pt>
                <c:pt idx="35">
                  <c:v>38.162197089986897</c:v>
                </c:pt>
                <c:pt idx="36">
                  <c:v>31.406588750726563</c:v>
                </c:pt>
                <c:pt idx="37">
                  <c:v>42.068218733080677</c:v>
                </c:pt>
                <c:pt idx="38">
                  <c:v>28.385925719072887</c:v>
                </c:pt>
                <c:pt idx="39">
                  <c:v>49.866111276405839</c:v>
                </c:pt>
                <c:pt idx="40">
                  <c:v>26.928440821892341</c:v>
                </c:pt>
                <c:pt idx="41">
                  <c:v>34.760480946625108</c:v>
                </c:pt>
                <c:pt idx="42">
                  <c:v>32.638415149944066</c:v>
                </c:pt>
                <c:pt idx="43">
                  <c:v>34.583670169765561</c:v>
                </c:pt>
                <c:pt idx="44">
                  <c:v>47.063160481690801</c:v>
                </c:pt>
                <c:pt idx="45">
                  <c:v>26.273870938546473</c:v>
                </c:pt>
                <c:pt idx="46">
                  <c:v>34.937601432648727</c:v>
                </c:pt>
                <c:pt idx="47">
                  <c:v>32.369419844568952</c:v>
                </c:pt>
                <c:pt idx="48">
                  <c:v>32.337725195691121</c:v>
                </c:pt>
                <c:pt idx="49">
                  <c:v>31.690316156335573</c:v>
                </c:pt>
                <c:pt idx="50">
                  <c:v>49.544324772162383</c:v>
                </c:pt>
                <c:pt idx="51">
                  <c:v>33.234295415959252</c:v>
                </c:pt>
                <c:pt idx="52">
                  <c:v>30.98484022248882</c:v>
                </c:pt>
                <c:pt idx="53">
                  <c:v>48.691099476439788</c:v>
                </c:pt>
                <c:pt idx="54">
                  <c:v>40.10077424112081</c:v>
                </c:pt>
                <c:pt idx="55">
                  <c:v>22.055807594307378</c:v>
                </c:pt>
                <c:pt idx="56">
                  <c:v>37.081935274380342</c:v>
                </c:pt>
                <c:pt idx="57">
                  <c:v>27.964848078335002</c:v>
                </c:pt>
                <c:pt idx="58">
                  <c:v>27.641041223538949</c:v>
                </c:pt>
                <c:pt idx="59">
                  <c:v>31.237327592680668</c:v>
                </c:pt>
                <c:pt idx="60">
                  <c:v>44.913353720693166</c:v>
                </c:pt>
                <c:pt idx="61">
                  <c:v>38.419574809466503</c:v>
                </c:pt>
                <c:pt idx="62">
                  <c:v>32.048471415837525</c:v>
                </c:pt>
                <c:pt idx="63">
                  <c:v>42.518986640057648</c:v>
                </c:pt>
                <c:pt idx="64">
                  <c:v>30.992461820880369</c:v>
                </c:pt>
                <c:pt idx="65">
                  <c:v>30.997050147492626</c:v>
                </c:pt>
                <c:pt idx="66">
                  <c:v>30.912326108055645</c:v>
                </c:pt>
                <c:pt idx="67">
                  <c:v>30.65461742410098</c:v>
                </c:pt>
                <c:pt idx="68">
                  <c:v>22.467078742273582</c:v>
                </c:pt>
                <c:pt idx="69">
                  <c:v>25.335399815953892</c:v>
                </c:pt>
                <c:pt idx="70">
                  <c:v>26.596360362677643</c:v>
                </c:pt>
                <c:pt idx="71">
                  <c:v>28.485983820059069</c:v>
                </c:pt>
                <c:pt idx="72">
                  <c:v>27.121840814786871</c:v>
                </c:pt>
                <c:pt idx="73">
                  <c:v>40.167944505293903</c:v>
                </c:pt>
                <c:pt idx="74">
                  <c:v>34.71607376761655</c:v>
                </c:pt>
                <c:pt idx="75">
                  <c:v>33.653234664970803</c:v>
                </c:pt>
                <c:pt idx="76">
                  <c:v>30.764327519267546</c:v>
                </c:pt>
                <c:pt idx="77">
                  <c:v>40.177175612298072</c:v>
                </c:pt>
                <c:pt idx="78">
                  <c:v>37.752140473080829</c:v>
                </c:pt>
                <c:pt idx="79">
                  <c:v>36.942126269956454</c:v>
                </c:pt>
                <c:pt idx="80">
                  <c:v>19.982899283907514</c:v>
                </c:pt>
                <c:pt idx="81">
                  <c:v>33.205736869578182</c:v>
                </c:pt>
                <c:pt idx="82">
                  <c:v>30.613644154953722</c:v>
                </c:pt>
                <c:pt idx="83">
                  <c:v>29.369593270563495</c:v>
                </c:pt>
                <c:pt idx="84">
                  <c:v>30.643502925013294</c:v>
                </c:pt>
                <c:pt idx="85">
                  <c:v>36.113229417685993</c:v>
                </c:pt>
                <c:pt idx="86">
                  <c:v>34.690072379025807</c:v>
                </c:pt>
                <c:pt idx="87">
                  <c:v>30.772065586740474</c:v>
                </c:pt>
                <c:pt idx="88">
                  <c:v>31.380890052356023</c:v>
                </c:pt>
                <c:pt idx="89">
                  <c:v>34.465713083718974</c:v>
                </c:pt>
                <c:pt idx="90">
                  <c:v>28.37564592226466</c:v>
                </c:pt>
                <c:pt idx="91">
                  <c:v>27.042824208834968</c:v>
                </c:pt>
                <c:pt idx="92">
                  <c:v>45.105025375739061</c:v>
                </c:pt>
                <c:pt idx="93">
                  <c:v>32.672154005307426</c:v>
                </c:pt>
                <c:pt idx="94">
                  <c:v>29.720189726808101</c:v>
                </c:pt>
                <c:pt idx="95">
                  <c:v>38.161009056965597</c:v>
                </c:pt>
                <c:pt idx="96">
                  <c:v>35.163025579097592</c:v>
                </c:pt>
                <c:pt idx="97">
                  <c:v>43.56435643564356</c:v>
                </c:pt>
                <c:pt idx="98">
                  <c:v>26.489734601902857</c:v>
                </c:pt>
                <c:pt idx="99">
                  <c:v>41.598766791455631</c:v>
                </c:pt>
                <c:pt idx="100">
                  <c:v>29.097746338128175</c:v>
                </c:pt>
                <c:pt idx="101">
                  <c:v>26.871911820600534</c:v>
                </c:pt>
                <c:pt idx="102">
                  <c:v>23.725490196078429</c:v>
                </c:pt>
                <c:pt idx="103">
                  <c:v>39.445438282647579</c:v>
                </c:pt>
                <c:pt idx="104">
                  <c:v>46.897546897546903</c:v>
                </c:pt>
                <c:pt idx="105">
                  <c:v>28.472198058132136</c:v>
                </c:pt>
                <c:pt idx="106">
                  <c:v>26.203010991040912</c:v>
                </c:pt>
                <c:pt idx="107">
                  <c:v>40.327323871627662</c:v>
                </c:pt>
                <c:pt idx="108">
                  <c:v>27.784924105994342</c:v>
                </c:pt>
                <c:pt idx="109">
                  <c:v>41.26528534828627</c:v>
                </c:pt>
                <c:pt idx="110">
                  <c:v>38.981715893108301</c:v>
                </c:pt>
                <c:pt idx="111">
                  <c:v>36.220725056143728</c:v>
                </c:pt>
                <c:pt idx="112">
                  <c:v>42.573039466940024</c:v>
                </c:pt>
                <c:pt idx="113">
                  <c:v>35.589160053900287</c:v>
                </c:pt>
                <c:pt idx="114">
                  <c:v>34.310436164577077</c:v>
                </c:pt>
                <c:pt idx="115">
                  <c:v>32.443483256175448</c:v>
                </c:pt>
                <c:pt idx="116">
                  <c:v>35.128097116378825</c:v>
                </c:pt>
                <c:pt idx="117">
                  <c:v>26.280477826869582</c:v>
                </c:pt>
                <c:pt idx="118">
                  <c:v>20.106175250183057</c:v>
                </c:pt>
                <c:pt idx="119">
                  <c:v>33.474857370306488</c:v>
                </c:pt>
                <c:pt idx="120">
                  <c:v>27.09837188471468</c:v>
                </c:pt>
                <c:pt idx="121">
                  <c:v>25.167315175097279</c:v>
                </c:pt>
                <c:pt idx="122">
                  <c:v>34.201893335832786</c:v>
                </c:pt>
                <c:pt idx="123">
                  <c:v>23.454545454545453</c:v>
                </c:pt>
                <c:pt idx="124">
                  <c:v>31.087595858980983</c:v>
                </c:pt>
                <c:pt idx="125">
                  <c:v>25.259409569247406</c:v>
                </c:pt>
                <c:pt idx="126">
                  <c:v>36.111194372627466</c:v>
                </c:pt>
                <c:pt idx="127">
                  <c:v>31.57317741640782</c:v>
                </c:pt>
                <c:pt idx="128">
                  <c:v>25.109902634406854</c:v>
                </c:pt>
                <c:pt idx="129">
                  <c:v>23.988662715794895</c:v>
                </c:pt>
                <c:pt idx="130">
                  <c:v>39.862394149345654</c:v>
                </c:pt>
                <c:pt idx="131">
                  <c:v>24.33369794306752</c:v>
                </c:pt>
                <c:pt idx="132">
                  <c:v>24.302127473679612</c:v>
                </c:pt>
                <c:pt idx="133">
                  <c:v>26.956461596984475</c:v>
                </c:pt>
                <c:pt idx="134">
                  <c:v>32.793566266369616</c:v>
                </c:pt>
                <c:pt idx="135">
                  <c:v>31.249639885858741</c:v>
                </c:pt>
                <c:pt idx="136">
                  <c:v>30.954207448275962</c:v>
                </c:pt>
                <c:pt idx="137">
                  <c:v>34.803499388060374</c:v>
                </c:pt>
                <c:pt idx="138">
                  <c:v>32.08263399530216</c:v>
                </c:pt>
                <c:pt idx="139">
                  <c:v>28.449197860962563</c:v>
                </c:pt>
                <c:pt idx="140">
                  <c:v>24.10247963412553</c:v>
                </c:pt>
                <c:pt idx="141">
                  <c:v>23.432001655971842</c:v>
                </c:pt>
                <c:pt idx="142">
                  <c:v>24.811890385508594</c:v>
                </c:pt>
                <c:pt idx="143">
                  <c:v>26.673806698121396</c:v>
                </c:pt>
                <c:pt idx="144">
                  <c:v>30.284425743175511</c:v>
                </c:pt>
                <c:pt idx="145">
                  <c:v>37.244151360674621</c:v>
                </c:pt>
                <c:pt idx="146">
                  <c:v>29.134460205555083</c:v>
                </c:pt>
                <c:pt idx="147">
                  <c:v>26.895579498539924</c:v>
                </c:pt>
                <c:pt idx="148">
                  <c:v>29.01296111665005</c:v>
                </c:pt>
                <c:pt idx="149">
                  <c:v>32.596971582659201</c:v>
                </c:pt>
                <c:pt idx="150">
                  <c:v>42.383867482895212</c:v>
                </c:pt>
                <c:pt idx="151">
                  <c:v>39.873621077433867</c:v>
                </c:pt>
                <c:pt idx="152">
                  <c:v>40.639923591212991</c:v>
                </c:pt>
                <c:pt idx="153">
                  <c:v>20.316161941087266</c:v>
                </c:pt>
                <c:pt idx="154">
                  <c:v>33.350717079530646</c:v>
                </c:pt>
                <c:pt idx="155">
                  <c:v>30.934739702979908</c:v>
                </c:pt>
                <c:pt idx="156">
                  <c:v>25.502124372344532</c:v>
                </c:pt>
                <c:pt idx="157">
                  <c:v>22.839415701792955</c:v>
                </c:pt>
                <c:pt idx="158">
                  <c:v>39.534782038389224</c:v>
                </c:pt>
                <c:pt idx="159">
                  <c:v>21.626526406447049</c:v>
                </c:pt>
                <c:pt idx="160">
                  <c:v>25.673923240349861</c:v>
                </c:pt>
                <c:pt idx="161">
                  <c:v>27.044604320030885</c:v>
                </c:pt>
                <c:pt idx="162">
                  <c:v>31.185609935996574</c:v>
                </c:pt>
                <c:pt idx="163">
                  <c:v>35.2112676056338</c:v>
                </c:pt>
                <c:pt idx="164">
                  <c:v>44.21113465613562</c:v>
                </c:pt>
                <c:pt idx="165">
                  <c:v>34.795972443031268</c:v>
                </c:pt>
                <c:pt idx="166">
                  <c:v>27.716839325614462</c:v>
                </c:pt>
                <c:pt idx="167">
                  <c:v>30.561305613056128</c:v>
                </c:pt>
                <c:pt idx="168">
                  <c:v>19.120998372219205</c:v>
                </c:pt>
                <c:pt idx="169">
                  <c:v>29.124261841939941</c:v>
                </c:pt>
                <c:pt idx="170">
                  <c:v>22.41469816272966</c:v>
                </c:pt>
                <c:pt idx="171">
                  <c:v>25.248556289813656</c:v>
                </c:pt>
                <c:pt idx="172">
                  <c:v>37.632884479092844</c:v>
                </c:pt>
                <c:pt idx="173">
                  <c:v>28.191757779646764</c:v>
                </c:pt>
                <c:pt idx="174">
                  <c:v>35.400117454331905</c:v>
                </c:pt>
                <c:pt idx="175">
                  <c:v>30.3650610459819</c:v>
                </c:pt>
                <c:pt idx="176">
                  <c:v>27.019418865403882</c:v>
                </c:pt>
                <c:pt idx="177">
                  <c:v>34.876302807759352</c:v>
                </c:pt>
                <c:pt idx="178">
                  <c:v>20.206473004031498</c:v>
                </c:pt>
                <c:pt idx="179">
                  <c:v>41.638104242997279</c:v>
                </c:pt>
                <c:pt idx="180">
                  <c:v>21.174387071780398</c:v>
                </c:pt>
                <c:pt idx="181">
                  <c:v>38.212847148611402</c:v>
                </c:pt>
                <c:pt idx="182">
                  <c:v>35.593394721950723</c:v>
                </c:pt>
                <c:pt idx="183">
                  <c:v>36.133109427465456</c:v>
                </c:pt>
                <c:pt idx="184">
                  <c:v>36.514612315324065</c:v>
                </c:pt>
                <c:pt idx="185">
                  <c:v>25.589738990043951</c:v>
                </c:pt>
                <c:pt idx="186">
                  <c:v>24.002542684261101</c:v>
                </c:pt>
                <c:pt idx="187">
                  <c:v>19.258796585467419</c:v>
                </c:pt>
                <c:pt idx="188">
                  <c:v>30.579167802532773</c:v>
                </c:pt>
                <c:pt idx="189">
                  <c:v>38.833054159687322</c:v>
                </c:pt>
                <c:pt idx="190">
                  <c:v>35.434802529093744</c:v>
                </c:pt>
                <c:pt idx="191">
                  <c:v>24.989946829900362</c:v>
                </c:pt>
                <c:pt idx="192">
                  <c:v>29.985895627644567</c:v>
                </c:pt>
                <c:pt idx="193">
                  <c:v>37.585493876252585</c:v>
                </c:pt>
                <c:pt idx="194">
                  <c:v>45.220933876527738</c:v>
                </c:pt>
                <c:pt idx="195">
                  <c:v>25.377643504531726</c:v>
                </c:pt>
                <c:pt idx="196">
                  <c:v>26.217440543601359</c:v>
                </c:pt>
                <c:pt idx="197">
                  <c:v>19.486539490105191</c:v>
                </c:pt>
                <c:pt idx="198">
                  <c:v>41.981659583985682</c:v>
                </c:pt>
                <c:pt idx="199">
                  <c:v>23.412496177759657</c:v>
                </c:pt>
                <c:pt idx="200">
                  <c:v>16.193832599118945</c:v>
                </c:pt>
                <c:pt idx="201">
                  <c:v>28.562161160279874</c:v>
                </c:pt>
                <c:pt idx="202">
                  <c:v>29.790816472132644</c:v>
                </c:pt>
                <c:pt idx="203">
                  <c:v>25.261733331301937</c:v>
                </c:pt>
                <c:pt idx="204">
                  <c:v>18.865662695736869</c:v>
                </c:pt>
                <c:pt idx="205">
                  <c:v>25.171058378220994</c:v>
                </c:pt>
                <c:pt idx="206">
                  <c:v>26.856109142986359</c:v>
                </c:pt>
                <c:pt idx="207">
                  <c:v>23.430932608266914</c:v>
                </c:pt>
                <c:pt idx="208">
                  <c:v>23.513947295224352</c:v>
                </c:pt>
                <c:pt idx="209">
                  <c:v>29.12152460514293</c:v>
                </c:pt>
                <c:pt idx="210">
                  <c:v>18.796852879058648</c:v>
                </c:pt>
                <c:pt idx="211">
                  <c:v>26.342702808087893</c:v>
                </c:pt>
                <c:pt idx="212">
                  <c:v>25.682822528636798</c:v>
                </c:pt>
                <c:pt idx="213">
                  <c:v>30.814986481266899</c:v>
                </c:pt>
                <c:pt idx="214">
                  <c:v>24.379790395745353</c:v>
                </c:pt>
                <c:pt idx="215">
                  <c:v>36.482127866389789</c:v>
                </c:pt>
                <c:pt idx="216">
                  <c:v>29.514657079646021</c:v>
                </c:pt>
                <c:pt idx="217">
                  <c:v>18.185550082101809</c:v>
                </c:pt>
                <c:pt idx="218">
                  <c:v>26.520940129606345</c:v>
                </c:pt>
                <c:pt idx="219">
                  <c:v>23.84174624829468</c:v>
                </c:pt>
                <c:pt idx="220">
                  <c:v>21.63794899264947</c:v>
                </c:pt>
                <c:pt idx="221">
                  <c:v>30.912405641849894</c:v>
                </c:pt>
                <c:pt idx="222">
                  <c:v>22.676545062365186</c:v>
                </c:pt>
                <c:pt idx="223">
                  <c:v>24.805057955742885</c:v>
                </c:pt>
                <c:pt idx="224">
                  <c:v>25.851525804259847</c:v>
                </c:pt>
                <c:pt idx="225">
                  <c:v>20.019723865877712</c:v>
                </c:pt>
                <c:pt idx="226">
                  <c:v>26.100574212632679</c:v>
                </c:pt>
                <c:pt idx="227">
                  <c:v>23.248862496551244</c:v>
                </c:pt>
                <c:pt idx="228">
                  <c:v>24.932665441639191</c:v>
                </c:pt>
                <c:pt idx="229">
                  <c:v>19.745746221866693</c:v>
                </c:pt>
                <c:pt idx="230">
                  <c:v>18.515375399361027</c:v>
                </c:pt>
                <c:pt idx="231">
                  <c:v>21.603453315047553</c:v>
                </c:pt>
                <c:pt idx="232">
                  <c:v>31.133759428801753</c:v>
                </c:pt>
                <c:pt idx="233">
                  <c:v>19.383273830210733</c:v>
                </c:pt>
                <c:pt idx="234">
                  <c:v>24.163754368447329</c:v>
                </c:pt>
                <c:pt idx="235">
                  <c:v>45.560277342876319</c:v>
                </c:pt>
                <c:pt idx="236">
                  <c:v>11.54661915669806</c:v>
                </c:pt>
                <c:pt idx="237">
                  <c:v>30.788086363788992</c:v>
                </c:pt>
                <c:pt idx="238">
                  <c:v>26.840158608510205</c:v>
                </c:pt>
                <c:pt idx="239">
                  <c:v>16.156446161274747</c:v>
                </c:pt>
                <c:pt idx="240">
                  <c:v>16.555435952637247</c:v>
                </c:pt>
                <c:pt idx="241">
                  <c:v>9.1700281139225037</c:v>
                </c:pt>
                <c:pt idx="242">
                  <c:v>18.188024577326214</c:v>
                </c:pt>
                <c:pt idx="243">
                  <c:v>16.097280597765565</c:v>
                </c:pt>
                <c:pt idx="244">
                  <c:v>11.962113345290915</c:v>
                </c:pt>
                <c:pt idx="245">
                  <c:v>12.243063505319228</c:v>
                </c:pt>
                <c:pt idx="246">
                  <c:v>43.372295448893311</c:v>
                </c:pt>
                <c:pt idx="247">
                  <c:v>39.860424147977504</c:v>
                </c:pt>
                <c:pt idx="248">
                  <c:v>38.542056074766364</c:v>
                </c:pt>
                <c:pt idx="249">
                  <c:v>37.848442107962555</c:v>
                </c:pt>
                <c:pt idx="250">
                  <c:v>48.457026268808974</c:v>
                </c:pt>
                <c:pt idx="251">
                  <c:v>35.879743716116316</c:v>
                </c:pt>
                <c:pt idx="252">
                  <c:v>37.195317682809389</c:v>
                </c:pt>
                <c:pt idx="253">
                  <c:v>45.325588878742771</c:v>
                </c:pt>
                <c:pt idx="254">
                  <c:v>37.434816960758496</c:v>
                </c:pt>
                <c:pt idx="255">
                  <c:v>34.410850522746543</c:v>
                </c:pt>
                <c:pt idx="256">
                  <c:v>33.621755253399257</c:v>
                </c:pt>
                <c:pt idx="257">
                  <c:v>30.835194529462051</c:v>
                </c:pt>
                <c:pt idx="258">
                  <c:v>25.738396624472575</c:v>
                </c:pt>
                <c:pt idx="259">
                  <c:v>35.368693402328596</c:v>
                </c:pt>
                <c:pt idx="260">
                  <c:v>22.087757451707819</c:v>
                </c:pt>
                <c:pt idx="261">
                  <c:v>28.225261998715311</c:v>
                </c:pt>
                <c:pt idx="262">
                  <c:v>40.509353284846469</c:v>
                </c:pt>
                <c:pt idx="263">
                  <c:v>25.270367700072097</c:v>
                </c:pt>
                <c:pt idx="264">
                  <c:v>22.661466643030195</c:v>
                </c:pt>
                <c:pt idx="265">
                  <c:v>24.213393444162676</c:v>
                </c:pt>
                <c:pt idx="266">
                  <c:v>13.042393202340927</c:v>
                </c:pt>
                <c:pt idx="267">
                  <c:v>29.07185215832299</c:v>
                </c:pt>
                <c:pt idx="268">
                  <c:v>18.720773985487774</c:v>
                </c:pt>
                <c:pt idx="269">
                  <c:v>31.231655614740735</c:v>
                </c:pt>
                <c:pt idx="270">
                  <c:v>53.086991775744238</c:v>
                </c:pt>
                <c:pt idx="271">
                  <c:v>29.68863194445608</c:v>
                </c:pt>
                <c:pt idx="272">
                  <c:v>39.369834419339369</c:v>
                </c:pt>
                <c:pt idx="273">
                  <c:v>22.376797925017684</c:v>
                </c:pt>
                <c:pt idx="274">
                  <c:v>19.345430978613088</c:v>
                </c:pt>
                <c:pt idx="275">
                  <c:v>18.452281464148417</c:v>
                </c:pt>
                <c:pt idx="276">
                  <c:v>29.973974470194573</c:v>
                </c:pt>
                <c:pt idx="277">
                  <c:v>36.4208984375</c:v>
                </c:pt>
                <c:pt idx="278">
                  <c:v>40.945841178425077</c:v>
                </c:pt>
                <c:pt idx="279">
                  <c:v>56.597289762043708</c:v>
                </c:pt>
                <c:pt idx="280">
                  <c:v>20.470551466572413</c:v>
                </c:pt>
                <c:pt idx="281">
                  <c:v>41.055045871559628</c:v>
                </c:pt>
                <c:pt idx="282">
                  <c:v>35.952435867866022</c:v>
                </c:pt>
                <c:pt idx="283">
                  <c:v>35.155487379723887</c:v>
                </c:pt>
                <c:pt idx="284">
                  <c:v>22.931377874343656</c:v>
                </c:pt>
                <c:pt idx="285">
                  <c:v>30.873786407766996</c:v>
                </c:pt>
                <c:pt idx="286">
                  <c:v>20.320616156188432</c:v>
                </c:pt>
                <c:pt idx="287">
                  <c:v>33.326295788029142</c:v>
                </c:pt>
                <c:pt idx="288">
                  <c:v>29.34261980239258</c:v>
                </c:pt>
                <c:pt idx="289">
                  <c:v>42.039623984120446</c:v>
                </c:pt>
                <c:pt idx="290">
                  <c:v>63.069739112780432</c:v>
                </c:pt>
                <c:pt idx="291">
                  <c:v>46.122260668973475</c:v>
                </c:pt>
                <c:pt idx="292">
                  <c:v>49.001832384993726</c:v>
                </c:pt>
                <c:pt idx="293">
                  <c:v>13.751087464289522</c:v>
                </c:pt>
                <c:pt idx="294">
                  <c:v>23.443558301547771</c:v>
                </c:pt>
                <c:pt idx="295">
                  <c:v>40.936012077575185</c:v>
                </c:pt>
                <c:pt idx="296">
                  <c:v>44.825253664036083</c:v>
                </c:pt>
                <c:pt idx="297">
                  <c:v>35.488721804511279</c:v>
                </c:pt>
                <c:pt idx="298">
                  <c:v>44.872791912009781</c:v>
                </c:pt>
                <c:pt idx="299">
                  <c:v>49.440488301119025</c:v>
                </c:pt>
                <c:pt idx="300">
                  <c:v>46.730348614024912</c:v>
                </c:pt>
                <c:pt idx="301">
                  <c:v>42.305129913391077</c:v>
                </c:pt>
                <c:pt idx="302">
                  <c:v>44.367953706475113</c:v>
                </c:pt>
                <c:pt idx="303">
                  <c:v>38.183948447568845</c:v>
                </c:pt>
                <c:pt idx="304">
                  <c:v>45.048066174826737</c:v>
                </c:pt>
                <c:pt idx="305">
                  <c:v>33.254800173413088</c:v>
                </c:pt>
                <c:pt idx="306">
                  <c:v>58.88768273789546</c:v>
                </c:pt>
                <c:pt idx="307">
                  <c:v>38.574071683662496</c:v>
                </c:pt>
                <c:pt idx="308">
                  <c:v>46.666666666666664</c:v>
                </c:pt>
                <c:pt idx="309">
                  <c:v>42.387515842839044</c:v>
                </c:pt>
                <c:pt idx="310">
                  <c:v>58.622103752306749</c:v>
                </c:pt>
                <c:pt idx="311">
                  <c:v>33.024933354241803</c:v>
                </c:pt>
                <c:pt idx="312">
                  <c:v>31.013334252144855</c:v>
                </c:pt>
                <c:pt idx="313">
                  <c:v>32.577674869420065</c:v>
                </c:pt>
                <c:pt idx="314">
                  <c:v>37.778624499904744</c:v>
                </c:pt>
                <c:pt idx="315">
                  <c:v>25.712095073797197</c:v>
                </c:pt>
                <c:pt idx="316">
                  <c:v>31.127997769102063</c:v>
                </c:pt>
                <c:pt idx="317">
                  <c:v>39.845437925876681</c:v>
                </c:pt>
                <c:pt idx="318">
                  <c:v>28.412645590682196</c:v>
                </c:pt>
                <c:pt idx="319">
                  <c:v>29.273889526307165</c:v>
                </c:pt>
                <c:pt idx="320">
                  <c:v>33.137359700694816</c:v>
                </c:pt>
                <c:pt idx="321">
                  <c:v>40.247703080098759</c:v>
                </c:pt>
                <c:pt idx="322">
                  <c:v>32.522988505747129</c:v>
                </c:pt>
                <c:pt idx="323">
                  <c:v>34.781757682521047</c:v>
                </c:pt>
                <c:pt idx="324">
                  <c:v>29.439991072590995</c:v>
                </c:pt>
                <c:pt idx="325">
                  <c:v>26.327970024245097</c:v>
                </c:pt>
                <c:pt idx="326">
                  <c:v>36.422811619547261</c:v>
                </c:pt>
                <c:pt idx="327">
                  <c:v>35.470527404343322</c:v>
                </c:pt>
                <c:pt idx="328">
                  <c:v>31.291866028708142</c:v>
                </c:pt>
                <c:pt idx="329">
                  <c:v>33.800522239828595</c:v>
                </c:pt>
                <c:pt idx="330">
                  <c:v>28.036454018227012</c:v>
                </c:pt>
                <c:pt idx="331">
                  <c:v>45.897379431843206</c:v>
                </c:pt>
                <c:pt idx="332">
                  <c:v>40.118526153053338</c:v>
                </c:pt>
                <c:pt idx="333">
                  <c:v>35.122556624263105</c:v>
                </c:pt>
                <c:pt idx="334">
                  <c:v>36.129032258064512</c:v>
                </c:pt>
                <c:pt idx="335">
                  <c:v>44.094215448562522</c:v>
                </c:pt>
                <c:pt idx="336">
                  <c:v>36.386295879966767</c:v>
                </c:pt>
                <c:pt idx="337">
                  <c:v>28.006890262437935</c:v>
                </c:pt>
                <c:pt idx="338">
                  <c:v>24.348308374930674</c:v>
                </c:pt>
                <c:pt idx="339">
                  <c:v>40.769477871951374</c:v>
                </c:pt>
                <c:pt idx="340">
                  <c:v>23.742088378948587</c:v>
                </c:pt>
                <c:pt idx="341">
                  <c:v>20.994590968174769</c:v>
                </c:pt>
                <c:pt idx="342">
                  <c:v>26.817694780345931</c:v>
                </c:pt>
                <c:pt idx="343">
                  <c:v>44.53611719144638</c:v>
                </c:pt>
                <c:pt idx="344">
                  <c:v>31.128876982964297</c:v>
                </c:pt>
                <c:pt idx="345">
                  <c:v>25.610466006924234</c:v>
                </c:pt>
                <c:pt idx="346">
                  <c:v>24.088760714571816</c:v>
                </c:pt>
                <c:pt idx="347">
                  <c:v>25.805252725470762</c:v>
                </c:pt>
                <c:pt idx="348">
                  <c:v>36.664078587583973</c:v>
                </c:pt>
                <c:pt idx="349">
                  <c:v>19.49378712658191</c:v>
                </c:pt>
                <c:pt idx="350">
                  <c:v>21.268115942028988</c:v>
                </c:pt>
                <c:pt idx="351">
                  <c:v>27.927224690764977</c:v>
                </c:pt>
                <c:pt idx="352">
                  <c:v>41.243655834847274</c:v>
                </c:pt>
                <c:pt idx="353">
                  <c:v>27.612805646584317</c:v>
                </c:pt>
                <c:pt idx="354">
                  <c:v>27.659325210871604</c:v>
                </c:pt>
                <c:pt idx="355">
                  <c:v>31.01715520734837</c:v>
                </c:pt>
                <c:pt idx="356">
                  <c:v>29.13807531380753</c:v>
                </c:pt>
                <c:pt idx="357">
                  <c:v>30.018965050121913</c:v>
                </c:pt>
                <c:pt idx="358">
                  <c:v>35.970485755277721</c:v>
                </c:pt>
                <c:pt idx="359">
                  <c:v>27.531120767470664</c:v>
                </c:pt>
                <c:pt idx="360">
                  <c:v>15.857202158572019</c:v>
                </c:pt>
                <c:pt idx="361">
                  <c:v>28.731960527066338</c:v>
                </c:pt>
                <c:pt idx="362">
                  <c:v>25.696277329131373</c:v>
                </c:pt>
                <c:pt idx="363">
                  <c:v>24.015285126396236</c:v>
                </c:pt>
                <c:pt idx="364">
                  <c:v>27.251398664500989</c:v>
                </c:pt>
                <c:pt idx="365">
                  <c:v>21.546247442661784</c:v>
                </c:pt>
                <c:pt idx="366">
                  <c:v>22.214262973575295</c:v>
                </c:pt>
                <c:pt idx="367">
                  <c:v>37.607004312680154</c:v>
                </c:pt>
                <c:pt idx="368">
                  <c:v>26.25414520567276</c:v>
                </c:pt>
                <c:pt idx="369">
                  <c:v>18.74188963727368</c:v>
                </c:pt>
                <c:pt idx="370">
                  <c:v>29.477798937556383</c:v>
                </c:pt>
                <c:pt idx="371">
                  <c:v>27.638804148871262</c:v>
                </c:pt>
                <c:pt idx="372">
                  <c:v>40.630168706582865</c:v>
                </c:pt>
                <c:pt idx="373">
                  <c:v>23.418138110637322</c:v>
                </c:pt>
                <c:pt idx="374">
                  <c:v>27.214274232438516</c:v>
                </c:pt>
                <c:pt idx="375">
                  <c:v>28.229840745330215</c:v>
                </c:pt>
                <c:pt idx="376">
                  <c:v>20.154744747022683</c:v>
                </c:pt>
                <c:pt idx="377">
                  <c:v>25.863247863247864</c:v>
                </c:pt>
                <c:pt idx="378">
                  <c:v>21.187202878067588</c:v>
                </c:pt>
                <c:pt idx="379">
                  <c:v>24.280465401102269</c:v>
                </c:pt>
                <c:pt idx="380">
                  <c:v>34.414984830497296</c:v>
                </c:pt>
                <c:pt idx="381">
                  <c:v>19.840672046828409</c:v>
                </c:pt>
                <c:pt idx="382">
                  <c:v>27.837148063951886</c:v>
                </c:pt>
                <c:pt idx="383">
                  <c:v>30.623863366806354</c:v>
                </c:pt>
                <c:pt idx="384">
                  <c:v>23.547323014463334</c:v>
                </c:pt>
                <c:pt idx="385">
                  <c:v>34.367810465514708</c:v>
                </c:pt>
                <c:pt idx="386">
                  <c:v>26.453603702887367</c:v>
                </c:pt>
                <c:pt idx="387">
                  <c:v>28.66945606694561</c:v>
                </c:pt>
                <c:pt idx="388">
                  <c:v>33.029092983456927</c:v>
                </c:pt>
                <c:pt idx="389">
                  <c:v>16.475614839516467</c:v>
                </c:pt>
                <c:pt idx="390">
                  <c:v>19.824753559693317</c:v>
                </c:pt>
                <c:pt idx="391">
                  <c:v>37.291280148423006</c:v>
                </c:pt>
                <c:pt idx="392">
                  <c:v>27.368354350167923</c:v>
                </c:pt>
                <c:pt idx="393">
                  <c:v>21.06542407721647</c:v>
                </c:pt>
                <c:pt idx="394">
                  <c:v>30.219200067576132</c:v>
                </c:pt>
                <c:pt idx="395">
                  <c:v>28.397642239036834</c:v>
                </c:pt>
                <c:pt idx="396">
                  <c:v>20.459278437552765</c:v>
                </c:pt>
                <c:pt idx="397">
                  <c:v>17.130835503907029</c:v>
                </c:pt>
                <c:pt idx="398">
                  <c:v>32.780110207294676</c:v>
                </c:pt>
                <c:pt idx="399">
                  <c:v>18.961864406779657</c:v>
                </c:pt>
                <c:pt idx="400">
                  <c:v>28.488855537753256</c:v>
                </c:pt>
                <c:pt idx="401">
                  <c:v>23.747437749924394</c:v>
                </c:pt>
                <c:pt idx="402">
                  <c:v>18.757612667478686</c:v>
                </c:pt>
                <c:pt idx="403">
                  <c:v>22.077756882265795</c:v>
                </c:pt>
                <c:pt idx="404">
                  <c:v>25.172026846774365</c:v>
                </c:pt>
                <c:pt idx="405">
                  <c:v>30.626675293465201</c:v>
                </c:pt>
                <c:pt idx="406">
                  <c:v>23.109455241164028</c:v>
                </c:pt>
                <c:pt idx="407">
                  <c:v>20.987370838117105</c:v>
                </c:pt>
                <c:pt idx="408">
                  <c:v>21.78926441351889</c:v>
                </c:pt>
                <c:pt idx="409">
                  <c:v>16.688654353562004</c:v>
                </c:pt>
                <c:pt idx="410">
                  <c:v>42.368379940634277</c:v>
                </c:pt>
                <c:pt idx="411">
                  <c:v>31.190815385904635</c:v>
                </c:pt>
                <c:pt idx="412">
                  <c:v>37.85246368555967</c:v>
                </c:pt>
                <c:pt idx="413">
                  <c:v>48.829558395545988</c:v>
                </c:pt>
                <c:pt idx="414">
                  <c:v>52.740670059372356</c:v>
                </c:pt>
                <c:pt idx="415">
                  <c:v>32.587893206449905</c:v>
                </c:pt>
                <c:pt idx="416">
                  <c:v>30.1</c:v>
                </c:pt>
                <c:pt idx="417">
                  <c:v>35.580320739331341</c:v>
                </c:pt>
                <c:pt idx="418">
                  <c:v>38.64766324163076</c:v>
                </c:pt>
                <c:pt idx="419">
                  <c:v>29.110524609899525</c:v>
                </c:pt>
                <c:pt idx="420">
                  <c:v>49.275362318840585</c:v>
                </c:pt>
                <c:pt idx="421">
                  <c:v>30.966164929885505</c:v>
                </c:pt>
                <c:pt idx="422">
                  <c:v>27.839887420842782</c:v>
                </c:pt>
                <c:pt idx="423">
                  <c:v>36.756126021003503</c:v>
                </c:pt>
                <c:pt idx="424">
                  <c:v>44.285420098846792</c:v>
                </c:pt>
                <c:pt idx="425">
                  <c:v>35.287561301827907</c:v>
                </c:pt>
                <c:pt idx="426">
                  <c:v>22.418090361172798</c:v>
                </c:pt>
                <c:pt idx="427">
                  <c:v>27.031509121061358</c:v>
                </c:pt>
                <c:pt idx="428">
                  <c:v>28.885526081538192</c:v>
                </c:pt>
                <c:pt idx="429">
                  <c:v>32.882424735557365</c:v>
                </c:pt>
                <c:pt idx="430">
                  <c:v>24.302295252999478</c:v>
                </c:pt>
                <c:pt idx="431">
                  <c:v>35.819495262219718</c:v>
                </c:pt>
                <c:pt idx="432">
                  <c:v>34.785148101793908</c:v>
                </c:pt>
                <c:pt idx="433">
                  <c:v>31.355229476872047</c:v>
                </c:pt>
                <c:pt idx="434">
                  <c:v>34.865078757243879</c:v>
                </c:pt>
                <c:pt idx="435">
                  <c:v>31.151105897164438</c:v>
                </c:pt>
                <c:pt idx="436">
                  <c:v>35.534250140991716</c:v>
                </c:pt>
                <c:pt idx="437">
                  <c:v>41.903839166767597</c:v>
                </c:pt>
                <c:pt idx="438">
                  <c:v>43.395923607767614</c:v>
                </c:pt>
                <c:pt idx="439">
                  <c:v>32.927974947807932</c:v>
                </c:pt>
                <c:pt idx="440">
                  <c:v>23.651370737938485</c:v>
                </c:pt>
                <c:pt idx="441">
                  <c:v>26.518422567645363</c:v>
                </c:pt>
                <c:pt idx="442">
                  <c:v>36.155881645417367</c:v>
                </c:pt>
                <c:pt idx="443">
                  <c:v>24.131025604348444</c:v>
                </c:pt>
                <c:pt idx="444">
                  <c:v>24.197227583786628</c:v>
                </c:pt>
                <c:pt idx="445">
                  <c:v>20.424671385237612</c:v>
                </c:pt>
                <c:pt idx="446">
                  <c:v>24.326979760267243</c:v>
                </c:pt>
                <c:pt idx="447">
                  <c:v>22.176271389613113</c:v>
                </c:pt>
                <c:pt idx="448">
                  <c:v>26.052022334195836</c:v>
                </c:pt>
                <c:pt idx="449">
                  <c:v>28.235039965435305</c:v>
                </c:pt>
                <c:pt idx="450">
                  <c:v>19.362786953233634</c:v>
                </c:pt>
                <c:pt idx="451">
                  <c:v>12.958212660322715</c:v>
                </c:pt>
                <c:pt idx="452">
                  <c:v>18.29824352721938</c:v>
                </c:pt>
                <c:pt idx="453">
                  <c:v>34.189056891112806</c:v>
                </c:pt>
                <c:pt idx="454">
                  <c:v>47.513375486381321</c:v>
                </c:pt>
                <c:pt idx="455">
                  <c:v>42.511843238587424</c:v>
                </c:pt>
                <c:pt idx="456">
                  <c:v>32.516172965611169</c:v>
                </c:pt>
                <c:pt idx="457">
                  <c:v>38.702405836304763</c:v>
                </c:pt>
                <c:pt idx="458">
                  <c:v>39.172965762561148</c:v>
                </c:pt>
                <c:pt idx="459">
                  <c:v>50.644043706138397</c:v>
                </c:pt>
                <c:pt idx="460">
                  <c:v>32.385811467444121</c:v>
                </c:pt>
                <c:pt idx="461">
                  <c:v>26.705816554809843</c:v>
                </c:pt>
                <c:pt idx="462">
                  <c:v>38.522208385222079</c:v>
                </c:pt>
                <c:pt idx="463">
                  <c:v>47.074578894113451</c:v>
                </c:pt>
                <c:pt idx="464">
                  <c:v>28.715198707118201</c:v>
                </c:pt>
                <c:pt idx="465">
                  <c:v>52.227140032018085</c:v>
                </c:pt>
                <c:pt idx="466">
                  <c:v>49.554117061246657</c:v>
                </c:pt>
                <c:pt idx="467">
                  <c:v>25.632113405574867</c:v>
                </c:pt>
                <c:pt idx="468">
                  <c:v>34.173103584868294</c:v>
                </c:pt>
                <c:pt idx="469">
                  <c:v>45.332976731746456</c:v>
                </c:pt>
                <c:pt idx="470">
                  <c:v>38.977676306443421</c:v>
                </c:pt>
                <c:pt idx="471">
                  <c:v>18.998057865644142</c:v>
                </c:pt>
                <c:pt idx="472">
                  <c:v>40.234308676212578</c:v>
                </c:pt>
                <c:pt idx="473">
                  <c:v>43.141153081510943</c:v>
                </c:pt>
                <c:pt idx="474">
                  <c:v>14.32406822488945</c:v>
                </c:pt>
                <c:pt idx="475">
                  <c:v>50.242846094354213</c:v>
                </c:pt>
                <c:pt idx="476">
                  <c:v>30.768032403801215</c:v>
                </c:pt>
                <c:pt idx="477">
                  <c:v>29.304623904373607</c:v>
                </c:pt>
                <c:pt idx="478">
                  <c:v>40.359616085530313</c:v>
                </c:pt>
                <c:pt idx="479">
                  <c:v>38.05967348470633</c:v>
                </c:pt>
                <c:pt idx="480">
                  <c:v>52.442501425584489</c:v>
                </c:pt>
                <c:pt idx="481">
                  <c:v>31.844802342606151</c:v>
                </c:pt>
                <c:pt idx="482">
                  <c:v>24.874256973022405</c:v>
                </c:pt>
                <c:pt idx="483">
                  <c:v>35.68651705248277</c:v>
                </c:pt>
                <c:pt idx="484">
                  <c:v>35.428530682649416</c:v>
                </c:pt>
                <c:pt idx="485">
                  <c:v>44.386202207099899</c:v>
                </c:pt>
                <c:pt idx="486">
                  <c:v>25.758172508861755</c:v>
                </c:pt>
                <c:pt idx="487">
                  <c:v>34.285949370560324</c:v>
                </c:pt>
                <c:pt idx="488">
                  <c:v>28.934974171984198</c:v>
                </c:pt>
                <c:pt idx="489">
                  <c:v>34.677019659672887</c:v>
                </c:pt>
                <c:pt idx="490">
                  <c:v>20.819606267577342</c:v>
                </c:pt>
                <c:pt idx="491">
                  <c:v>31.544610860975833</c:v>
                </c:pt>
                <c:pt idx="492">
                  <c:v>31.87917154063167</c:v>
                </c:pt>
                <c:pt idx="493">
                  <c:v>46.92458161269289</c:v>
                </c:pt>
                <c:pt idx="494">
                  <c:v>44.491488810161584</c:v>
                </c:pt>
                <c:pt idx="495">
                  <c:v>29.792088158064651</c:v>
                </c:pt>
                <c:pt idx="496">
                  <c:v>21.914281387248224</c:v>
                </c:pt>
                <c:pt idx="497">
                  <c:v>53.20916521506097</c:v>
                </c:pt>
                <c:pt idx="498">
                  <c:v>40.074331518400783</c:v>
                </c:pt>
                <c:pt idx="499">
                  <c:v>37.417872285335136</c:v>
                </c:pt>
                <c:pt idx="500">
                  <c:v>38.769912438020889</c:v>
                </c:pt>
                <c:pt idx="501">
                  <c:v>40.68627450980393</c:v>
                </c:pt>
                <c:pt idx="502">
                  <c:v>30.827360928282388</c:v>
                </c:pt>
                <c:pt idx="503">
                  <c:v>31.511496419148134</c:v>
                </c:pt>
                <c:pt idx="504">
                  <c:v>32.221006564551423</c:v>
                </c:pt>
                <c:pt idx="505">
                  <c:v>19.552906110283157</c:v>
                </c:pt>
                <c:pt idx="506">
                  <c:v>30.844628225744696</c:v>
                </c:pt>
                <c:pt idx="507">
                  <c:v>37.865087621029048</c:v>
                </c:pt>
                <c:pt idx="508">
                  <c:v>35.721469278291266</c:v>
                </c:pt>
                <c:pt idx="509">
                  <c:v>39.808661359818892</c:v>
                </c:pt>
                <c:pt idx="510">
                  <c:v>32.196927217674101</c:v>
                </c:pt>
                <c:pt idx="511">
                  <c:v>36.677602568172993</c:v>
                </c:pt>
                <c:pt idx="512">
                  <c:v>37.946458827516096</c:v>
                </c:pt>
                <c:pt idx="513">
                  <c:v>32.276243480695861</c:v>
                </c:pt>
                <c:pt idx="514">
                  <c:v>38.065996356029423</c:v>
                </c:pt>
                <c:pt idx="515">
                  <c:v>20.578043205780435</c:v>
                </c:pt>
                <c:pt idx="516">
                  <c:v>39.27654609101517</c:v>
                </c:pt>
                <c:pt idx="517">
                  <c:v>55.945263717284448</c:v>
                </c:pt>
                <c:pt idx="518">
                  <c:v>40.036563071297991</c:v>
                </c:pt>
                <c:pt idx="519">
                  <c:v>40.160732224578638</c:v>
                </c:pt>
                <c:pt idx="520">
                  <c:v>21.904018728053057</c:v>
                </c:pt>
                <c:pt idx="521">
                  <c:v>30.585361837591591</c:v>
                </c:pt>
                <c:pt idx="522">
                  <c:v>29.097472924187723</c:v>
                </c:pt>
                <c:pt idx="523">
                  <c:v>30.796711085908701</c:v>
                </c:pt>
                <c:pt idx="524">
                  <c:v>24.380105017502917</c:v>
                </c:pt>
                <c:pt idx="525">
                  <c:v>40.085703155434359</c:v>
                </c:pt>
                <c:pt idx="526">
                  <c:v>26.973244147157192</c:v>
                </c:pt>
                <c:pt idx="527">
                  <c:v>41.182693324870414</c:v>
                </c:pt>
                <c:pt idx="528">
                  <c:v>29.562127226251583</c:v>
                </c:pt>
                <c:pt idx="529">
                  <c:v>30.013279411768483</c:v>
                </c:pt>
                <c:pt idx="530">
                  <c:v>26.013234077750205</c:v>
                </c:pt>
                <c:pt idx="531">
                  <c:v>29.443034916032374</c:v>
                </c:pt>
                <c:pt idx="532">
                  <c:v>28.412562629842359</c:v>
                </c:pt>
                <c:pt idx="533">
                  <c:v>30.904651030722931</c:v>
                </c:pt>
                <c:pt idx="534">
                  <c:v>27.667625638234451</c:v>
                </c:pt>
                <c:pt idx="535">
                  <c:v>27.60555398129782</c:v>
                </c:pt>
                <c:pt idx="536">
                  <c:v>38.466693472724842</c:v>
                </c:pt>
                <c:pt idx="537">
                  <c:v>35.099241983856366</c:v>
                </c:pt>
                <c:pt idx="538">
                  <c:v>27.356441664494834</c:v>
                </c:pt>
                <c:pt idx="539">
                  <c:v>37.498906099588687</c:v>
                </c:pt>
                <c:pt idx="540">
                  <c:v>32.44661876369566</c:v>
                </c:pt>
                <c:pt idx="541">
                  <c:v>38.496743531068468</c:v>
                </c:pt>
                <c:pt idx="542">
                  <c:v>37.535145267104028</c:v>
                </c:pt>
                <c:pt idx="543">
                  <c:v>23.908452713886192</c:v>
                </c:pt>
                <c:pt idx="544">
                  <c:v>50.95621784292787</c:v>
                </c:pt>
                <c:pt idx="545">
                  <c:v>26.970286971980023</c:v>
                </c:pt>
                <c:pt idx="546">
                  <c:v>40.218813176358651</c:v>
                </c:pt>
                <c:pt idx="547">
                  <c:v>31.844888366627497</c:v>
                </c:pt>
                <c:pt idx="548">
                  <c:v>32.398972202756362</c:v>
                </c:pt>
                <c:pt idx="549">
                  <c:v>34.572636001661088</c:v>
                </c:pt>
                <c:pt idx="550">
                  <c:v>25.551367391130004</c:v>
                </c:pt>
                <c:pt idx="551">
                  <c:v>17.429165009061578</c:v>
                </c:pt>
                <c:pt idx="552">
                  <c:v>33.062377636241976</c:v>
                </c:pt>
                <c:pt idx="553">
                  <c:v>25.591068301225921</c:v>
                </c:pt>
                <c:pt idx="554">
                  <c:v>20.326489818015244</c:v>
                </c:pt>
                <c:pt idx="555">
                  <c:v>29.092103102938765</c:v>
                </c:pt>
                <c:pt idx="556">
                  <c:v>33.910698231944863</c:v>
                </c:pt>
                <c:pt idx="557">
                  <c:v>24.831727412372576</c:v>
                </c:pt>
                <c:pt idx="558">
                  <c:v>37.661843107387661</c:v>
                </c:pt>
                <c:pt idx="559">
                  <c:v>23.094688221709006</c:v>
                </c:pt>
                <c:pt idx="560">
                  <c:v>16.179598078807139</c:v>
                </c:pt>
                <c:pt idx="561">
                  <c:v>14.156998998881102</c:v>
                </c:pt>
                <c:pt idx="562">
                  <c:v>31.47539022785719</c:v>
                </c:pt>
                <c:pt idx="563">
                  <c:v>26.01998129829224</c:v>
                </c:pt>
                <c:pt idx="564">
                  <c:v>25.165489112265142</c:v>
                </c:pt>
                <c:pt idx="565">
                  <c:v>23.159960745829245</c:v>
                </c:pt>
                <c:pt idx="566">
                  <c:v>30.776092774308655</c:v>
                </c:pt>
                <c:pt idx="567">
                  <c:v>26.810592364139104</c:v>
                </c:pt>
                <c:pt idx="568">
                  <c:v>27.347686669720566</c:v>
                </c:pt>
                <c:pt idx="569">
                  <c:v>17.408269872238659</c:v>
                </c:pt>
                <c:pt idx="570">
                  <c:v>28.98205785426584</c:v>
                </c:pt>
                <c:pt idx="571">
                  <c:v>31.376404494382026</c:v>
                </c:pt>
                <c:pt idx="572">
                  <c:v>30.34027211242401</c:v>
                </c:pt>
                <c:pt idx="573">
                  <c:v>21.073266356285227</c:v>
                </c:pt>
                <c:pt idx="574">
                  <c:v>22.667413841412163</c:v>
                </c:pt>
                <c:pt idx="575">
                  <c:v>33.498969181159808</c:v>
                </c:pt>
                <c:pt idx="576">
                  <c:v>32.837513340448233</c:v>
                </c:pt>
                <c:pt idx="577">
                  <c:v>32.208480565371026</c:v>
                </c:pt>
                <c:pt idx="578">
                  <c:v>21.948763843830406</c:v>
                </c:pt>
                <c:pt idx="579">
                  <c:v>16.532782495600951</c:v>
                </c:pt>
                <c:pt idx="580">
                  <c:v>27.127134189360795</c:v>
                </c:pt>
                <c:pt idx="581">
                  <c:v>26.753683250293264</c:v>
                </c:pt>
                <c:pt idx="582">
                  <c:v>28.171433878157504</c:v>
                </c:pt>
                <c:pt idx="583">
                  <c:v>30.915714522271902</c:v>
                </c:pt>
                <c:pt idx="584">
                  <c:v>30.904246738473077</c:v>
                </c:pt>
                <c:pt idx="585">
                  <c:v>25.388525450749945</c:v>
                </c:pt>
                <c:pt idx="586">
                  <c:v>21.829394883067714</c:v>
                </c:pt>
                <c:pt idx="587">
                  <c:v>28.419920824984118</c:v>
                </c:pt>
                <c:pt idx="588">
                  <c:v>21.998833604469134</c:v>
                </c:pt>
                <c:pt idx="589">
                  <c:v>24.688338330440271</c:v>
                </c:pt>
                <c:pt idx="590">
                  <c:v>26.274263684045369</c:v>
                </c:pt>
                <c:pt idx="591">
                  <c:v>22.223631367575567</c:v>
                </c:pt>
                <c:pt idx="592">
                  <c:v>25.986984815618225</c:v>
                </c:pt>
                <c:pt idx="593">
                  <c:v>30.435593694618042</c:v>
                </c:pt>
                <c:pt idx="594">
                  <c:v>21.602929210740438</c:v>
                </c:pt>
                <c:pt idx="595">
                  <c:v>40.981436540704095</c:v>
                </c:pt>
                <c:pt idx="596">
                  <c:v>32.497766906781123</c:v>
                </c:pt>
                <c:pt idx="597">
                  <c:v>27.759336099585063</c:v>
                </c:pt>
                <c:pt idx="598">
                  <c:v>18.293401413982721</c:v>
                </c:pt>
                <c:pt idx="599">
                  <c:v>16.356589147286826</c:v>
                </c:pt>
                <c:pt idx="600">
                  <c:v>22.432418977448101</c:v>
                </c:pt>
                <c:pt idx="601">
                  <c:v>21.455915040750806</c:v>
                </c:pt>
                <c:pt idx="602">
                  <c:v>19.261309496801125</c:v>
                </c:pt>
                <c:pt idx="603">
                  <c:v>24.341782737837761</c:v>
                </c:pt>
                <c:pt idx="604">
                  <c:v>23.934839278806315</c:v>
                </c:pt>
                <c:pt idx="605">
                  <c:v>22.623974442750306</c:v>
                </c:pt>
                <c:pt idx="606">
                  <c:v>43.120518948446573</c:v>
                </c:pt>
                <c:pt idx="607">
                  <c:v>24.448485806910732</c:v>
                </c:pt>
                <c:pt idx="608">
                  <c:v>23.829595062471778</c:v>
                </c:pt>
                <c:pt idx="609">
                  <c:v>18.019754276078054</c:v>
                </c:pt>
                <c:pt idx="610">
                  <c:v>18.080079582193484</c:v>
                </c:pt>
                <c:pt idx="611">
                  <c:v>21.596500820120287</c:v>
                </c:pt>
                <c:pt idx="612">
                  <c:v>14.977417640807648</c:v>
                </c:pt>
                <c:pt idx="613">
                  <c:v>21.360888513988474</c:v>
                </c:pt>
                <c:pt idx="614">
                  <c:v>42.876743654241935</c:v>
                </c:pt>
                <c:pt idx="615">
                  <c:v>28.093191585614115</c:v>
                </c:pt>
                <c:pt idx="616">
                  <c:v>22.659603616768653</c:v>
                </c:pt>
                <c:pt idx="617">
                  <c:v>26.543566344987457</c:v>
                </c:pt>
                <c:pt idx="618">
                  <c:v>21.081864283989376</c:v>
                </c:pt>
                <c:pt idx="619">
                  <c:v>25.134776478394294</c:v>
                </c:pt>
                <c:pt idx="620">
                  <c:v>27.690711822591048</c:v>
                </c:pt>
                <c:pt idx="621">
                  <c:v>25.445176439893025</c:v>
                </c:pt>
                <c:pt idx="622">
                  <c:v>11.35270979020979</c:v>
                </c:pt>
                <c:pt idx="623">
                  <c:v>18.480667688639073</c:v>
                </c:pt>
                <c:pt idx="624">
                  <c:v>24.211377729846319</c:v>
                </c:pt>
                <c:pt idx="625">
                  <c:v>22.81128569015036</c:v>
                </c:pt>
                <c:pt idx="626">
                  <c:v>14.057273394794811</c:v>
                </c:pt>
                <c:pt idx="627">
                  <c:v>18.715277777777779</c:v>
                </c:pt>
                <c:pt idx="628">
                  <c:v>20.7926664869237</c:v>
                </c:pt>
                <c:pt idx="629">
                  <c:v>18.353909465020578</c:v>
                </c:pt>
                <c:pt idx="630">
                  <c:v>21.069324875396465</c:v>
                </c:pt>
                <c:pt idx="631">
                  <c:v>21.208608071878846</c:v>
                </c:pt>
                <c:pt idx="632">
                  <c:v>26.758444293989317</c:v>
                </c:pt>
                <c:pt idx="633">
                  <c:v>17.731716147719045</c:v>
                </c:pt>
                <c:pt idx="634">
                  <c:v>47.796934865900376</c:v>
                </c:pt>
                <c:pt idx="635">
                  <c:v>31.97719908377568</c:v>
                </c:pt>
                <c:pt idx="636">
                  <c:v>44.30103617524086</c:v>
                </c:pt>
                <c:pt idx="637">
                  <c:v>32.386442561466872</c:v>
                </c:pt>
                <c:pt idx="638">
                  <c:v>31.838260278627253</c:v>
                </c:pt>
                <c:pt idx="639">
                  <c:v>24.398541919805592</c:v>
                </c:pt>
                <c:pt idx="640">
                  <c:v>21.001378043178686</c:v>
                </c:pt>
                <c:pt idx="641">
                  <c:v>31.071206027304136</c:v>
                </c:pt>
                <c:pt idx="642">
                  <c:v>23.513666352497644</c:v>
                </c:pt>
                <c:pt idx="643">
                  <c:v>30.929274355569181</c:v>
                </c:pt>
                <c:pt idx="644">
                  <c:v>19.340025630072617</c:v>
                </c:pt>
                <c:pt idx="645">
                  <c:v>26.928305991117554</c:v>
                </c:pt>
                <c:pt idx="646">
                  <c:v>25.711387268577226</c:v>
                </c:pt>
                <c:pt idx="647">
                  <c:v>21.801173299508481</c:v>
                </c:pt>
                <c:pt idx="648">
                  <c:v>29.129444761474979</c:v>
                </c:pt>
                <c:pt idx="649">
                  <c:v>25.39465991034886</c:v>
                </c:pt>
                <c:pt idx="650">
                  <c:v>45.350469813154767</c:v>
                </c:pt>
                <c:pt idx="651">
                  <c:v>37.065088757396452</c:v>
                </c:pt>
                <c:pt idx="652">
                  <c:v>21.942373564376386</c:v>
                </c:pt>
                <c:pt idx="653">
                  <c:v>43.700652248541026</c:v>
                </c:pt>
                <c:pt idx="654">
                  <c:v>41.944349020955002</c:v>
                </c:pt>
                <c:pt idx="655">
                  <c:v>26.527135556096372</c:v>
                </c:pt>
                <c:pt idx="656">
                  <c:v>35.742491324638024</c:v>
                </c:pt>
                <c:pt idx="657">
                  <c:v>24.571428571428573</c:v>
                </c:pt>
                <c:pt idx="658">
                  <c:v>16.419567993780888</c:v>
                </c:pt>
                <c:pt idx="659">
                  <c:v>30.817531081250788</c:v>
                </c:pt>
                <c:pt idx="660">
                  <c:v>24.778725937686051</c:v>
                </c:pt>
                <c:pt idx="661">
                  <c:v>11.627906976744185</c:v>
                </c:pt>
                <c:pt idx="662">
                  <c:v>28.864376831372866</c:v>
                </c:pt>
                <c:pt idx="663">
                  <c:v>28.942315719175223</c:v>
                </c:pt>
                <c:pt idx="664">
                  <c:v>20.883078247935178</c:v>
                </c:pt>
                <c:pt idx="665">
                  <c:v>51.741960650462012</c:v>
                </c:pt>
                <c:pt idx="666">
                  <c:v>28.411425028097511</c:v>
                </c:pt>
                <c:pt idx="667">
                  <c:v>41.766717601688136</c:v>
                </c:pt>
                <c:pt idx="668">
                  <c:v>40.864339598516807</c:v>
                </c:pt>
                <c:pt idx="669">
                  <c:v>37.256033073742913</c:v>
                </c:pt>
                <c:pt idx="670">
                  <c:v>37.751422389614554</c:v>
                </c:pt>
                <c:pt idx="671">
                  <c:v>35.776036741861404</c:v>
                </c:pt>
                <c:pt idx="672">
                  <c:v>46.214145733119544</c:v>
                </c:pt>
                <c:pt idx="673">
                  <c:v>37.857726901062961</c:v>
                </c:pt>
                <c:pt idx="674">
                  <c:v>42.973484848484851</c:v>
                </c:pt>
                <c:pt idx="675">
                  <c:v>34.861455401070806</c:v>
                </c:pt>
                <c:pt idx="676">
                  <c:v>30.218653911855146</c:v>
                </c:pt>
                <c:pt idx="677">
                  <c:v>31.073046074437666</c:v>
                </c:pt>
                <c:pt idx="678">
                  <c:v>30.17995431500362</c:v>
                </c:pt>
                <c:pt idx="679">
                  <c:v>24.998821032775286</c:v>
                </c:pt>
                <c:pt idx="680">
                  <c:v>42.214389670298978</c:v>
                </c:pt>
                <c:pt idx="681">
                  <c:v>39.797613653526653</c:v>
                </c:pt>
                <c:pt idx="682">
                  <c:v>36.680327868852459</c:v>
                </c:pt>
                <c:pt idx="683">
                  <c:v>36.894908452470531</c:v>
                </c:pt>
                <c:pt idx="684">
                  <c:v>12.74157053303164</c:v>
                </c:pt>
                <c:pt idx="685">
                  <c:v>30.047740066028553</c:v>
                </c:pt>
                <c:pt idx="686">
                  <c:v>32.97899266008605</c:v>
                </c:pt>
                <c:pt idx="687">
                  <c:v>33.712362412444278</c:v>
                </c:pt>
                <c:pt idx="688">
                  <c:v>26.464386058549259</c:v>
                </c:pt>
                <c:pt idx="689">
                  <c:v>31.976471813023792</c:v>
                </c:pt>
                <c:pt idx="690">
                  <c:v>40.232320556963941</c:v>
                </c:pt>
                <c:pt idx="691">
                  <c:v>29.649868447682657</c:v>
                </c:pt>
                <c:pt idx="692">
                  <c:v>36.249430449781954</c:v>
                </c:pt>
                <c:pt idx="693">
                  <c:v>22.869087732434796</c:v>
                </c:pt>
                <c:pt idx="694">
                  <c:v>33.587841244687752</c:v>
                </c:pt>
                <c:pt idx="695">
                  <c:v>20.463137996219281</c:v>
                </c:pt>
                <c:pt idx="696">
                  <c:v>36.174404659928044</c:v>
                </c:pt>
                <c:pt idx="697">
                  <c:v>28.907508862391239</c:v>
                </c:pt>
                <c:pt idx="698">
                  <c:v>28.556836422004956</c:v>
                </c:pt>
                <c:pt idx="699">
                  <c:v>40.552315367858895</c:v>
                </c:pt>
                <c:pt idx="700">
                  <c:v>28.343313373253491</c:v>
                </c:pt>
                <c:pt idx="701">
                  <c:v>36.868812910739543</c:v>
                </c:pt>
                <c:pt idx="702">
                  <c:v>28.571818752901976</c:v>
                </c:pt>
                <c:pt idx="703">
                  <c:v>46.941035879798306</c:v>
                </c:pt>
                <c:pt idx="704">
                  <c:v>22.063999631921604</c:v>
                </c:pt>
                <c:pt idx="705">
                  <c:v>35.139010155783282</c:v>
                </c:pt>
                <c:pt idx="706">
                  <c:v>32.253789447527538</c:v>
                </c:pt>
                <c:pt idx="707">
                  <c:v>35.663837616475753</c:v>
                </c:pt>
                <c:pt idx="708">
                  <c:v>34.612172009562485</c:v>
                </c:pt>
                <c:pt idx="709">
                  <c:v>45.47968885047537</c:v>
                </c:pt>
                <c:pt idx="710">
                  <c:v>40.249585545964663</c:v>
                </c:pt>
                <c:pt idx="711">
                  <c:v>38.813334938019011</c:v>
                </c:pt>
                <c:pt idx="712">
                  <c:v>31.190929617755067</c:v>
                </c:pt>
                <c:pt idx="713">
                  <c:v>36.304753540454492</c:v>
                </c:pt>
                <c:pt idx="714">
                  <c:v>31.515910141338733</c:v>
                </c:pt>
                <c:pt idx="715">
                  <c:v>47.645211930926216</c:v>
                </c:pt>
                <c:pt idx="716">
                  <c:v>42.262948207171313</c:v>
                </c:pt>
                <c:pt idx="717">
                  <c:v>43.28107502799552</c:v>
                </c:pt>
                <c:pt idx="718">
                  <c:v>50.441348505796022</c:v>
                </c:pt>
                <c:pt idx="719">
                  <c:v>27.802998110418653</c:v>
                </c:pt>
                <c:pt idx="720">
                  <c:v>34.027364663890545</c:v>
                </c:pt>
                <c:pt idx="721">
                  <c:v>22.803738317757013</c:v>
                </c:pt>
                <c:pt idx="722">
                  <c:v>26.096140731137744</c:v>
                </c:pt>
                <c:pt idx="723">
                  <c:v>29.950828960088984</c:v>
                </c:pt>
                <c:pt idx="724">
                  <c:v>31.274615109201577</c:v>
                </c:pt>
                <c:pt idx="725">
                  <c:v>29.216179827899083</c:v>
                </c:pt>
                <c:pt idx="726">
                  <c:v>25.787615426398698</c:v>
                </c:pt>
                <c:pt idx="727">
                  <c:v>33.449401523394997</c:v>
                </c:pt>
                <c:pt idx="728">
                  <c:v>29.394362559573423</c:v>
                </c:pt>
                <c:pt idx="729">
                  <c:v>33.255203450215639</c:v>
                </c:pt>
                <c:pt idx="730">
                  <c:v>32.751993322643706</c:v>
                </c:pt>
                <c:pt idx="731">
                  <c:v>28.03901950975488</c:v>
                </c:pt>
                <c:pt idx="732">
                  <c:v>32.621533177997712</c:v>
                </c:pt>
                <c:pt idx="733">
                  <c:v>33.019341873901027</c:v>
                </c:pt>
                <c:pt idx="734">
                  <c:v>20.859828158441641</c:v>
                </c:pt>
                <c:pt idx="735">
                  <c:v>34.724790841039187</c:v>
                </c:pt>
                <c:pt idx="736">
                  <c:v>30.796554867622</c:v>
                </c:pt>
                <c:pt idx="737">
                  <c:v>37.131958517105737</c:v>
                </c:pt>
                <c:pt idx="738">
                  <c:v>24.96264930232444</c:v>
                </c:pt>
                <c:pt idx="739">
                  <c:v>43.338437978560492</c:v>
                </c:pt>
                <c:pt idx="740">
                  <c:v>21.062845200776234</c:v>
                </c:pt>
                <c:pt idx="741">
                  <c:v>21.014925373134332</c:v>
                </c:pt>
                <c:pt idx="742">
                  <c:v>18.518518518518515</c:v>
                </c:pt>
                <c:pt idx="743">
                  <c:v>16.166051876573569</c:v>
                </c:pt>
                <c:pt idx="744">
                  <c:v>37.932126876014728</c:v>
                </c:pt>
                <c:pt idx="745">
                  <c:v>41.754822650902305</c:v>
                </c:pt>
                <c:pt idx="746">
                  <c:v>37.347458763577848</c:v>
                </c:pt>
                <c:pt idx="747">
                  <c:v>40.093625940311043</c:v>
                </c:pt>
                <c:pt idx="748">
                  <c:v>29.232907653548782</c:v>
                </c:pt>
                <c:pt idx="749">
                  <c:v>33.410106407480768</c:v>
                </c:pt>
                <c:pt idx="750">
                  <c:v>26.871368738952491</c:v>
                </c:pt>
                <c:pt idx="751">
                  <c:v>33.195439047925376</c:v>
                </c:pt>
                <c:pt idx="752">
                  <c:v>29.413277938594469</c:v>
                </c:pt>
                <c:pt idx="753">
                  <c:v>29.998737298847061</c:v>
                </c:pt>
                <c:pt idx="754">
                  <c:v>28.259495209842918</c:v>
                </c:pt>
                <c:pt idx="755">
                  <c:v>27.457443668208207</c:v>
                </c:pt>
                <c:pt idx="756">
                  <c:v>23.730927933979459</c:v>
                </c:pt>
                <c:pt idx="757">
                  <c:v>31.334683071172712</c:v>
                </c:pt>
                <c:pt idx="758">
                  <c:v>18.034194148365405</c:v>
                </c:pt>
                <c:pt idx="759">
                  <c:v>28.854645132612234</c:v>
                </c:pt>
                <c:pt idx="760">
                  <c:v>43.650508677438658</c:v>
                </c:pt>
                <c:pt idx="761">
                  <c:v>23.729642832180055</c:v>
                </c:pt>
                <c:pt idx="762">
                  <c:v>24.082485465116278</c:v>
                </c:pt>
                <c:pt idx="763">
                  <c:v>29.574514991181658</c:v>
                </c:pt>
                <c:pt idx="764">
                  <c:v>48.951317014402271</c:v>
                </c:pt>
                <c:pt idx="765">
                  <c:v>37.100266908395028</c:v>
                </c:pt>
                <c:pt idx="766">
                  <c:v>27.392938939544528</c:v>
                </c:pt>
                <c:pt idx="767">
                  <c:v>33.830066996431022</c:v>
                </c:pt>
                <c:pt idx="768">
                  <c:v>29.256080188890039</c:v>
                </c:pt>
                <c:pt idx="769">
                  <c:v>18.36643606337871</c:v>
                </c:pt>
                <c:pt idx="770">
                  <c:v>33.824140592531023</c:v>
                </c:pt>
                <c:pt idx="771">
                  <c:v>32.896049098580747</c:v>
                </c:pt>
                <c:pt idx="772">
                  <c:v>43.740733812936924</c:v>
                </c:pt>
                <c:pt idx="773">
                  <c:v>23.380027112516949</c:v>
                </c:pt>
                <c:pt idx="774">
                  <c:v>23.283582089552237</c:v>
                </c:pt>
                <c:pt idx="775">
                  <c:v>22.0008172487561</c:v>
                </c:pt>
                <c:pt idx="776">
                  <c:v>18.031497997592197</c:v>
                </c:pt>
                <c:pt idx="777">
                  <c:v>28.989225243714728</c:v>
                </c:pt>
                <c:pt idx="778">
                  <c:v>16.801510205250793</c:v>
                </c:pt>
                <c:pt idx="779">
                  <c:v>32.321092278719391</c:v>
                </c:pt>
                <c:pt idx="780">
                  <c:v>35.825140164134233</c:v>
                </c:pt>
                <c:pt idx="781">
                  <c:v>31.003701284563462</c:v>
                </c:pt>
                <c:pt idx="782">
                  <c:v>41.371201157742398</c:v>
                </c:pt>
                <c:pt idx="783">
                  <c:v>27.165133255582909</c:v>
                </c:pt>
                <c:pt idx="784">
                  <c:v>28.547223701408726</c:v>
                </c:pt>
                <c:pt idx="785">
                  <c:v>30.512430238457632</c:v>
                </c:pt>
                <c:pt idx="786">
                  <c:v>27.439061855101503</c:v>
                </c:pt>
                <c:pt idx="787">
                  <c:v>21.967495425680767</c:v>
                </c:pt>
                <c:pt idx="788">
                  <c:v>18.981987380591491</c:v>
                </c:pt>
                <c:pt idx="789">
                  <c:v>38.574110890214271</c:v>
                </c:pt>
                <c:pt idx="790">
                  <c:v>29.529124520404604</c:v>
                </c:pt>
                <c:pt idx="791">
                  <c:v>34.447603307033354</c:v>
                </c:pt>
                <c:pt idx="792">
                  <c:v>32.381210234195208</c:v>
                </c:pt>
                <c:pt idx="793">
                  <c:v>29.847302626059239</c:v>
                </c:pt>
                <c:pt idx="794">
                  <c:v>22.086263329448919</c:v>
                </c:pt>
                <c:pt idx="795">
                  <c:v>31.791221826809021</c:v>
                </c:pt>
                <c:pt idx="796">
                  <c:v>33.573902537253325</c:v>
                </c:pt>
                <c:pt idx="797">
                  <c:v>29.061784922475706</c:v>
                </c:pt>
                <c:pt idx="798">
                  <c:v>28.318987477542706</c:v>
                </c:pt>
                <c:pt idx="799">
                  <c:v>27.852412488174078</c:v>
                </c:pt>
                <c:pt idx="800">
                  <c:v>25.882396975708353</c:v>
                </c:pt>
                <c:pt idx="801">
                  <c:v>26.355508161758678</c:v>
                </c:pt>
                <c:pt idx="802">
                  <c:v>38.394425931535899</c:v>
                </c:pt>
                <c:pt idx="803">
                  <c:v>27.924217462932454</c:v>
                </c:pt>
                <c:pt idx="804">
                  <c:v>33.936723432972094</c:v>
                </c:pt>
                <c:pt idx="805">
                  <c:v>51.686650679456434</c:v>
                </c:pt>
                <c:pt idx="806">
                  <c:v>20.214590387406005</c:v>
                </c:pt>
                <c:pt idx="807">
                  <c:v>32.057805821290451</c:v>
                </c:pt>
                <c:pt idx="808">
                  <c:v>28.729347438488055</c:v>
                </c:pt>
                <c:pt idx="809">
                  <c:v>20.214729072303307</c:v>
                </c:pt>
                <c:pt idx="810">
                  <c:v>30.557546681949507</c:v>
                </c:pt>
                <c:pt idx="811">
                  <c:v>42.069847888925743</c:v>
                </c:pt>
                <c:pt idx="812">
                  <c:v>29.403450159015712</c:v>
                </c:pt>
                <c:pt idx="813">
                  <c:v>25.384979240027331</c:v>
                </c:pt>
                <c:pt idx="814">
                  <c:v>22.080518130572102</c:v>
                </c:pt>
                <c:pt idx="815">
                  <c:v>28.187618941005258</c:v>
                </c:pt>
                <c:pt idx="816">
                  <c:v>23.338424875563135</c:v>
                </c:pt>
                <c:pt idx="817">
                  <c:v>26.79371346139245</c:v>
                </c:pt>
                <c:pt idx="818">
                  <c:v>27.554804069888167</c:v>
                </c:pt>
                <c:pt idx="819">
                  <c:v>30.332373724155978</c:v>
                </c:pt>
                <c:pt idx="820">
                  <c:v>28.17243097192339</c:v>
                </c:pt>
                <c:pt idx="821">
                  <c:v>26.549543218552351</c:v>
                </c:pt>
                <c:pt idx="822">
                  <c:v>26.979960627933973</c:v>
                </c:pt>
                <c:pt idx="823">
                  <c:v>20.566430653894212</c:v>
                </c:pt>
                <c:pt idx="824">
                  <c:v>21.919634355360884</c:v>
                </c:pt>
                <c:pt idx="825">
                  <c:v>15.34255387584432</c:v>
                </c:pt>
                <c:pt idx="826">
                  <c:v>28.998410174880764</c:v>
                </c:pt>
                <c:pt idx="827">
                  <c:v>21.757271815446337</c:v>
                </c:pt>
                <c:pt idx="828">
                  <c:v>30.670175768399282</c:v>
                </c:pt>
                <c:pt idx="829">
                  <c:v>20.99519860323003</c:v>
                </c:pt>
                <c:pt idx="830">
                  <c:v>19.68033253174049</c:v>
                </c:pt>
                <c:pt idx="831">
                  <c:v>22.646813827571844</c:v>
                </c:pt>
                <c:pt idx="832">
                  <c:v>24.695863746958633</c:v>
                </c:pt>
                <c:pt idx="833">
                  <c:v>30.441474147814525</c:v>
                </c:pt>
                <c:pt idx="834">
                  <c:v>20.343563733293841</c:v>
                </c:pt>
                <c:pt idx="835">
                  <c:v>15.73644770807749</c:v>
                </c:pt>
                <c:pt idx="836">
                  <c:v>23.495499140285222</c:v>
                </c:pt>
                <c:pt idx="837">
                  <c:v>23.924601256645719</c:v>
                </c:pt>
                <c:pt idx="838">
                  <c:v>29.535993501878359</c:v>
                </c:pt>
                <c:pt idx="839">
                  <c:v>23.414110050157745</c:v>
                </c:pt>
                <c:pt idx="840">
                  <c:v>18.853518148713736</c:v>
                </c:pt>
                <c:pt idx="841">
                  <c:v>24.349345803221389</c:v>
                </c:pt>
                <c:pt idx="842">
                  <c:v>33.318704467655579</c:v>
                </c:pt>
                <c:pt idx="843">
                  <c:v>24.821570182394925</c:v>
                </c:pt>
                <c:pt idx="844">
                  <c:v>26.210254941277569</c:v>
                </c:pt>
                <c:pt idx="845">
                  <c:v>24.971573389692871</c:v>
                </c:pt>
                <c:pt idx="846">
                  <c:v>20.217560097275076</c:v>
                </c:pt>
                <c:pt idx="847">
                  <c:v>33.165076768664235</c:v>
                </c:pt>
                <c:pt idx="848">
                  <c:v>26.181880694516074</c:v>
                </c:pt>
                <c:pt idx="849">
                  <c:v>21.95121951219512</c:v>
                </c:pt>
                <c:pt idx="850">
                  <c:v>22.68049724211739</c:v>
                </c:pt>
                <c:pt idx="851">
                  <c:v>20.077819736844162</c:v>
                </c:pt>
                <c:pt idx="852">
                  <c:v>15.248065543923529</c:v>
                </c:pt>
                <c:pt idx="853">
                  <c:v>30.741052442646257</c:v>
                </c:pt>
                <c:pt idx="854">
                  <c:v>21.137047532793829</c:v>
                </c:pt>
                <c:pt idx="855">
                  <c:v>18.769335704367737</c:v>
                </c:pt>
                <c:pt idx="856">
                  <c:v>21.890205677781427</c:v>
                </c:pt>
                <c:pt idx="857">
                  <c:v>16.018834473950086</c:v>
                </c:pt>
                <c:pt idx="858">
                  <c:v>23.583635422061111</c:v>
                </c:pt>
                <c:pt idx="859">
                  <c:v>27.457244878782188</c:v>
                </c:pt>
                <c:pt idx="860">
                  <c:v>19.492235324441012</c:v>
                </c:pt>
                <c:pt idx="861">
                  <c:v>28.393341076267905</c:v>
                </c:pt>
                <c:pt idx="862">
                  <c:v>28.978523410077933</c:v>
                </c:pt>
                <c:pt idx="863">
                  <c:v>38.132001211020281</c:v>
                </c:pt>
                <c:pt idx="864">
                  <c:v>22.014364912472352</c:v>
                </c:pt>
                <c:pt idx="865">
                  <c:v>17.593809315228501</c:v>
                </c:pt>
                <c:pt idx="866">
                  <c:v>20.171878730007158</c:v>
                </c:pt>
                <c:pt idx="867">
                  <c:v>26.150225534418514</c:v>
                </c:pt>
                <c:pt idx="868">
                  <c:v>18.258982795681025</c:v>
                </c:pt>
                <c:pt idx="869">
                  <c:v>25.290503133175147</c:v>
                </c:pt>
                <c:pt idx="870">
                  <c:v>20.175344809152143</c:v>
                </c:pt>
                <c:pt idx="871">
                  <c:v>46.046110751993105</c:v>
                </c:pt>
                <c:pt idx="872">
                  <c:v>13.176612417118749</c:v>
                </c:pt>
                <c:pt idx="873">
                  <c:v>12.989938429193572</c:v>
                </c:pt>
                <c:pt idx="874">
                  <c:v>25.149377522044539</c:v>
                </c:pt>
                <c:pt idx="875">
                  <c:v>19.817700242600083</c:v>
                </c:pt>
                <c:pt idx="876">
                  <c:v>20.944934287140242</c:v>
                </c:pt>
                <c:pt idx="877">
                  <c:v>16.29951364144711</c:v>
                </c:pt>
                <c:pt idx="878">
                  <c:v>22.091137000442412</c:v>
                </c:pt>
                <c:pt idx="879">
                  <c:v>23.894668400520157</c:v>
                </c:pt>
                <c:pt idx="880">
                  <c:v>19.15125484791179</c:v>
                </c:pt>
                <c:pt idx="881">
                  <c:v>21.638237759286632</c:v>
                </c:pt>
                <c:pt idx="882">
                  <c:v>25.811871811321904</c:v>
                </c:pt>
                <c:pt idx="883">
                  <c:v>16.372237415921354</c:v>
                </c:pt>
                <c:pt idx="884">
                  <c:v>18.894622939903446</c:v>
                </c:pt>
                <c:pt idx="885">
                  <c:v>20.917518421678153</c:v>
                </c:pt>
                <c:pt idx="886">
                  <c:v>22.748035812168826</c:v>
                </c:pt>
                <c:pt idx="887">
                  <c:v>20.318471337579624</c:v>
                </c:pt>
                <c:pt idx="888">
                  <c:v>20.575426921759554</c:v>
                </c:pt>
                <c:pt idx="889">
                  <c:v>16.825483256193845</c:v>
                </c:pt>
                <c:pt idx="890">
                  <c:v>17.761686721328932</c:v>
                </c:pt>
                <c:pt idx="891">
                  <c:v>19.656316909077603</c:v>
                </c:pt>
                <c:pt idx="892">
                  <c:v>30.360772357723576</c:v>
                </c:pt>
                <c:pt idx="893">
                  <c:v>19.201396465197469</c:v>
                </c:pt>
                <c:pt idx="894">
                  <c:v>20.823468862583631</c:v>
                </c:pt>
                <c:pt idx="895">
                  <c:v>14.553642384105963</c:v>
                </c:pt>
                <c:pt idx="896">
                  <c:v>19.518407038666361</c:v>
                </c:pt>
                <c:pt idx="897">
                  <c:v>21.393558159594388</c:v>
                </c:pt>
                <c:pt idx="898">
                  <c:v>28.11091854419411</c:v>
                </c:pt>
                <c:pt idx="899">
                  <c:v>23.119584055459267</c:v>
                </c:pt>
                <c:pt idx="900">
                  <c:v>19.160197876189933</c:v>
                </c:pt>
                <c:pt idx="901">
                  <c:v>14.948498225569113</c:v>
                </c:pt>
                <c:pt idx="902">
                  <c:v>16.503789047766006</c:v>
                </c:pt>
                <c:pt idx="903">
                  <c:v>17.055843475222733</c:v>
                </c:pt>
                <c:pt idx="904">
                  <c:v>15.748491337356432</c:v>
                </c:pt>
                <c:pt idx="905">
                  <c:v>10.502451626509201</c:v>
                </c:pt>
                <c:pt idx="906">
                  <c:v>17.640822315807121</c:v>
                </c:pt>
                <c:pt idx="907">
                  <c:v>29.665809768637533</c:v>
                </c:pt>
                <c:pt idx="908">
                  <c:v>36.29219503482765</c:v>
                </c:pt>
                <c:pt idx="909">
                  <c:v>24.883572276504427</c:v>
                </c:pt>
                <c:pt idx="910">
                  <c:v>34.300798158480752</c:v>
                </c:pt>
                <c:pt idx="911">
                  <c:v>38.237097746506159</c:v>
                </c:pt>
                <c:pt idx="912">
                  <c:v>18.315695902769093</c:v>
                </c:pt>
                <c:pt idx="913">
                  <c:v>26.11353740103025</c:v>
                </c:pt>
                <c:pt idx="914">
                  <c:v>31.881285258768695</c:v>
                </c:pt>
                <c:pt idx="915">
                  <c:v>34.639608117564734</c:v>
                </c:pt>
                <c:pt idx="916">
                  <c:v>24.716223698781839</c:v>
                </c:pt>
                <c:pt idx="917">
                  <c:v>17.100592245365078</c:v>
                </c:pt>
                <c:pt idx="918">
                  <c:v>47.589229805886042</c:v>
                </c:pt>
                <c:pt idx="919">
                  <c:v>29.670100498935838</c:v>
                </c:pt>
                <c:pt idx="920">
                  <c:v>23.725629898309474</c:v>
                </c:pt>
                <c:pt idx="921">
                  <c:v>30.924076715802819</c:v>
                </c:pt>
                <c:pt idx="922">
                  <c:v>43.595349299413705</c:v>
                </c:pt>
                <c:pt idx="923">
                  <c:v>21.09010420522776</c:v>
                </c:pt>
                <c:pt idx="924">
                  <c:v>24.431089218403446</c:v>
                </c:pt>
                <c:pt idx="925">
                  <c:v>8.4998450545353155</c:v>
                </c:pt>
                <c:pt idx="926">
                  <c:v>9.0514900102939571</c:v>
                </c:pt>
                <c:pt idx="927">
                  <c:v>16.388645010242904</c:v>
                </c:pt>
                <c:pt idx="928">
                  <c:v>9.728663870913987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7964032"/>
        <c:axId val="80945152"/>
      </c:scatterChart>
      <c:valAx>
        <c:axId val="779640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BMI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0945152"/>
        <c:crosses val="autoZero"/>
        <c:crossBetween val="midCat"/>
      </c:valAx>
      <c:valAx>
        <c:axId val="809451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rtl="0">
                  <a:defRPr/>
                </a:pPr>
                <a:r>
                  <a:rPr lang="en-US"/>
                  <a:t>% Methylat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7796403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rtl="0">
              <a:defRPr sz="1600"/>
            </a:pPr>
            <a:r>
              <a:rPr lang="en-US" sz="1600" b="1" i="0" baseline="0">
                <a:effectLst/>
              </a:rPr>
              <a:t>Methylation and BMI - group 1+2</a:t>
            </a:r>
            <a:endParaRPr lang="he-IL" sz="1600">
              <a:effectLst/>
            </a:endParaRPr>
          </a:p>
        </c:rich>
      </c:tx>
      <c:layout>
        <c:manualLayout>
          <c:xMode val="edge"/>
          <c:yMode val="edge"/>
          <c:x val="0.18097222222222226"/>
          <c:y val="2.7777777777777776E-2"/>
        </c:manualLayout>
      </c:layout>
      <c:overlay val="1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dispRSqr val="0"/>
            <c:dispEq val="0"/>
          </c:trendline>
          <c:xVal>
            <c:numRef>
              <c:f>'[SJ database FTO methylation analysis2.xlsx]age,lym'!$D$2:$D$469</c:f>
              <c:numCache>
                <c:formatCode>General</c:formatCode>
                <c:ptCount val="468"/>
                <c:pt idx="0">
                  <c:v>32.43</c:v>
                </c:pt>
                <c:pt idx="1">
                  <c:v>30.11</c:v>
                </c:pt>
                <c:pt idx="2">
                  <c:v>28.43</c:v>
                </c:pt>
                <c:pt idx="3">
                  <c:v>26.66</c:v>
                </c:pt>
                <c:pt idx="4">
                  <c:v>23.22</c:v>
                </c:pt>
                <c:pt idx="5">
                  <c:v>29.82</c:v>
                </c:pt>
                <c:pt idx="6">
                  <c:v>34.450000000000003</c:v>
                </c:pt>
                <c:pt idx="7">
                  <c:v>43.44</c:v>
                </c:pt>
                <c:pt idx="8">
                  <c:v>25.49</c:v>
                </c:pt>
                <c:pt idx="9">
                  <c:v>21.14</c:v>
                </c:pt>
                <c:pt idx="10">
                  <c:v>29.22</c:v>
                </c:pt>
                <c:pt idx="11">
                  <c:v>28.76</c:v>
                </c:pt>
                <c:pt idx="12">
                  <c:v>30.15</c:v>
                </c:pt>
                <c:pt idx="13">
                  <c:v>18.04</c:v>
                </c:pt>
                <c:pt idx="14">
                  <c:v>18.97</c:v>
                </c:pt>
                <c:pt idx="15">
                  <c:v>27.02</c:v>
                </c:pt>
                <c:pt idx="16">
                  <c:v>32.14</c:v>
                </c:pt>
                <c:pt idx="17">
                  <c:v>37.299999999999997</c:v>
                </c:pt>
                <c:pt idx="18">
                  <c:v>31.78</c:v>
                </c:pt>
                <c:pt idx="19">
                  <c:v>27.79</c:v>
                </c:pt>
                <c:pt idx="20">
                  <c:v>22.22</c:v>
                </c:pt>
                <c:pt idx="21">
                  <c:v>25.39</c:v>
                </c:pt>
                <c:pt idx="22">
                  <c:v>32.67</c:v>
                </c:pt>
                <c:pt idx="23">
                  <c:v>25.76</c:v>
                </c:pt>
                <c:pt idx="24">
                  <c:v>33.770000000000003</c:v>
                </c:pt>
                <c:pt idx="25">
                  <c:v>24.31</c:v>
                </c:pt>
                <c:pt idx="26">
                  <c:v>26.89</c:v>
                </c:pt>
                <c:pt idx="27">
                  <c:v>27.39</c:v>
                </c:pt>
                <c:pt idx="28">
                  <c:v>22.31</c:v>
                </c:pt>
                <c:pt idx="29">
                  <c:v>28.5</c:v>
                </c:pt>
                <c:pt idx="30">
                  <c:v>24.99</c:v>
                </c:pt>
                <c:pt idx="31">
                  <c:v>26.37</c:v>
                </c:pt>
                <c:pt idx="32">
                  <c:v>26.41</c:v>
                </c:pt>
                <c:pt idx="33">
                  <c:v>30.92</c:v>
                </c:pt>
                <c:pt idx="34">
                  <c:v>25.59</c:v>
                </c:pt>
                <c:pt idx="35">
                  <c:v>42.08</c:v>
                </c:pt>
                <c:pt idx="36">
                  <c:v>23.92</c:v>
                </c:pt>
                <c:pt idx="37">
                  <c:v>24.89</c:v>
                </c:pt>
                <c:pt idx="38">
                  <c:v>30.38</c:v>
                </c:pt>
                <c:pt idx="39">
                  <c:v>28</c:v>
                </c:pt>
                <c:pt idx="40">
                  <c:v>27.98</c:v>
                </c:pt>
                <c:pt idx="41">
                  <c:v>32.880000000000003</c:v>
                </c:pt>
                <c:pt idx="42">
                  <c:v>26.75</c:v>
                </c:pt>
                <c:pt idx="43">
                  <c:v>18.27</c:v>
                </c:pt>
                <c:pt idx="44">
                  <c:v>20.85</c:v>
                </c:pt>
                <c:pt idx="45">
                  <c:v>33.11</c:v>
                </c:pt>
                <c:pt idx="46">
                  <c:v>28.99</c:v>
                </c:pt>
                <c:pt idx="47">
                  <c:v>23.05</c:v>
                </c:pt>
                <c:pt idx="48">
                  <c:v>33.35</c:v>
                </c:pt>
                <c:pt idx="49">
                  <c:v>28.36</c:v>
                </c:pt>
                <c:pt idx="50">
                  <c:v>28.38</c:v>
                </c:pt>
                <c:pt idx="51">
                  <c:v>23.16</c:v>
                </c:pt>
                <c:pt idx="52">
                  <c:v>34.24</c:v>
                </c:pt>
                <c:pt idx="53">
                  <c:v>42.46</c:v>
                </c:pt>
                <c:pt idx="54">
                  <c:v>19.72</c:v>
                </c:pt>
                <c:pt idx="55">
                  <c:v>31.27</c:v>
                </c:pt>
                <c:pt idx="56">
                  <c:v>30.33</c:v>
                </c:pt>
                <c:pt idx="57">
                  <c:v>25.37</c:v>
                </c:pt>
                <c:pt idx="58">
                  <c:v>26.43</c:v>
                </c:pt>
                <c:pt idx="59">
                  <c:v>22.66</c:v>
                </c:pt>
                <c:pt idx="60">
                  <c:v>23.85</c:v>
                </c:pt>
                <c:pt idx="61">
                  <c:v>19.54</c:v>
                </c:pt>
                <c:pt idx="62">
                  <c:v>19.03</c:v>
                </c:pt>
                <c:pt idx="63">
                  <c:v>24.54</c:v>
                </c:pt>
                <c:pt idx="64">
                  <c:v>21.21</c:v>
                </c:pt>
                <c:pt idx="65">
                  <c:v>28.61</c:v>
                </c:pt>
                <c:pt idx="66">
                  <c:v>40.46</c:v>
                </c:pt>
                <c:pt idx="67">
                  <c:v>23.46</c:v>
                </c:pt>
                <c:pt idx="68">
                  <c:v>25.84</c:v>
                </c:pt>
                <c:pt idx="69">
                  <c:v>24.8</c:v>
                </c:pt>
                <c:pt idx="70">
                  <c:v>27.51</c:v>
                </c:pt>
                <c:pt idx="71">
                  <c:v>26.24</c:v>
                </c:pt>
                <c:pt idx="72">
                  <c:v>26.71</c:v>
                </c:pt>
                <c:pt idx="73">
                  <c:v>24.89</c:v>
                </c:pt>
                <c:pt idx="74">
                  <c:v>28.63</c:v>
                </c:pt>
                <c:pt idx="75">
                  <c:v>19.96</c:v>
                </c:pt>
                <c:pt idx="76">
                  <c:v>44.3</c:v>
                </c:pt>
                <c:pt idx="77">
                  <c:v>27.93</c:v>
                </c:pt>
                <c:pt idx="78">
                  <c:v>27.16</c:v>
                </c:pt>
                <c:pt idx="79">
                  <c:v>24.62</c:v>
                </c:pt>
                <c:pt idx="80">
                  <c:v>36.75</c:v>
                </c:pt>
                <c:pt idx="81">
                  <c:v>22.97</c:v>
                </c:pt>
                <c:pt idx="82">
                  <c:v>20.62</c:v>
                </c:pt>
                <c:pt idx="83">
                  <c:v>21.6</c:v>
                </c:pt>
                <c:pt idx="84">
                  <c:v>26.31</c:v>
                </c:pt>
                <c:pt idx="85">
                  <c:v>29.62</c:v>
                </c:pt>
                <c:pt idx="86">
                  <c:v>39.47</c:v>
                </c:pt>
                <c:pt idx="87">
                  <c:v>29.58</c:v>
                </c:pt>
                <c:pt idx="88">
                  <c:v>19.600000000000001</c:v>
                </c:pt>
                <c:pt idx="89">
                  <c:v>22.91</c:v>
                </c:pt>
                <c:pt idx="90">
                  <c:v>26.12</c:v>
                </c:pt>
                <c:pt idx="91">
                  <c:v>25.3</c:v>
                </c:pt>
                <c:pt idx="92">
                  <c:v>30.12</c:v>
                </c:pt>
                <c:pt idx="93">
                  <c:v>31.75</c:v>
                </c:pt>
                <c:pt idx="94">
                  <c:v>35.28</c:v>
                </c:pt>
                <c:pt idx="95">
                  <c:v>20.93</c:v>
                </c:pt>
                <c:pt idx="96">
                  <c:v>23.01</c:v>
                </c:pt>
                <c:pt idx="97">
                  <c:v>28.69</c:v>
                </c:pt>
                <c:pt idx="98">
                  <c:v>22.76</c:v>
                </c:pt>
                <c:pt idx="99">
                  <c:v>27.81</c:v>
                </c:pt>
                <c:pt idx="100">
                  <c:v>28.33</c:v>
                </c:pt>
                <c:pt idx="101">
                  <c:v>28.56</c:v>
                </c:pt>
                <c:pt idx="102">
                  <c:v>31.82</c:v>
                </c:pt>
                <c:pt idx="103">
                  <c:v>21.47</c:v>
                </c:pt>
                <c:pt idx="104">
                  <c:v>24.62</c:v>
                </c:pt>
                <c:pt idx="105">
                  <c:v>23.4</c:v>
                </c:pt>
                <c:pt idx="106">
                  <c:v>20.5</c:v>
                </c:pt>
                <c:pt idx="107">
                  <c:v>21.23</c:v>
                </c:pt>
                <c:pt idx="108">
                  <c:v>33.299999999999997</c:v>
                </c:pt>
                <c:pt idx="109">
                  <c:v>34.42</c:v>
                </c:pt>
                <c:pt idx="110">
                  <c:v>24.54</c:v>
                </c:pt>
                <c:pt idx="111">
                  <c:v>39.43</c:v>
                </c:pt>
                <c:pt idx="112">
                  <c:v>22.48</c:v>
                </c:pt>
                <c:pt idx="113">
                  <c:v>32.869999999999997</c:v>
                </c:pt>
                <c:pt idx="114">
                  <c:v>24.32</c:v>
                </c:pt>
                <c:pt idx="115">
                  <c:v>36.25</c:v>
                </c:pt>
                <c:pt idx="116">
                  <c:v>27.71</c:v>
                </c:pt>
                <c:pt idx="117">
                  <c:v>21.2</c:v>
                </c:pt>
                <c:pt idx="118">
                  <c:v>26.99</c:v>
                </c:pt>
                <c:pt idx="119">
                  <c:v>26.45</c:v>
                </c:pt>
                <c:pt idx="120">
                  <c:v>23.33</c:v>
                </c:pt>
                <c:pt idx="121">
                  <c:v>24.62</c:v>
                </c:pt>
                <c:pt idx="122">
                  <c:v>18.43</c:v>
                </c:pt>
                <c:pt idx="123">
                  <c:v>28.77</c:v>
                </c:pt>
                <c:pt idx="124">
                  <c:v>29.48</c:v>
                </c:pt>
                <c:pt idx="125">
                  <c:v>25.19</c:v>
                </c:pt>
                <c:pt idx="126">
                  <c:v>25.8</c:v>
                </c:pt>
                <c:pt idx="127">
                  <c:v>24.72</c:v>
                </c:pt>
                <c:pt idx="128">
                  <c:v>27.12</c:v>
                </c:pt>
                <c:pt idx="129">
                  <c:v>24.92</c:v>
                </c:pt>
                <c:pt idx="130">
                  <c:v>27.04</c:v>
                </c:pt>
                <c:pt idx="131">
                  <c:v>28.7</c:v>
                </c:pt>
                <c:pt idx="132">
                  <c:v>31.4</c:v>
                </c:pt>
                <c:pt idx="133">
                  <c:v>25.15</c:v>
                </c:pt>
                <c:pt idx="134">
                  <c:v>43.36</c:v>
                </c:pt>
                <c:pt idx="135">
                  <c:v>19.64</c:v>
                </c:pt>
                <c:pt idx="136">
                  <c:v>31.79</c:v>
                </c:pt>
                <c:pt idx="137">
                  <c:v>31.8</c:v>
                </c:pt>
                <c:pt idx="138">
                  <c:v>34.79</c:v>
                </c:pt>
                <c:pt idx="139">
                  <c:v>31.82</c:v>
                </c:pt>
                <c:pt idx="140">
                  <c:v>26.63</c:v>
                </c:pt>
                <c:pt idx="141">
                  <c:v>22.64</c:v>
                </c:pt>
                <c:pt idx="142">
                  <c:v>20.87</c:v>
                </c:pt>
                <c:pt idx="143">
                  <c:v>23.91</c:v>
                </c:pt>
                <c:pt idx="144">
                  <c:v>24.37</c:v>
                </c:pt>
                <c:pt idx="145">
                  <c:v>18.87</c:v>
                </c:pt>
                <c:pt idx="146">
                  <c:v>32.28</c:v>
                </c:pt>
                <c:pt idx="147">
                  <c:v>27.39</c:v>
                </c:pt>
                <c:pt idx="148">
                  <c:v>32.53</c:v>
                </c:pt>
                <c:pt idx="149">
                  <c:v>26.39</c:v>
                </c:pt>
                <c:pt idx="150">
                  <c:v>30.94</c:v>
                </c:pt>
                <c:pt idx="151">
                  <c:v>26.31</c:v>
                </c:pt>
                <c:pt idx="152">
                  <c:v>24.13</c:v>
                </c:pt>
                <c:pt idx="153">
                  <c:v>43.74</c:v>
                </c:pt>
                <c:pt idx="154">
                  <c:v>23.12</c:v>
                </c:pt>
                <c:pt idx="155">
                  <c:v>24.57</c:v>
                </c:pt>
                <c:pt idx="156">
                  <c:v>20.92</c:v>
                </c:pt>
                <c:pt idx="157">
                  <c:v>25.93</c:v>
                </c:pt>
                <c:pt idx="158">
                  <c:v>28.05</c:v>
                </c:pt>
                <c:pt idx="159">
                  <c:v>32.26</c:v>
                </c:pt>
                <c:pt idx="160">
                  <c:v>28.59</c:v>
                </c:pt>
                <c:pt idx="161">
                  <c:v>42.66</c:v>
                </c:pt>
                <c:pt idx="162">
                  <c:v>35.71</c:v>
                </c:pt>
                <c:pt idx="163">
                  <c:v>20.99</c:v>
                </c:pt>
                <c:pt idx="164">
                  <c:v>20.32</c:v>
                </c:pt>
                <c:pt idx="165">
                  <c:v>45.1</c:v>
                </c:pt>
                <c:pt idx="166">
                  <c:v>18.010000000000002</c:v>
                </c:pt>
                <c:pt idx="167">
                  <c:v>27.35</c:v>
                </c:pt>
                <c:pt idx="168">
                  <c:v>22.92</c:v>
                </c:pt>
                <c:pt idx="169">
                  <c:v>36.68</c:v>
                </c:pt>
                <c:pt idx="170">
                  <c:v>27.96</c:v>
                </c:pt>
                <c:pt idx="171">
                  <c:v>40.31</c:v>
                </c:pt>
                <c:pt idx="172">
                  <c:v>24.51</c:v>
                </c:pt>
                <c:pt idx="173">
                  <c:v>30.97</c:v>
                </c:pt>
                <c:pt idx="174">
                  <c:v>25</c:v>
                </c:pt>
                <c:pt idx="175">
                  <c:v>37.270000000000003</c:v>
                </c:pt>
                <c:pt idx="176">
                  <c:v>29.06</c:v>
                </c:pt>
                <c:pt idx="177">
                  <c:v>30.44</c:v>
                </c:pt>
                <c:pt idx="178">
                  <c:v>27.76</c:v>
                </c:pt>
                <c:pt idx="179">
                  <c:v>20.07</c:v>
                </c:pt>
                <c:pt idx="180">
                  <c:v>22.8</c:v>
                </c:pt>
                <c:pt idx="181">
                  <c:v>19.899999999999999</c:v>
                </c:pt>
                <c:pt idx="182">
                  <c:v>30.71</c:v>
                </c:pt>
                <c:pt idx="183">
                  <c:v>32.799999999999997</c:v>
                </c:pt>
                <c:pt idx="184">
                  <c:v>39.35</c:v>
                </c:pt>
                <c:pt idx="185">
                  <c:v>29.21</c:v>
                </c:pt>
                <c:pt idx="186">
                  <c:v>28.08</c:v>
                </c:pt>
                <c:pt idx="187">
                  <c:v>25.67</c:v>
                </c:pt>
                <c:pt idx="188">
                  <c:v>23.28</c:v>
                </c:pt>
                <c:pt idx="189">
                  <c:v>35.659999999999997</c:v>
                </c:pt>
                <c:pt idx="190">
                  <c:v>27.49</c:v>
                </c:pt>
                <c:pt idx="191">
                  <c:v>32.590000000000003</c:v>
                </c:pt>
                <c:pt idx="192">
                  <c:v>32.090000000000003</c:v>
                </c:pt>
                <c:pt idx="193">
                  <c:v>27.86</c:v>
                </c:pt>
                <c:pt idx="194">
                  <c:v>37.869999999999997</c:v>
                </c:pt>
                <c:pt idx="195">
                  <c:v>18.86</c:v>
                </c:pt>
                <c:pt idx="196">
                  <c:v>40.06</c:v>
                </c:pt>
                <c:pt idx="197">
                  <c:v>26.13</c:v>
                </c:pt>
                <c:pt idx="198">
                  <c:v>22.87</c:v>
                </c:pt>
                <c:pt idx="199">
                  <c:v>16.600000000000001</c:v>
                </c:pt>
                <c:pt idx="200">
                  <c:v>24.45</c:v>
                </c:pt>
                <c:pt idx="201">
                  <c:v>28.96</c:v>
                </c:pt>
                <c:pt idx="202">
                  <c:v>34</c:v>
                </c:pt>
                <c:pt idx="203">
                  <c:v>26.54</c:v>
                </c:pt>
                <c:pt idx="204">
                  <c:v>29.74</c:v>
                </c:pt>
                <c:pt idx="205">
                  <c:v>34.78</c:v>
                </c:pt>
                <c:pt idx="206">
                  <c:v>24.78</c:v>
                </c:pt>
                <c:pt idx="207">
                  <c:v>20.3</c:v>
                </c:pt>
                <c:pt idx="208">
                  <c:v>28.92</c:v>
                </c:pt>
                <c:pt idx="209">
                  <c:v>26.07</c:v>
                </c:pt>
                <c:pt idx="210">
                  <c:v>31.5</c:v>
                </c:pt>
                <c:pt idx="211">
                  <c:v>27.64</c:v>
                </c:pt>
                <c:pt idx="212">
                  <c:v>33.86</c:v>
                </c:pt>
                <c:pt idx="213">
                  <c:v>28.23</c:v>
                </c:pt>
                <c:pt idx="214">
                  <c:v>27.5</c:v>
                </c:pt>
                <c:pt idx="215">
                  <c:v>33.29</c:v>
                </c:pt>
                <c:pt idx="216">
                  <c:v>26.42</c:v>
                </c:pt>
                <c:pt idx="217">
                  <c:v>36.979999999999997</c:v>
                </c:pt>
                <c:pt idx="218">
                  <c:v>20.68</c:v>
                </c:pt>
                <c:pt idx="219">
                  <c:v>34.200000000000003</c:v>
                </c:pt>
                <c:pt idx="220">
                  <c:v>24.94</c:v>
                </c:pt>
                <c:pt idx="221">
                  <c:v>29.37</c:v>
                </c:pt>
                <c:pt idx="222">
                  <c:v>25.55</c:v>
                </c:pt>
                <c:pt idx="223">
                  <c:v>24.41</c:v>
                </c:pt>
                <c:pt idx="224">
                  <c:v>26.39</c:v>
                </c:pt>
                <c:pt idx="225">
                  <c:v>38.14</c:v>
                </c:pt>
                <c:pt idx="226">
                  <c:v>22.49</c:v>
                </c:pt>
                <c:pt idx="227">
                  <c:v>34.53</c:v>
                </c:pt>
                <c:pt idx="228">
                  <c:v>30.18</c:v>
                </c:pt>
                <c:pt idx="229">
                  <c:v>22.6</c:v>
                </c:pt>
                <c:pt idx="230">
                  <c:v>23.08</c:v>
                </c:pt>
                <c:pt idx="231">
                  <c:v>24.46</c:v>
                </c:pt>
                <c:pt idx="232">
                  <c:v>27.16</c:v>
                </c:pt>
                <c:pt idx="233">
                  <c:v>18</c:v>
                </c:pt>
                <c:pt idx="234">
                  <c:v>27.4</c:v>
                </c:pt>
                <c:pt idx="235">
                  <c:v>24.33</c:v>
                </c:pt>
                <c:pt idx="236">
                  <c:v>34.51</c:v>
                </c:pt>
                <c:pt idx="237">
                  <c:v>17.670000000000002</c:v>
                </c:pt>
                <c:pt idx="238">
                  <c:v>28.35</c:v>
                </c:pt>
                <c:pt idx="239">
                  <c:v>27.9</c:v>
                </c:pt>
                <c:pt idx="240">
                  <c:v>25.62</c:v>
                </c:pt>
                <c:pt idx="241">
                  <c:v>29.31</c:v>
                </c:pt>
                <c:pt idx="242">
                  <c:v>21.17</c:v>
                </c:pt>
                <c:pt idx="243">
                  <c:v>25.65</c:v>
                </c:pt>
                <c:pt idx="244">
                  <c:v>20.72</c:v>
                </c:pt>
                <c:pt idx="245">
                  <c:v>20.66</c:v>
                </c:pt>
                <c:pt idx="246">
                  <c:v>27.39</c:v>
                </c:pt>
                <c:pt idx="247">
                  <c:v>33.08</c:v>
                </c:pt>
                <c:pt idx="248">
                  <c:v>28.76</c:v>
                </c:pt>
                <c:pt idx="249">
                  <c:v>25.11</c:v>
                </c:pt>
                <c:pt idx="250">
                  <c:v>28.97</c:v>
                </c:pt>
                <c:pt idx="251">
                  <c:v>29.97</c:v>
                </c:pt>
                <c:pt idx="252">
                  <c:v>32.159999999999997</c:v>
                </c:pt>
                <c:pt idx="253">
                  <c:v>21.08</c:v>
                </c:pt>
                <c:pt idx="254">
                  <c:v>23.79</c:v>
                </c:pt>
                <c:pt idx="255">
                  <c:v>27.9</c:v>
                </c:pt>
                <c:pt idx="256">
                  <c:v>26.83</c:v>
                </c:pt>
                <c:pt idx="257">
                  <c:v>18.760000000000002</c:v>
                </c:pt>
                <c:pt idx="258">
                  <c:v>23.1</c:v>
                </c:pt>
                <c:pt idx="259">
                  <c:v>27.32</c:v>
                </c:pt>
                <c:pt idx="260">
                  <c:v>27.27</c:v>
                </c:pt>
                <c:pt idx="261">
                  <c:v>26.73</c:v>
                </c:pt>
                <c:pt idx="262">
                  <c:v>26.89</c:v>
                </c:pt>
                <c:pt idx="263">
                  <c:v>22.59</c:v>
                </c:pt>
                <c:pt idx="264">
                  <c:v>41.28</c:v>
                </c:pt>
                <c:pt idx="265">
                  <c:v>39.76</c:v>
                </c:pt>
                <c:pt idx="266">
                  <c:v>25.11</c:v>
                </c:pt>
                <c:pt idx="267">
                  <c:v>23.66</c:v>
                </c:pt>
                <c:pt idx="268">
                  <c:v>26.11</c:v>
                </c:pt>
                <c:pt idx="269">
                  <c:v>38.36</c:v>
                </c:pt>
                <c:pt idx="270">
                  <c:v>29.97</c:v>
                </c:pt>
                <c:pt idx="271">
                  <c:v>19.57</c:v>
                </c:pt>
                <c:pt idx="272">
                  <c:v>23.33</c:v>
                </c:pt>
                <c:pt idx="273">
                  <c:v>25.24</c:v>
                </c:pt>
                <c:pt idx="274">
                  <c:v>33.97</c:v>
                </c:pt>
                <c:pt idx="275">
                  <c:v>35.78</c:v>
                </c:pt>
                <c:pt idx="276">
                  <c:v>25.24</c:v>
                </c:pt>
                <c:pt idx="277">
                  <c:v>30.08</c:v>
                </c:pt>
                <c:pt idx="278">
                  <c:v>28.24</c:v>
                </c:pt>
                <c:pt idx="279">
                  <c:v>34.54</c:v>
                </c:pt>
                <c:pt idx="280">
                  <c:v>29</c:v>
                </c:pt>
                <c:pt idx="281">
                  <c:v>25.81</c:v>
                </c:pt>
                <c:pt idx="282">
                  <c:v>25</c:v>
                </c:pt>
                <c:pt idx="283">
                  <c:v>23.03</c:v>
                </c:pt>
                <c:pt idx="284">
                  <c:v>26.96</c:v>
                </c:pt>
                <c:pt idx="285">
                  <c:v>31.73</c:v>
                </c:pt>
                <c:pt idx="286">
                  <c:v>24.39</c:v>
                </c:pt>
                <c:pt idx="287">
                  <c:v>24.38</c:v>
                </c:pt>
                <c:pt idx="288">
                  <c:v>34.75</c:v>
                </c:pt>
                <c:pt idx="289">
                  <c:v>26.17</c:v>
                </c:pt>
                <c:pt idx="290">
                  <c:v>23.55</c:v>
                </c:pt>
                <c:pt idx="291">
                  <c:v>25.84</c:v>
                </c:pt>
                <c:pt idx="292">
                  <c:v>28.5</c:v>
                </c:pt>
                <c:pt idx="293">
                  <c:v>32.590000000000003</c:v>
                </c:pt>
                <c:pt idx="294">
                  <c:v>37.53</c:v>
                </c:pt>
                <c:pt idx="295">
                  <c:v>23.32</c:v>
                </c:pt>
                <c:pt idx="296">
                  <c:v>31.28</c:v>
                </c:pt>
                <c:pt idx="297">
                  <c:v>28.37</c:v>
                </c:pt>
                <c:pt idx="298">
                  <c:v>28.16</c:v>
                </c:pt>
                <c:pt idx="299">
                  <c:v>35.9</c:v>
                </c:pt>
                <c:pt idx="300">
                  <c:v>30.84</c:v>
                </c:pt>
                <c:pt idx="301">
                  <c:v>29.03</c:v>
                </c:pt>
                <c:pt idx="302">
                  <c:v>28.35</c:v>
                </c:pt>
                <c:pt idx="303">
                  <c:v>34.82</c:v>
                </c:pt>
                <c:pt idx="304">
                  <c:v>34.28</c:v>
                </c:pt>
                <c:pt idx="305">
                  <c:v>33.07</c:v>
                </c:pt>
                <c:pt idx="306">
                  <c:v>24.52</c:v>
                </c:pt>
                <c:pt idx="307">
                  <c:v>25.72</c:v>
                </c:pt>
                <c:pt idx="308">
                  <c:v>23.36</c:v>
                </c:pt>
                <c:pt idx="309">
                  <c:v>33.47</c:v>
                </c:pt>
                <c:pt idx="310">
                  <c:v>25.66</c:v>
                </c:pt>
                <c:pt idx="311">
                  <c:v>31.08</c:v>
                </c:pt>
                <c:pt idx="312">
                  <c:v>39.53</c:v>
                </c:pt>
                <c:pt idx="313">
                  <c:v>30.19</c:v>
                </c:pt>
                <c:pt idx="314">
                  <c:v>32.06</c:v>
                </c:pt>
                <c:pt idx="315">
                  <c:v>27.98</c:v>
                </c:pt>
                <c:pt idx="316">
                  <c:v>36.78</c:v>
                </c:pt>
                <c:pt idx="317">
                  <c:v>26.76</c:v>
                </c:pt>
                <c:pt idx="318">
                  <c:v>18.760000000000002</c:v>
                </c:pt>
                <c:pt idx="319">
                  <c:v>28.41</c:v>
                </c:pt>
                <c:pt idx="320">
                  <c:v>32.33</c:v>
                </c:pt>
                <c:pt idx="321">
                  <c:v>27.88</c:v>
                </c:pt>
                <c:pt idx="322">
                  <c:v>26.51</c:v>
                </c:pt>
                <c:pt idx="323">
                  <c:v>31.99</c:v>
                </c:pt>
                <c:pt idx="324">
                  <c:v>27.74</c:v>
                </c:pt>
                <c:pt idx="325">
                  <c:v>22.37</c:v>
                </c:pt>
                <c:pt idx="326">
                  <c:v>29.69</c:v>
                </c:pt>
                <c:pt idx="327">
                  <c:v>27.16</c:v>
                </c:pt>
                <c:pt idx="328">
                  <c:v>44.94</c:v>
                </c:pt>
                <c:pt idx="329">
                  <c:v>40.94</c:v>
                </c:pt>
                <c:pt idx="330">
                  <c:v>33.06</c:v>
                </c:pt>
                <c:pt idx="331">
                  <c:v>27.46</c:v>
                </c:pt>
                <c:pt idx="332">
                  <c:v>24.58</c:v>
                </c:pt>
                <c:pt idx="333">
                  <c:v>31.52</c:v>
                </c:pt>
                <c:pt idx="334">
                  <c:v>33.380000000000003</c:v>
                </c:pt>
                <c:pt idx="335">
                  <c:v>44.72</c:v>
                </c:pt>
                <c:pt idx="336">
                  <c:v>28.86</c:v>
                </c:pt>
                <c:pt idx="337">
                  <c:v>30.22</c:v>
                </c:pt>
                <c:pt idx="338">
                  <c:v>29.14</c:v>
                </c:pt>
                <c:pt idx="339">
                  <c:v>26.7</c:v>
                </c:pt>
                <c:pt idx="340">
                  <c:v>41.59</c:v>
                </c:pt>
                <c:pt idx="341">
                  <c:v>30.17</c:v>
                </c:pt>
                <c:pt idx="342">
                  <c:v>28.45</c:v>
                </c:pt>
                <c:pt idx="343">
                  <c:v>32.61</c:v>
                </c:pt>
                <c:pt idx="344">
                  <c:v>28.76</c:v>
                </c:pt>
                <c:pt idx="345">
                  <c:v>45.34</c:v>
                </c:pt>
                <c:pt idx="346">
                  <c:v>29.83</c:v>
                </c:pt>
                <c:pt idx="347">
                  <c:v>31.07</c:v>
                </c:pt>
                <c:pt idx="348">
                  <c:v>22.79</c:v>
                </c:pt>
                <c:pt idx="349">
                  <c:v>28.99</c:v>
                </c:pt>
                <c:pt idx="350">
                  <c:v>29.22</c:v>
                </c:pt>
                <c:pt idx="351">
                  <c:v>33</c:v>
                </c:pt>
                <c:pt idx="352">
                  <c:v>32.64</c:v>
                </c:pt>
                <c:pt idx="353">
                  <c:v>25.82</c:v>
                </c:pt>
                <c:pt idx="354">
                  <c:v>35.96</c:v>
                </c:pt>
                <c:pt idx="355">
                  <c:v>27.15</c:v>
                </c:pt>
                <c:pt idx="356">
                  <c:v>31.79</c:v>
                </c:pt>
                <c:pt idx="357">
                  <c:v>29.32</c:v>
                </c:pt>
                <c:pt idx="358">
                  <c:v>29.66</c:v>
                </c:pt>
                <c:pt idx="359">
                  <c:v>30.66</c:v>
                </c:pt>
                <c:pt idx="360">
                  <c:v>51.13</c:v>
                </c:pt>
                <c:pt idx="361">
                  <c:v>31.56</c:v>
                </c:pt>
                <c:pt idx="362">
                  <c:v>34.5</c:v>
                </c:pt>
                <c:pt idx="363">
                  <c:v>28.21</c:v>
                </c:pt>
                <c:pt idx="364">
                  <c:v>28.18</c:v>
                </c:pt>
                <c:pt idx="365">
                  <c:v>27.94</c:v>
                </c:pt>
                <c:pt idx="366">
                  <c:v>30.3</c:v>
                </c:pt>
                <c:pt idx="367">
                  <c:v>26.75</c:v>
                </c:pt>
                <c:pt idx="368">
                  <c:v>25.15</c:v>
                </c:pt>
                <c:pt idx="369">
                  <c:v>31.94</c:v>
                </c:pt>
                <c:pt idx="370">
                  <c:v>26.98</c:v>
                </c:pt>
                <c:pt idx="371">
                  <c:v>28.78</c:v>
                </c:pt>
                <c:pt idx="372">
                  <c:v>23.75</c:v>
                </c:pt>
                <c:pt idx="373">
                  <c:v>27.54</c:v>
                </c:pt>
                <c:pt idx="374">
                  <c:v>35.380000000000003</c:v>
                </c:pt>
                <c:pt idx="375">
                  <c:v>27.76</c:v>
                </c:pt>
                <c:pt idx="376">
                  <c:v>34.75</c:v>
                </c:pt>
                <c:pt idx="377">
                  <c:v>31.71</c:v>
                </c:pt>
                <c:pt idx="378">
                  <c:v>26.29</c:v>
                </c:pt>
                <c:pt idx="379">
                  <c:v>37.119999999999997</c:v>
                </c:pt>
                <c:pt idx="380">
                  <c:v>24.58</c:v>
                </c:pt>
                <c:pt idx="381">
                  <c:v>23.93</c:v>
                </c:pt>
                <c:pt idx="382">
                  <c:v>35.450000000000003</c:v>
                </c:pt>
                <c:pt idx="383">
                  <c:v>33.979999999999997</c:v>
                </c:pt>
                <c:pt idx="384">
                  <c:v>26.07</c:v>
                </c:pt>
                <c:pt idx="385">
                  <c:v>20.3</c:v>
                </c:pt>
                <c:pt idx="386">
                  <c:v>35.79</c:v>
                </c:pt>
                <c:pt idx="387">
                  <c:v>27.9</c:v>
                </c:pt>
                <c:pt idx="388">
                  <c:v>17.04</c:v>
                </c:pt>
                <c:pt idx="389">
                  <c:v>24.99</c:v>
                </c:pt>
                <c:pt idx="390">
                  <c:v>28.73</c:v>
                </c:pt>
                <c:pt idx="391">
                  <c:v>40.15</c:v>
                </c:pt>
                <c:pt idx="392">
                  <c:v>30.19</c:v>
                </c:pt>
                <c:pt idx="393">
                  <c:v>34.89</c:v>
                </c:pt>
                <c:pt idx="394">
                  <c:v>33.19</c:v>
                </c:pt>
                <c:pt idx="395">
                  <c:v>29.26</c:v>
                </c:pt>
                <c:pt idx="396">
                  <c:v>25.38</c:v>
                </c:pt>
                <c:pt idx="397">
                  <c:v>35.6</c:v>
                </c:pt>
                <c:pt idx="398">
                  <c:v>25.56</c:v>
                </c:pt>
                <c:pt idx="399">
                  <c:v>26.76</c:v>
                </c:pt>
                <c:pt idx="400">
                  <c:v>27.84</c:v>
                </c:pt>
                <c:pt idx="401">
                  <c:v>26.29</c:v>
                </c:pt>
                <c:pt idx="402">
                  <c:v>24.09</c:v>
                </c:pt>
                <c:pt idx="403">
                  <c:v>30.73</c:v>
                </c:pt>
                <c:pt idx="404">
                  <c:v>30.33</c:v>
                </c:pt>
                <c:pt idx="405">
                  <c:v>25.06</c:v>
                </c:pt>
                <c:pt idx="406">
                  <c:v>24.03</c:v>
                </c:pt>
                <c:pt idx="407">
                  <c:v>26.91</c:v>
                </c:pt>
                <c:pt idx="408">
                  <c:v>33.130000000000003</c:v>
                </c:pt>
                <c:pt idx="409">
                  <c:v>26.38</c:v>
                </c:pt>
                <c:pt idx="410">
                  <c:v>32.61</c:v>
                </c:pt>
                <c:pt idx="411">
                  <c:v>29.58</c:v>
                </c:pt>
                <c:pt idx="412">
                  <c:v>26.13</c:v>
                </c:pt>
                <c:pt idx="413">
                  <c:v>30.15</c:v>
                </c:pt>
                <c:pt idx="414">
                  <c:v>32.450000000000003</c:v>
                </c:pt>
                <c:pt idx="415">
                  <c:v>27.47</c:v>
                </c:pt>
                <c:pt idx="416">
                  <c:v>26.63</c:v>
                </c:pt>
                <c:pt idx="417">
                  <c:v>25.34</c:v>
                </c:pt>
                <c:pt idx="418">
                  <c:v>32.229999999999997</c:v>
                </c:pt>
                <c:pt idx="419">
                  <c:v>28.41</c:v>
                </c:pt>
                <c:pt idx="420">
                  <c:v>28.89</c:v>
                </c:pt>
                <c:pt idx="421">
                  <c:v>26.63</c:v>
                </c:pt>
                <c:pt idx="422">
                  <c:v>37.24</c:v>
                </c:pt>
                <c:pt idx="423">
                  <c:v>23.39</c:v>
                </c:pt>
                <c:pt idx="424">
                  <c:v>24.24</c:v>
                </c:pt>
                <c:pt idx="425">
                  <c:v>31.12</c:v>
                </c:pt>
                <c:pt idx="426">
                  <c:v>27.19</c:v>
                </c:pt>
                <c:pt idx="427">
                  <c:v>19.940000000000001</c:v>
                </c:pt>
                <c:pt idx="428">
                  <c:v>23.52</c:v>
                </c:pt>
                <c:pt idx="429">
                  <c:v>40.71</c:v>
                </c:pt>
                <c:pt idx="430">
                  <c:v>24.53</c:v>
                </c:pt>
                <c:pt idx="431">
                  <c:v>20.56</c:v>
                </c:pt>
                <c:pt idx="432">
                  <c:v>19.2</c:v>
                </c:pt>
                <c:pt idx="433">
                  <c:v>28.56</c:v>
                </c:pt>
                <c:pt idx="434">
                  <c:v>26.5</c:v>
                </c:pt>
                <c:pt idx="435">
                  <c:v>23.15</c:v>
                </c:pt>
                <c:pt idx="436">
                  <c:v>19.41</c:v>
                </c:pt>
                <c:pt idx="437">
                  <c:v>31.01</c:v>
                </c:pt>
                <c:pt idx="438">
                  <c:v>21.67</c:v>
                </c:pt>
                <c:pt idx="439">
                  <c:v>36.24</c:v>
                </c:pt>
                <c:pt idx="440">
                  <c:v>21.96</c:v>
                </c:pt>
                <c:pt idx="441">
                  <c:v>30.49</c:v>
                </c:pt>
                <c:pt idx="442">
                  <c:v>28.55</c:v>
                </c:pt>
                <c:pt idx="443">
                  <c:v>21.77</c:v>
                </c:pt>
                <c:pt idx="444">
                  <c:v>30.3</c:v>
                </c:pt>
                <c:pt idx="445">
                  <c:v>23.84</c:v>
                </c:pt>
                <c:pt idx="446">
                  <c:v>33.909999999999997</c:v>
                </c:pt>
                <c:pt idx="447">
                  <c:v>22.58</c:v>
                </c:pt>
                <c:pt idx="448">
                  <c:v>30.27</c:v>
                </c:pt>
                <c:pt idx="449">
                  <c:v>27.71</c:v>
                </c:pt>
                <c:pt idx="450">
                  <c:v>30.26</c:v>
                </c:pt>
                <c:pt idx="451">
                  <c:v>30.16</c:v>
                </c:pt>
                <c:pt idx="452">
                  <c:v>20.87</c:v>
                </c:pt>
                <c:pt idx="453">
                  <c:v>20.99</c:v>
                </c:pt>
                <c:pt idx="454">
                  <c:v>29.15</c:v>
                </c:pt>
                <c:pt idx="455">
                  <c:v>29.61</c:v>
                </c:pt>
                <c:pt idx="456">
                  <c:v>23.7</c:v>
                </c:pt>
                <c:pt idx="457">
                  <c:v>28.09</c:v>
                </c:pt>
                <c:pt idx="458">
                  <c:v>27.29</c:v>
                </c:pt>
                <c:pt idx="459">
                  <c:v>29.16</c:v>
                </c:pt>
                <c:pt idx="460">
                  <c:v>29.73</c:v>
                </c:pt>
                <c:pt idx="461">
                  <c:v>32.46</c:v>
                </c:pt>
                <c:pt idx="462">
                  <c:v>38.69</c:v>
                </c:pt>
                <c:pt idx="463">
                  <c:v>32.72</c:v>
                </c:pt>
                <c:pt idx="464">
                  <c:v>35.46</c:v>
                </c:pt>
                <c:pt idx="465">
                  <c:v>26.22</c:v>
                </c:pt>
                <c:pt idx="466">
                  <c:v>39.11</c:v>
                </c:pt>
                <c:pt idx="467">
                  <c:v>24.81</c:v>
                </c:pt>
              </c:numCache>
            </c:numRef>
          </c:xVal>
          <c:yVal>
            <c:numRef>
              <c:f>'[SJ database FTO methylation analysis2.xlsx]age,lym'!$K$2:$K$469</c:f>
              <c:numCache>
                <c:formatCode>0.0</c:formatCode>
                <c:ptCount val="468"/>
                <c:pt idx="0">
                  <c:v>54.628333969384734</c:v>
                </c:pt>
                <c:pt idx="1">
                  <c:v>31.224140921140648</c:v>
                </c:pt>
                <c:pt idx="2">
                  <c:v>28.628023352793999</c:v>
                </c:pt>
                <c:pt idx="3">
                  <c:v>32.741267021906452</c:v>
                </c:pt>
                <c:pt idx="4">
                  <c:v>39.377142440376332</c:v>
                </c:pt>
                <c:pt idx="5">
                  <c:v>40.045322110715439</c:v>
                </c:pt>
                <c:pt idx="6">
                  <c:v>35.254214060572842</c:v>
                </c:pt>
                <c:pt idx="7">
                  <c:v>28.620965590824216</c:v>
                </c:pt>
                <c:pt idx="8">
                  <c:v>35.598024885203046</c:v>
                </c:pt>
                <c:pt idx="9">
                  <c:v>38.511250530685409</c:v>
                </c:pt>
                <c:pt idx="10">
                  <c:v>21.465150993225397</c:v>
                </c:pt>
                <c:pt idx="11">
                  <c:v>38.104245481294662</c:v>
                </c:pt>
                <c:pt idx="12">
                  <c:v>47.777133303763343</c:v>
                </c:pt>
                <c:pt idx="13">
                  <c:v>37.599043205262369</c:v>
                </c:pt>
                <c:pt idx="14">
                  <c:v>39.511169513797633</c:v>
                </c:pt>
                <c:pt idx="15">
                  <c:v>37.371976465460889</c:v>
                </c:pt>
                <c:pt idx="16">
                  <c:v>23.561780890445224</c:v>
                </c:pt>
                <c:pt idx="17">
                  <c:v>38.307942612039639</c:v>
                </c:pt>
                <c:pt idx="18">
                  <c:v>34.731599865919648</c:v>
                </c:pt>
                <c:pt idx="19">
                  <c:v>47.619147091556172</c:v>
                </c:pt>
                <c:pt idx="20">
                  <c:v>42.288278182837921</c:v>
                </c:pt>
                <c:pt idx="21">
                  <c:v>33.67616069917684</c:v>
                </c:pt>
                <c:pt idx="22">
                  <c:v>37.606645711719807</c:v>
                </c:pt>
                <c:pt idx="23">
                  <c:v>25.856279382135661</c:v>
                </c:pt>
                <c:pt idx="24">
                  <c:v>39.956281342419956</c:v>
                </c:pt>
                <c:pt idx="25">
                  <c:v>39.612684351882393</c:v>
                </c:pt>
                <c:pt idx="26">
                  <c:v>43.135613489595798</c:v>
                </c:pt>
                <c:pt idx="27">
                  <c:v>29.126012040689226</c:v>
                </c:pt>
                <c:pt idx="28">
                  <c:v>41.046551555478075</c:v>
                </c:pt>
                <c:pt idx="29">
                  <c:v>39.394778754933874</c:v>
                </c:pt>
                <c:pt idx="30">
                  <c:v>31.538925352640749</c:v>
                </c:pt>
                <c:pt idx="31">
                  <c:v>33.363963641006457</c:v>
                </c:pt>
                <c:pt idx="32">
                  <c:v>25.91283863368669</c:v>
                </c:pt>
                <c:pt idx="33">
                  <c:v>29.117647058823529</c:v>
                </c:pt>
                <c:pt idx="34">
                  <c:v>37.18004338394794</c:v>
                </c:pt>
                <c:pt idx="35">
                  <c:v>38.162197089986897</c:v>
                </c:pt>
                <c:pt idx="36">
                  <c:v>31.406588750726563</c:v>
                </c:pt>
                <c:pt idx="37">
                  <c:v>42.068218733080677</c:v>
                </c:pt>
                <c:pt idx="38">
                  <c:v>28.385925719072887</c:v>
                </c:pt>
                <c:pt idx="39">
                  <c:v>49.866111276405839</c:v>
                </c:pt>
                <c:pt idx="40">
                  <c:v>26.928440821892341</c:v>
                </c:pt>
                <c:pt idx="41">
                  <c:v>34.760480946625108</c:v>
                </c:pt>
                <c:pt idx="42">
                  <c:v>32.638415149944066</c:v>
                </c:pt>
                <c:pt idx="43">
                  <c:v>34.583670169765561</c:v>
                </c:pt>
                <c:pt idx="44">
                  <c:v>47.063160481690801</c:v>
                </c:pt>
                <c:pt idx="45">
                  <c:v>26.273870938546473</c:v>
                </c:pt>
                <c:pt idx="46">
                  <c:v>34.937601432648727</c:v>
                </c:pt>
                <c:pt idx="47">
                  <c:v>32.369419844568952</c:v>
                </c:pt>
                <c:pt idx="48">
                  <c:v>32.337725195691121</c:v>
                </c:pt>
                <c:pt idx="49">
                  <c:v>31.690316156335573</c:v>
                </c:pt>
                <c:pt idx="50">
                  <c:v>49.544324772162383</c:v>
                </c:pt>
                <c:pt idx="51">
                  <c:v>33.234295415959252</c:v>
                </c:pt>
                <c:pt idx="52">
                  <c:v>30.98484022248882</c:v>
                </c:pt>
                <c:pt idx="53">
                  <c:v>48.691099476439788</c:v>
                </c:pt>
                <c:pt idx="54">
                  <c:v>40.10077424112081</c:v>
                </c:pt>
                <c:pt idx="55">
                  <c:v>22.055807594307378</c:v>
                </c:pt>
                <c:pt idx="56">
                  <c:v>37.081935274380342</c:v>
                </c:pt>
                <c:pt idx="57">
                  <c:v>27.964848078335002</c:v>
                </c:pt>
                <c:pt idx="58">
                  <c:v>27.641041223538949</c:v>
                </c:pt>
                <c:pt idx="59">
                  <c:v>31.237327592680668</c:v>
                </c:pt>
                <c:pt idx="60">
                  <c:v>44.913353720693166</c:v>
                </c:pt>
                <c:pt idx="61">
                  <c:v>38.419574809466503</c:v>
                </c:pt>
                <c:pt idx="62">
                  <c:v>32.048471415837525</c:v>
                </c:pt>
                <c:pt idx="63">
                  <c:v>42.518986640057648</c:v>
                </c:pt>
                <c:pt idx="64">
                  <c:v>30.992461820880369</c:v>
                </c:pt>
                <c:pt idx="65">
                  <c:v>30.997050147492626</c:v>
                </c:pt>
                <c:pt idx="66">
                  <c:v>30.912326108055645</c:v>
                </c:pt>
                <c:pt idx="67">
                  <c:v>30.65461742410098</c:v>
                </c:pt>
                <c:pt idx="68">
                  <c:v>22.467078742273582</c:v>
                </c:pt>
                <c:pt idx="69">
                  <c:v>25.335399815953892</c:v>
                </c:pt>
                <c:pt idx="70">
                  <c:v>26.596360362677643</c:v>
                </c:pt>
                <c:pt idx="71">
                  <c:v>28.485983820059069</c:v>
                </c:pt>
                <c:pt idx="72">
                  <c:v>27.121840814786871</c:v>
                </c:pt>
                <c:pt idx="73">
                  <c:v>40.167944505293903</c:v>
                </c:pt>
                <c:pt idx="74">
                  <c:v>34.71607376761655</c:v>
                </c:pt>
                <c:pt idx="75">
                  <c:v>33.653234664970803</c:v>
                </c:pt>
                <c:pt idx="76">
                  <c:v>30.764327519267546</c:v>
                </c:pt>
                <c:pt idx="77">
                  <c:v>40.177175612298072</c:v>
                </c:pt>
                <c:pt idx="78">
                  <c:v>37.752140473080829</c:v>
                </c:pt>
                <c:pt idx="79">
                  <c:v>36.942126269956454</c:v>
                </c:pt>
                <c:pt idx="80">
                  <c:v>19.982899283907514</c:v>
                </c:pt>
                <c:pt idx="81">
                  <c:v>33.205736869578182</c:v>
                </c:pt>
                <c:pt idx="82">
                  <c:v>30.613644154953722</c:v>
                </c:pt>
                <c:pt idx="83">
                  <c:v>29.369593270563495</c:v>
                </c:pt>
                <c:pt idx="84">
                  <c:v>30.643502925013294</c:v>
                </c:pt>
                <c:pt idx="85">
                  <c:v>36.113229417685993</c:v>
                </c:pt>
                <c:pt idx="86">
                  <c:v>34.690072379025807</c:v>
                </c:pt>
                <c:pt idx="87">
                  <c:v>30.772065586740474</c:v>
                </c:pt>
                <c:pt idx="88">
                  <c:v>31.380890052356023</c:v>
                </c:pt>
                <c:pt idx="89">
                  <c:v>34.465713083718974</c:v>
                </c:pt>
                <c:pt idx="90">
                  <c:v>28.37564592226466</c:v>
                </c:pt>
                <c:pt idx="91">
                  <c:v>27.042824208834968</c:v>
                </c:pt>
                <c:pt idx="92">
                  <c:v>45.105025375739061</c:v>
                </c:pt>
                <c:pt idx="93">
                  <c:v>32.672154005307426</c:v>
                </c:pt>
                <c:pt idx="94">
                  <c:v>29.720189726808101</c:v>
                </c:pt>
                <c:pt idx="95">
                  <c:v>38.161009056965597</c:v>
                </c:pt>
                <c:pt idx="96">
                  <c:v>35.163025579097592</c:v>
                </c:pt>
                <c:pt idx="97">
                  <c:v>43.56435643564356</c:v>
                </c:pt>
                <c:pt idx="98">
                  <c:v>26.489734601902857</c:v>
                </c:pt>
                <c:pt idx="99">
                  <c:v>41.598766791455631</c:v>
                </c:pt>
                <c:pt idx="100">
                  <c:v>29.097746338128175</c:v>
                </c:pt>
                <c:pt idx="101">
                  <c:v>26.871911820600534</c:v>
                </c:pt>
                <c:pt idx="102">
                  <c:v>23.725490196078429</c:v>
                </c:pt>
                <c:pt idx="103">
                  <c:v>39.445438282647579</c:v>
                </c:pt>
                <c:pt idx="104">
                  <c:v>46.897546897546903</c:v>
                </c:pt>
                <c:pt idx="105">
                  <c:v>28.472198058132136</c:v>
                </c:pt>
                <c:pt idx="106">
                  <c:v>26.203010991040912</c:v>
                </c:pt>
                <c:pt idx="107">
                  <c:v>40.327323871627662</c:v>
                </c:pt>
                <c:pt idx="108">
                  <c:v>27.784924105994342</c:v>
                </c:pt>
                <c:pt idx="109">
                  <c:v>41.26528534828627</c:v>
                </c:pt>
                <c:pt idx="110">
                  <c:v>38.981715893108301</c:v>
                </c:pt>
                <c:pt idx="111">
                  <c:v>36.220725056143728</c:v>
                </c:pt>
                <c:pt idx="112">
                  <c:v>42.573039466940024</c:v>
                </c:pt>
                <c:pt idx="113">
                  <c:v>35.589160053900287</c:v>
                </c:pt>
                <c:pt idx="114">
                  <c:v>34.310436164577077</c:v>
                </c:pt>
                <c:pt idx="115">
                  <c:v>32.443483256175448</c:v>
                </c:pt>
                <c:pt idx="116">
                  <c:v>35.128097116378825</c:v>
                </c:pt>
                <c:pt idx="117">
                  <c:v>26.280477826869582</c:v>
                </c:pt>
                <c:pt idx="118">
                  <c:v>20.106175250183057</c:v>
                </c:pt>
                <c:pt idx="119">
                  <c:v>33.474857370306488</c:v>
                </c:pt>
                <c:pt idx="120">
                  <c:v>27.09837188471468</c:v>
                </c:pt>
                <c:pt idx="121">
                  <c:v>25.167315175097279</c:v>
                </c:pt>
                <c:pt idx="122">
                  <c:v>34.201893335832786</c:v>
                </c:pt>
                <c:pt idx="123">
                  <c:v>23.454545454545453</c:v>
                </c:pt>
                <c:pt idx="124">
                  <c:v>31.087595858980983</c:v>
                </c:pt>
                <c:pt idx="125">
                  <c:v>25.259409569247406</c:v>
                </c:pt>
                <c:pt idx="126">
                  <c:v>36.111194372627466</c:v>
                </c:pt>
                <c:pt idx="127">
                  <c:v>31.57317741640782</c:v>
                </c:pt>
                <c:pt idx="128">
                  <c:v>25.109902634406854</c:v>
                </c:pt>
                <c:pt idx="129">
                  <c:v>23.988662715794895</c:v>
                </c:pt>
                <c:pt idx="130">
                  <c:v>39.862394149345654</c:v>
                </c:pt>
                <c:pt idx="131">
                  <c:v>24.33369794306752</c:v>
                </c:pt>
                <c:pt idx="132">
                  <c:v>24.302127473679612</c:v>
                </c:pt>
                <c:pt idx="133">
                  <c:v>26.956461596984475</c:v>
                </c:pt>
                <c:pt idx="134">
                  <c:v>32.793566266369616</c:v>
                </c:pt>
                <c:pt idx="135">
                  <c:v>31.249639885858741</c:v>
                </c:pt>
                <c:pt idx="136">
                  <c:v>30.954207448275962</c:v>
                </c:pt>
                <c:pt idx="137">
                  <c:v>34.803499388060374</c:v>
                </c:pt>
                <c:pt idx="138">
                  <c:v>32.08263399530216</c:v>
                </c:pt>
                <c:pt idx="139">
                  <c:v>28.449197860962563</c:v>
                </c:pt>
                <c:pt idx="140">
                  <c:v>24.10247963412553</c:v>
                </c:pt>
                <c:pt idx="141">
                  <c:v>23.432001655971842</c:v>
                </c:pt>
                <c:pt idx="142">
                  <c:v>24.811890385508594</c:v>
                </c:pt>
                <c:pt idx="143">
                  <c:v>26.673806698121396</c:v>
                </c:pt>
                <c:pt idx="144">
                  <c:v>30.284425743175511</c:v>
                </c:pt>
                <c:pt idx="145">
                  <c:v>37.244151360674621</c:v>
                </c:pt>
                <c:pt idx="146">
                  <c:v>29.134460205555083</c:v>
                </c:pt>
                <c:pt idx="147">
                  <c:v>26.895579498539924</c:v>
                </c:pt>
                <c:pt idx="148">
                  <c:v>29.01296111665005</c:v>
                </c:pt>
                <c:pt idx="149">
                  <c:v>32.596971582659201</c:v>
                </c:pt>
                <c:pt idx="150">
                  <c:v>42.383867482895212</c:v>
                </c:pt>
                <c:pt idx="151">
                  <c:v>39.873621077433867</c:v>
                </c:pt>
                <c:pt idx="152">
                  <c:v>40.639923591212991</c:v>
                </c:pt>
                <c:pt idx="153">
                  <c:v>20.316161941087266</c:v>
                </c:pt>
                <c:pt idx="154">
                  <c:v>33.350717079530646</c:v>
                </c:pt>
                <c:pt idx="155">
                  <c:v>30.934739702979908</c:v>
                </c:pt>
                <c:pt idx="156">
                  <c:v>25.502124372344532</c:v>
                </c:pt>
                <c:pt idx="157">
                  <c:v>22.839415701792955</c:v>
                </c:pt>
                <c:pt idx="158">
                  <c:v>39.534782038389224</c:v>
                </c:pt>
                <c:pt idx="159">
                  <c:v>21.626526406447049</c:v>
                </c:pt>
                <c:pt idx="160">
                  <c:v>25.673923240349861</c:v>
                </c:pt>
                <c:pt idx="161">
                  <c:v>27.044604320030885</c:v>
                </c:pt>
                <c:pt idx="162">
                  <c:v>31.185609935996574</c:v>
                </c:pt>
                <c:pt idx="163">
                  <c:v>35.2112676056338</c:v>
                </c:pt>
                <c:pt idx="164">
                  <c:v>44.21113465613562</c:v>
                </c:pt>
                <c:pt idx="165">
                  <c:v>34.795972443031268</c:v>
                </c:pt>
                <c:pt idx="166">
                  <c:v>27.716839325614462</c:v>
                </c:pt>
                <c:pt idx="167">
                  <c:v>30.561305613056128</c:v>
                </c:pt>
                <c:pt idx="168">
                  <c:v>19.120998372219205</c:v>
                </c:pt>
                <c:pt idx="169">
                  <c:v>29.124261841939941</c:v>
                </c:pt>
                <c:pt idx="170">
                  <c:v>22.41469816272966</c:v>
                </c:pt>
                <c:pt idx="171">
                  <c:v>25.248556289813656</c:v>
                </c:pt>
                <c:pt idx="172">
                  <c:v>37.632884479092844</c:v>
                </c:pt>
                <c:pt idx="173">
                  <c:v>28.191757779646764</c:v>
                </c:pt>
                <c:pt idx="174">
                  <c:v>35.400117454331905</c:v>
                </c:pt>
                <c:pt idx="175">
                  <c:v>30.3650610459819</c:v>
                </c:pt>
                <c:pt idx="176">
                  <c:v>27.019418865403882</c:v>
                </c:pt>
                <c:pt idx="177">
                  <c:v>34.876302807759352</c:v>
                </c:pt>
                <c:pt idx="178">
                  <c:v>20.206473004031498</c:v>
                </c:pt>
                <c:pt idx="179">
                  <c:v>41.638104242997279</c:v>
                </c:pt>
                <c:pt idx="180">
                  <c:v>21.174387071780398</c:v>
                </c:pt>
                <c:pt idx="181">
                  <c:v>38.212847148611402</c:v>
                </c:pt>
                <c:pt idx="182">
                  <c:v>35.593394721950723</c:v>
                </c:pt>
                <c:pt idx="183">
                  <c:v>36.133109427465456</c:v>
                </c:pt>
                <c:pt idx="184">
                  <c:v>36.514612315324065</c:v>
                </c:pt>
                <c:pt idx="185">
                  <c:v>25.589738990043951</c:v>
                </c:pt>
                <c:pt idx="186">
                  <c:v>24.002542684261101</c:v>
                </c:pt>
                <c:pt idx="187">
                  <c:v>19.258796585467419</c:v>
                </c:pt>
                <c:pt idx="188">
                  <c:v>30.579167802532773</c:v>
                </c:pt>
                <c:pt idx="189">
                  <c:v>38.833054159687322</c:v>
                </c:pt>
                <c:pt idx="190">
                  <c:v>35.434802529093744</c:v>
                </c:pt>
                <c:pt idx="191">
                  <c:v>24.989946829900362</c:v>
                </c:pt>
                <c:pt idx="192">
                  <c:v>29.985895627644567</c:v>
                </c:pt>
                <c:pt idx="193">
                  <c:v>37.585493876252585</c:v>
                </c:pt>
                <c:pt idx="194">
                  <c:v>45.220933876527738</c:v>
                </c:pt>
                <c:pt idx="195">
                  <c:v>25.377643504531726</c:v>
                </c:pt>
                <c:pt idx="196">
                  <c:v>26.217440543601359</c:v>
                </c:pt>
                <c:pt idx="197">
                  <c:v>19.486539490105191</c:v>
                </c:pt>
                <c:pt idx="198">
                  <c:v>41.981659583985682</c:v>
                </c:pt>
                <c:pt idx="199">
                  <c:v>23.412496177759657</c:v>
                </c:pt>
                <c:pt idx="200">
                  <c:v>16.193832599118945</c:v>
                </c:pt>
                <c:pt idx="201">
                  <c:v>28.562161160279874</c:v>
                </c:pt>
                <c:pt idx="202">
                  <c:v>29.790816472132644</c:v>
                </c:pt>
                <c:pt idx="203">
                  <c:v>25.261733331301937</c:v>
                </c:pt>
                <c:pt idx="204">
                  <c:v>18.865662695736869</c:v>
                </c:pt>
                <c:pt idx="205">
                  <c:v>25.171058378220994</c:v>
                </c:pt>
                <c:pt idx="206">
                  <c:v>26.856109142986359</c:v>
                </c:pt>
                <c:pt idx="207">
                  <c:v>23.430932608266914</c:v>
                </c:pt>
                <c:pt idx="208">
                  <c:v>23.513947295224352</c:v>
                </c:pt>
                <c:pt idx="209">
                  <c:v>29.12152460514293</c:v>
                </c:pt>
                <c:pt idx="210">
                  <c:v>18.796852879058648</c:v>
                </c:pt>
                <c:pt idx="211">
                  <c:v>26.342702808087893</c:v>
                </c:pt>
                <c:pt idx="212">
                  <c:v>25.682822528636798</c:v>
                </c:pt>
                <c:pt idx="213">
                  <c:v>30.814986481266899</c:v>
                </c:pt>
                <c:pt idx="214">
                  <c:v>24.379790395745353</c:v>
                </c:pt>
                <c:pt idx="215">
                  <c:v>36.482127866389789</c:v>
                </c:pt>
                <c:pt idx="216">
                  <c:v>29.514657079646021</c:v>
                </c:pt>
                <c:pt idx="217">
                  <c:v>18.185550082101809</c:v>
                </c:pt>
                <c:pt idx="218">
                  <c:v>26.520940129606345</c:v>
                </c:pt>
                <c:pt idx="219">
                  <c:v>23.84174624829468</c:v>
                </c:pt>
                <c:pt idx="220">
                  <c:v>21.63794899264947</c:v>
                </c:pt>
                <c:pt idx="221">
                  <c:v>30.912405641849894</c:v>
                </c:pt>
                <c:pt idx="222">
                  <c:v>22.676545062365186</c:v>
                </c:pt>
                <c:pt idx="223">
                  <c:v>24.805057955742885</c:v>
                </c:pt>
                <c:pt idx="224">
                  <c:v>25.851525804259847</c:v>
                </c:pt>
                <c:pt idx="225">
                  <c:v>20.019723865877712</c:v>
                </c:pt>
                <c:pt idx="226">
                  <c:v>26.100574212632679</c:v>
                </c:pt>
                <c:pt idx="227">
                  <c:v>23.248862496551244</c:v>
                </c:pt>
                <c:pt idx="228">
                  <c:v>24.932665441639191</c:v>
                </c:pt>
                <c:pt idx="229">
                  <c:v>19.745746221866693</c:v>
                </c:pt>
                <c:pt idx="230">
                  <c:v>18.515375399361027</c:v>
                </c:pt>
                <c:pt idx="231">
                  <c:v>21.603453315047553</c:v>
                </c:pt>
                <c:pt idx="232">
                  <c:v>31.133759428801753</c:v>
                </c:pt>
                <c:pt idx="233">
                  <c:v>19.383273830210733</c:v>
                </c:pt>
                <c:pt idx="234">
                  <c:v>24.163754368447329</c:v>
                </c:pt>
                <c:pt idx="235">
                  <c:v>45.560277342876319</c:v>
                </c:pt>
                <c:pt idx="236">
                  <c:v>11.54661915669806</c:v>
                </c:pt>
                <c:pt idx="237">
                  <c:v>30.788086363788992</c:v>
                </c:pt>
                <c:pt idx="238">
                  <c:v>26.840158608510205</c:v>
                </c:pt>
                <c:pt idx="239">
                  <c:v>16.156446161274747</c:v>
                </c:pt>
                <c:pt idx="240">
                  <c:v>16.555435952637247</c:v>
                </c:pt>
                <c:pt idx="241">
                  <c:v>9.1700281139225037</c:v>
                </c:pt>
                <c:pt idx="242">
                  <c:v>18.188024577326214</c:v>
                </c:pt>
                <c:pt idx="243">
                  <c:v>16.097280597765565</c:v>
                </c:pt>
                <c:pt idx="244">
                  <c:v>11.962113345290915</c:v>
                </c:pt>
                <c:pt idx="245">
                  <c:v>12.243063505319228</c:v>
                </c:pt>
                <c:pt idx="246">
                  <c:v>43.372295448893311</c:v>
                </c:pt>
                <c:pt idx="247">
                  <c:v>39.860424147977504</c:v>
                </c:pt>
                <c:pt idx="248">
                  <c:v>38.542056074766364</c:v>
                </c:pt>
                <c:pt idx="249">
                  <c:v>37.848442107962555</c:v>
                </c:pt>
                <c:pt idx="250">
                  <c:v>48.457026268808974</c:v>
                </c:pt>
                <c:pt idx="251">
                  <c:v>35.879743716116316</c:v>
                </c:pt>
                <c:pt idx="252">
                  <c:v>37.195317682809389</c:v>
                </c:pt>
                <c:pt idx="253">
                  <c:v>45.325588878742771</c:v>
                </c:pt>
                <c:pt idx="254">
                  <c:v>37.434816960758496</c:v>
                </c:pt>
                <c:pt idx="255">
                  <c:v>34.410850522746543</c:v>
                </c:pt>
                <c:pt idx="256">
                  <c:v>33.621755253399257</c:v>
                </c:pt>
                <c:pt idx="257">
                  <c:v>30.835194529462051</c:v>
                </c:pt>
                <c:pt idx="258">
                  <c:v>25.738396624472575</c:v>
                </c:pt>
                <c:pt idx="259">
                  <c:v>35.368693402328596</c:v>
                </c:pt>
                <c:pt idx="260">
                  <c:v>22.087757451707819</c:v>
                </c:pt>
                <c:pt idx="261">
                  <c:v>28.225261998715311</c:v>
                </c:pt>
                <c:pt idx="262">
                  <c:v>40.509353284846469</c:v>
                </c:pt>
                <c:pt idx="263">
                  <c:v>25.270367700072097</c:v>
                </c:pt>
                <c:pt idx="264">
                  <c:v>22.661466643030195</c:v>
                </c:pt>
                <c:pt idx="265">
                  <c:v>24.213393444162676</c:v>
                </c:pt>
                <c:pt idx="266">
                  <c:v>13.042393202340927</c:v>
                </c:pt>
                <c:pt idx="267">
                  <c:v>29.07185215832299</c:v>
                </c:pt>
                <c:pt idx="268">
                  <c:v>18.720773985487774</c:v>
                </c:pt>
                <c:pt idx="269">
                  <c:v>31.231655614740735</c:v>
                </c:pt>
                <c:pt idx="270">
                  <c:v>53.086991775744238</c:v>
                </c:pt>
                <c:pt idx="271">
                  <c:v>29.68863194445608</c:v>
                </c:pt>
                <c:pt idx="272">
                  <c:v>39.369834419339369</c:v>
                </c:pt>
                <c:pt idx="273">
                  <c:v>22.376797925017684</c:v>
                </c:pt>
                <c:pt idx="274">
                  <c:v>19.345430978613088</c:v>
                </c:pt>
                <c:pt idx="275">
                  <c:v>18.452281464148417</c:v>
                </c:pt>
                <c:pt idx="276">
                  <c:v>29.973974470194573</c:v>
                </c:pt>
                <c:pt idx="277">
                  <c:v>36.4208984375</c:v>
                </c:pt>
                <c:pt idx="278">
                  <c:v>40.945841178425077</c:v>
                </c:pt>
                <c:pt idx="279">
                  <c:v>56.597289762043708</c:v>
                </c:pt>
                <c:pt idx="280">
                  <c:v>20.470551466572413</c:v>
                </c:pt>
                <c:pt idx="281">
                  <c:v>41.055045871559628</c:v>
                </c:pt>
                <c:pt idx="282">
                  <c:v>35.952435867866022</c:v>
                </c:pt>
                <c:pt idx="283">
                  <c:v>35.155487379723887</c:v>
                </c:pt>
                <c:pt idx="284">
                  <c:v>22.931377874343656</c:v>
                </c:pt>
                <c:pt idx="285">
                  <c:v>30.873786407766996</c:v>
                </c:pt>
                <c:pt idx="286">
                  <c:v>20.320616156188432</c:v>
                </c:pt>
                <c:pt idx="287">
                  <c:v>33.326295788029142</c:v>
                </c:pt>
                <c:pt idx="288">
                  <c:v>29.34261980239258</c:v>
                </c:pt>
                <c:pt idx="289">
                  <c:v>42.039623984120446</c:v>
                </c:pt>
                <c:pt idx="290">
                  <c:v>63.069739112780432</c:v>
                </c:pt>
                <c:pt idx="291">
                  <c:v>46.122260668973475</c:v>
                </c:pt>
                <c:pt idx="292">
                  <c:v>49.001832384993726</c:v>
                </c:pt>
                <c:pt idx="293">
                  <c:v>13.751087464289522</c:v>
                </c:pt>
                <c:pt idx="294">
                  <c:v>23.443558301547771</c:v>
                </c:pt>
                <c:pt idx="295">
                  <c:v>40.936012077575185</c:v>
                </c:pt>
                <c:pt idx="296">
                  <c:v>44.825253664036083</c:v>
                </c:pt>
                <c:pt idx="297">
                  <c:v>35.488721804511279</c:v>
                </c:pt>
                <c:pt idx="298">
                  <c:v>44.872791912009781</c:v>
                </c:pt>
                <c:pt idx="299">
                  <c:v>49.440488301119025</c:v>
                </c:pt>
                <c:pt idx="300">
                  <c:v>46.730348614024912</c:v>
                </c:pt>
                <c:pt idx="301">
                  <c:v>42.305129913391077</c:v>
                </c:pt>
                <c:pt idx="302">
                  <c:v>44.367953706475113</c:v>
                </c:pt>
                <c:pt idx="303">
                  <c:v>38.183948447568845</c:v>
                </c:pt>
                <c:pt idx="304">
                  <c:v>45.048066174826737</c:v>
                </c:pt>
                <c:pt idx="305">
                  <c:v>33.254800173413088</c:v>
                </c:pt>
                <c:pt idx="306">
                  <c:v>58.88768273789546</c:v>
                </c:pt>
                <c:pt idx="307">
                  <c:v>38.574071683662496</c:v>
                </c:pt>
                <c:pt idx="308">
                  <c:v>46.666666666666664</c:v>
                </c:pt>
                <c:pt idx="309">
                  <c:v>42.387515842839044</c:v>
                </c:pt>
                <c:pt idx="310">
                  <c:v>58.622103752306749</c:v>
                </c:pt>
                <c:pt idx="311">
                  <c:v>33.024933354241803</c:v>
                </c:pt>
                <c:pt idx="312">
                  <c:v>31.013334252144855</c:v>
                </c:pt>
                <c:pt idx="313">
                  <c:v>32.577674869420065</c:v>
                </c:pt>
                <c:pt idx="314">
                  <c:v>37.778624499904744</c:v>
                </c:pt>
                <c:pt idx="315">
                  <c:v>25.712095073797197</c:v>
                </c:pt>
                <c:pt idx="316">
                  <c:v>31.127997769102063</c:v>
                </c:pt>
                <c:pt idx="317">
                  <c:v>39.845437925876681</c:v>
                </c:pt>
                <c:pt idx="318">
                  <c:v>28.412645590682196</c:v>
                </c:pt>
                <c:pt idx="319">
                  <c:v>29.273889526307165</c:v>
                </c:pt>
                <c:pt idx="320">
                  <c:v>33.137359700694816</c:v>
                </c:pt>
                <c:pt idx="321">
                  <c:v>40.247703080098759</c:v>
                </c:pt>
                <c:pt idx="322">
                  <c:v>32.522988505747129</c:v>
                </c:pt>
                <c:pt idx="323">
                  <c:v>34.781757682521047</c:v>
                </c:pt>
                <c:pt idx="324">
                  <c:v>29.439991072590995</c:v>
                </c:pt>
                <c:pt idx="325">
                  <c:v>26.327970024245097</c:v>
                </c:pt>
                <c:pt idx="326">
                  <c:v>36.422811619547261</c:v>
                </c:pt>
                <c:pt idx="327">
                  <c:v>35.470527404343322</c:v>
                </c:pt>
                <c:pt idx="328">
                  <c:v>31.291866028708142</c:v>
                </c:pt>
                <c:pt idx="329">
                  <c:v>33.800522239828595</c:v>
                </c:pt>
                <c:pt idx="330">
                  <c:v>28.036454018227012</c:v>
                </c:pt>
                <c:pt idx="331">
                  <c:v>45.897379431843206</c:v>
                </c:pt>
                <c:pt idx="332">
                  <c:v>40.118526153053338</c:v>
                </c:pt>
                <c:pt idx="333">
                  <c:v>35.122556624263105</c:v>
                </c:pt>
                <c:pt idx="334">
                  <c:v>36.129032258064512</c:v>
                </c:pt>
                <c:pt idx="335">
                  <c:v>44.094215448562522</c:v>
                </c:pt>
                <c:pt idx="336">
                  <c:v>36.386295879966767</c:v>
                </c:pt>
                <c:pt idx="337">
                  <c:v>28.006890262437935</c:v>
                </c:pt>
                <c:pt idx="338">
                  <c:v>24.348308374930674</c:v>
                </c:pt>
                <c:pt idx="339">
                  <c:v>40.769477871951374</c:v>
                </c:pt>
                <c:pt idx="340">
                  <c:v>23.742088378948587</c:v>
                </c:pt>
                <c:pt idx="341">
                  <c:v>20.994590968174769</c:v>
                </c:pt>
                <c:pt idx="342">
                  <c:v>26.817694780345931</c:v>
                </c:pt>
                <c:pt idx="343">
                  <c:v>44.53611719144638</c:v>
                </c:pt>
                <c:pt idx="344">
                  <c:v>31.128876982964297</c:v>
                </c:pt>
                <c:pt idx="345">
                  <c:v>25.610466006924234</c:v>
                </c:pt>
                <c:pt idx="346">
                  <c:v>24.088760714571816</c:v>
                </c:pt>
                <c:pt idx="347">
                  <c:v>25.805252725470762</c:v>
                </c:pt>
                <c:pt idx="348">
                  <c:v>36.664078587583973</c:v>
                </c:pt>
                <c:pt idx="349">
                  <c:v>19.49378712658191</c:v>
                </c:pt>
                <c:pt idx="350">
                  <c:v>21.268115942028988</c:v>
                </c:pt>
                <c:pt idx="351">
                  <c:v>27.927224690764977</c:v>
                </c:pt>
                <c:pt idx="352">
                  <c:v>41.243655834847274</c:v>
                </c:pt>
                <c:pt idx="353">
                  <c:v>27.612805646584317</c:v>
                </c:pt>
                <c:pt idx="354">
                  <c:v>27.659325210871604</c:v>
                </c:pt>
                <c:pt idx="355">
                  <c:v>31.01715520734837</c:v>
                </c:pt>
                <c:pt idx="356">
                  <c:v>29.13807531380753</c:v>
                </c:pt>
                <c:pt idx="357">
                  <c:v>30.018965050121913</c:v>
                </c:pt>
                <c:pt idx="358">
                  <c:v>35.970485755277721</c:v>
                </c:pt>
                <c:pt idx="359">
                  <c:v>27.531120767470664</c:v>
                </c:pt>
                <c:pt idx="360">
                  <c:v>15.857202158572019</c:v>
                </c:pt>
                <c:pt idx="361">
                  <c:v>28.731960527066338</c:v>
                </c:pt>
                <c:pt idx="362">
                  <c:v>25.696277329131373</c:v>
                </c:pt>
                <c:pt idx="363">
                  <c:v>24.015285126396236</c:v>
                </c:pt>
                <c:pt idx="364">
                  <c:v>27.251398664500989</c:v>
                </c:pt>
                <c:pt idx="365">
                  <c:v>21.546247442661784</c:v>
                </c:pt>
                <c:pt idx="366">
                  <c:v>22.214262973575295</c:v>
                </c:pt>
                <c:pt idx="367">
                  <c:v>37.607004312680154</c:v>
                </c:pt>
                <c:pt idx="368">
                  <c:v>26.25414520567276</c:v>
                </c:pt>
                <c:pt idx="369">
                  <c:v>18.74188963727368</c:v>
                </c:pt>
                <c:pt idx="370">
                  <c:v>29.477798937556383</c:v>
                </c:pt>
                <c:pt idx="371">
                  <c:v>27.638804148871262</c:v>
                </c:pt>
                <c:pt idx="372">
                  <c:v>40.630168706582865</c:v>
                </c:pt>
                <c:pt idx="373">
                  <c:v>23.418138110637322</c:v>
                </c:pt>
                <c:pt idx="374">
                  <c:v>27.214274232438516</c:v>
                </c:pt>
                <c:pt idx="375">
                  <c:v>28.229840745330215</c:v>
                </c:pt>
                <c:pt idx="376">
                  <c:v>20.154744747022683</c:v>
                </c:pt>
                <c:pt idx="377">
                  <c:v>25.863247863247864</c:v>
                </c:pt>
                <c:pt idx="378">
                  <c:v>21.187202878067588</c:v>
                </c:pt>
                <c:pt idx="379">
                  <c:v>24.280465401102269</c:v>
                </c:pt>
                <c:pt idx="380">
                  <c:v>34.414984830497296</c:v>
                </c:pt>
                <c:pt idx="381">
                  <c:v>19.840672046828409</c:v>
                </c:pt>
                <c:pt idx="382">
                  <c:v>27.837148063951886</c:v>
                </c:pt>
                <c:pt idx="383">
                  <c:v>30.623863366806354</c:v>
                </c:pt>
                <c:pt idx="384">
                  <c:v>23.547323014463334</c:v>
                </c:pt>
                <c:pt idx="385">
                  <c:v>34.367810465514708</c:v>
                </c:pt>
                <c:pt idx="386">
                  <c:v>26.453603702887367</c:v>
                </c:pt>
                <c:pt idx="387">
                  <c:v>28.66945606694561</c:v>
                </c:pt>
                <c:pt idx="388">
                  <c:v>33.029092983456927</c:v>
                </c:pt>
                <c:pt idx="389">
                  <c:v>16.475614839516467</c:v>
                </c:pt>
                <c:pt idx="390">
                  <c:v>19.824753559693317</c:v>
                </c:pt>
                <c:pt idx="391">
                  <c:v>37.291280148423006</c:v>
                </c:pt>
                <c:pt idx="392">
                  <c:v>27.368354350167923</c:v>
                </c:pt>
                <c:pt idx="393">
                  <c:v>21.06542407721647</c:v>
                </c:pt>
                <c:pt idx="394">
                  <c:v>30.219200067576132</c:v>
                </c:pt>
                <c:pt idx="395">
                  <c:v>28.397642239036834</c:v>
                </c:pt>
                <c:pt idx="396">
                  <c:v>20.459278437552765</c:v>
                </c:pt>
                <c:pt idx="397">
                  <c:v>17.130835503907029</c:v>
                </c:pt>
                <c:pt idx="398">
                  <c:v>32.780110207294676</c:v>
                </c:pt>
                <c:pt idx="399">
                  <c:v>18.961864406779657</c:v>
                </c:pt>
                <c:pt idx="400">
                  <c:v>28.488855537753256</c:v>
                </c:pt>
                <c:pt idx="401">
                  <c:v>23.747437749924394</c:v>
                </c:pt>
                <c:pt idx="402">
                  <c:v>18.757612667478686</c:v>
                </c:pt>
                <c:pt idx="403">
                  <c:v>22.077756882265795</c:v>
                </c:pt>
                <c:pt idx="404">
                  <c:v>25.172026846774365</c:v>
                </c:pt>
                <c:pt idx="405">
                  <c:v>30.626675293465201</c:v>
                </c:pt>
                <c:pt idx="406">
                  <c:v>23.109455241164028</c:v>
                </c:pt>
                <c:pt idx="407">
                  <c:v>20.987370838117105</c:v>
                </c:pt>
                <c:pt idx="408">
                  <c:v>21.78926441351889</c:v>
                </c:pt>
                <c:pt idx="409">
                  <c:v>16.688654353562004</c:v>
                </c:pt>
                <c:pt idx="410">
                  <c:v>42.368379940634277</c:v>
                </c:pt>
                <c:pt idx="411">
                  <c:v>31.190815385904635</c:v>
                </c:pt>
                <c:pt idx="412">
                  <c:v>37.85246368555967</c:v>
                </c:pt>
                <c:pt idx="413">
                  <c:v>48.829558395545988</c:v>
                </c:pt>
                <c:pt idx="414">
                  <c:v>52.740670059372356</c:v>
                </c:pt>
                <c:pt idx="415">
                  <c:v>32.587893206449905</c:v>
                </c:pt>
                <c:pt idx="416">
                  <c:v>30.1</c:v>
                </c:pt>
                <c:pt idx="417">
                  <c:v>35.580320739331341</c:v>
                </c:pt>
                <c:pt idx="418">
                  <c:v>38.64766324163076</c:v>
                </c:pt>
                <c:pt idx="419">
                  <c:v>29.110524609899525</c:v>
                </c:pt>
                <c:pt idx="420">
                  <c:v>49.275362318840585</c:v>
                </c:pt>
                <c:pt idx="421">
                  <c:v>30.966164929885505</c:v>
                </c:pt>
                <c:pt idx="422">
                  <c:v>27.839887420842782</c:v>
                </c:pt>
                <c:pt idx="423">
                  <c:v>36.756126021003503</c:v>
                </c:pt>
                <c:pt idx="424">
                  <c:v>44.285420098846792</c:v>
                </c:pt>
                <c:pt idx="425">
                  <c:v>35.287561301827907</c:v>
                </c:pt>
                <c:pt idx="426">
                  <c:v>22.418090361172798</c:v>
                </c:pt>
                <c:pt idx="427">
                  <c:v>27.031509121061358</c:v>
                </c:pt>
                <c:pt idx="428">
                  <c:v>28.885526081538192</c:v>
                </c:pt>
                <c:pt idx="429">
                  <c:v>32.882424735557365</c:v>
                </c:pt>
                <c:pt idx="430">
                  <c:v>24.302295252999478</c:v>
                </c:pt>
                <c:pt idx="431">
                  <c:v>35.819495262219718</c:v>
                </c:pt>
                <c:pt idx="432">
                  <c:v>34.785148101793908</c:v>
                </c:pt>
                <c:pt idx="433">
                  <c:v>31.355229476872047</c:v>
                </c:pt>
                <c:pt idx="434">
                  <c:v>34.865078757243879</c:v>
                </c:pt>
                <c:pt idx="435">
                  <c:v>31.151105897164438</c:v>
                </c:pt>
                <c:pt idx="436">
                  <c:v>35.534250140991716</c:v>
                </c:pt>
                <c:pt idx="437">
                  <c:v>41.903839166767597</c:v>
                </c:pt>
                <c:pt idx="438">
                  <c:v>43.395923607767614</c:v>
                </c:pt>
                <c:pt idx="439">
                  <c:v>32.927974947807932</c:v>
                </c:pt>
                <c:pt idx="440">
                  <c:v>23.651370737938485</c:v>
                </c:pt>
                <c:pt idx="441">
                  <c:v>26.518422567645363</c:v>
                </c:pt>
                <c:pt idx="442">
                  <c:v>36.155881645417367</c:v>
                </c:pt>
                <c:pt idx="443">
                  <c:v>24.131025604348444</c:v>
                </c:pt>
                <c:pt idx="444">
                  <c:v>24.197227583786628</c:v>
                </c:pt>
                <c:pt idx="445">
                  <c:v>20.424671385237612</c:v>
                </c:pt>
                <c:pt idx="446">
                  <c:v>24.326979760267243</c:v>
                </c:pt>
                <c:pt idx="447">
                  <c:v>22.176271389613113</c:v>
                </c:pt>
                <c:pt idx="448">
                  <c:v>26.052022334195836</c:v>
                </c:pt>
                <c:pt idx="449">
                  <c:v>28.235039965435305</c:v>
                </c:pt>
                <c:pt idx="450">
                  <c:v>19.362786953233634</c:v>
                </c:pt>
                <c:pt idx="451">
                  <c:v>12.958212660322715</c:v>
                </c:pt>
                <c:pt idx="452">
                  <c:v>18.29824352721938</c:v>
                </c:pt>
                <c:pt idx="453">
                  <c:v>34.189056891112806</c:v>
                </c:pt>
                <c:pt idx="454">
                  <c:v>47.513375486381321</c:v>
                </c:pt>
                <c:pt idx="455">
                  <c:v>42.511843238587424</c:v>
                </c:pt>
                <c:pt idx="456">
                  <c:v>32.516172965611169</c:v>
                </c:pt>
                <c:pt idx="457">
                  <c:v>38.702405836304763</c:v>
                </c:pt>
                <c:pt idx="458">
                  <c:v>39.172965762561148</c:v>
                </c:pt>
                <c:pt idx="459">
                  <c:v>50.644043706138397</c:v>
                </c:pt>
                <c:pt idx="460">
                  <c:v>32.385811467444121</c:v>
                </c:pt>
                <c:pt idx="461">
                  <c:v>26.705816554809843</c:v>
                </c:pt>
                <c:pt idx="462">
                  <c:v>38.522208385222079</c:v>
                </c:pt>
                <c:pt idx="463">
                  <c:v>47.074578894113451</c:v>
                </c:pt>
                <c:pt idx="464">
                  <c:v>28.715198707118201</c:v>
                </c:pt>
                <c:pt idx="465">
                  <c:v>52.227140032018085</c:v>
                </c:pt>
                <c:pt idx="466">
                  <c:v>49.554117061246657</c:v>
                </c:pt>
                <c:pt idx="467">
                  <c:v>25.63211340557486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986880"/>
        <c:axId val="80988800"/>
      </c:scatterChart>
      <c:valAx>
        <c:axId val="809868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BMI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0988800"/>
        <c:crosses val="autoZero"/>
        <c:crossBetween val="midCat"/>
      </c:valAx>
      <c:valAx>
        <c:axId val="809888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rtl="0">
                  <a:defRPr/>
                </a:pPr>
                <a:r>
                  <a:rPr lang="en-US"/>
                  <a:t>% Methylat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8098688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rtl="0">
              <a:defRPr sz="1600"/>
            </a:pPr>
            <a:r>
              <a:rPr lang="en-US" sz="1600" b="1" i="0" baseline="0">
                <a:effectLst/>
              </a:rPr>
              <a:t>Methylation and BMI - group 3+4</a:t>
            </a:r>
            <a:endParaRPr lang="he-IL" sz="1600">
              <a:effectLst/>
            </a:endParaRPr>
          </a:p>
        </c:rich>
      </c:tx>
      <c:layout>
        <c:manualLayout>
          <c:xMode val="edge"/>
          <c:yMode val="edge"/>
          <c:x val="0.18097222222222226"/>
          <c:y val="2.7777777777777776E-2"/>
        </c:manualLayout>
      </c:layout>
      <c:overlay val="1"/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trendline>
            <c:trendlineType val="linear"/>
            <c:dispRSqr val="0"/>
            <c:dispEq val="0"/>
          </c:trendline>
          <c:xVal>
            <c:numRef>
              <c:f>'[SJ database FTO methylation analysis2.xlsx]age,lym'!$D$470:$D$930</c:f>
              <c:numCache>
                <c:formatCode>General</c:formatCode>
                <c:ptCount val="461"/>
                <c:pt idx="0">
                  <c:v>27.61</c:v>
                </c:pt>
                <c:pt idx="1">
                  <c:v>27.11</c:v>
                </c:pt>
                <c:pt idx="2">
                  <c:v>29.19</c:v>
                </c:pt>
                <c:pt idx="3">
                  <c:v>26.27</c:v>
                </c:pt>
                <c:pt idx="4">
                  <c:v>31.49</c:v>
                </c:pt>
                <c:pt idx="5">
                  <c:v>24.22</c:v>
                </c:pt>
                <c:pt idx="6">
                  <c:v>36.14</c:v>
                </c:pt>
                <c:pt idx="7">
                  <c:v>36.83</c:v>
                </c:pt>
                <c:pt idx="8">
                  <c:v>35.57</c:v>
                </c:pt>
                <c:pt idx="9">
                  <c:v>34.64</c:v>
                </c:pt>
                <c:pt idx="10">
                  <c:v>38.56</c:v>
                </c:pt>
                <c:pt idx="11">
                  <c:v>23.61</c:v>
                </c:pt>
                <c:pt idx="12">
                  <c:v>35.270000000000003</c:v>
                </c:pt>
                <c:pt idx="13">
                  <c:v>34.909999999999997</c:v>
                </c:pt>
                <c:pt idx="14">
                  <c:v>36.04</c:v>
                </c:pt>
                <c:pt idx="15">
                  <c:v>42.38</c:v>
                </c:pt>
                <c:pt idx="16">
                  <c:v>34.19</c:v>
                </c:pt>
                <c:pt idx="17">
                  <c:v>26.71</c:v>
                </c:pt>
                <c:pt idx="18">
                  <c:v>30.31</c:v>
                </c:pt>
                <c:pt idx="19">
                  <c:v>29.69</c:v>
                </c:pt>
                <c:pt idx="20">
                  <c:v>18.05</c:v>
                </c:pt>
                <c:pt idx="21">
                  <c:v>28.32</c:v>
                </c:pt>
                <c:pt idx="22">
                  <c:v>19.68</c:v>
                </c:pt>
                <c:pt idx="23">
                  <c:v>41.51</c:v>
                </c:pt>
                <c:pt idx="24">
                  <c:v>27.46</c:v>
                </c:pt>
                <c:pt idx="25">
                  <c:v>34.04</c:v>
                </c:pt>
                <c:pt idx="26">
                  <c:v>29.45</c:v>
                </c:pt>
                <c:pt idx="27">
                  <c:v>24.24</c:v>
                </c:pt>
                <c:pt idx="28">
                  <c:v>29.04</c:v>
                </c:pt>
                <c:pt idx="29">
                  <c:v>27.86</c:v>
                </c:pt>
                <c:pt idx="30">
                  <c:v>36.67</c:v>
                </c:pt>
                <c:pt idx="31">
                  <c:v>38.479999999999997</c:v>
                </c:pt>
                <c:pt idx="32">
                  <c:v>25.17</c:v>
                </c:pt>
                <c:pt idx="33">
                  <c:v>32.21</c:v>
                </c:pt>
                <c:pt idx="34">
                  <c:v>46.77</c:v>
                </c:pt>
                <c:pt idx="35">
                  <c:v>39.840000000000003</c:v>
                </c:pt>
                <c:pt idx="36">
                  <c:v>29.88</c:v>
                </c:pt>
                <c:pt idx="37">
                  <c:v>29.78</c:v>
                </c:pt>
                <c:pt idx="38">
                  <c:v>31.89</c:v>
                </c:pt>
                <c:pt idx="39">
                  <c:v>35.450000000000003</c:v>
                </c:pt>
                <c:pt idx="40">
                  <c:v>39.840000000000003</c:v>
                </c:pt>
                <c:pt idx="41">
                  <c:v>35.71</c:v>
                </c:pt>
                <c:pt idx="42">
                  <c:v>26.21</c:v>
                </c:pt>
                <c:pt idx="43">
                  <c:v>30.55</c:v>
                </c:pt>
                <c:pt idx="44">
                  <c:v>40.43</c:v>
                </c:pt>
                <c:pt idx="45">
                  <c:v>33.06</c:v>
                </c:pt>
                <c:pt idx="46">
                  <c:v>36.64</c:v>
                </c:pt>
                <c:pt idx="47">
                  <c:v>28.52</c:v>
                </c:pt>
                <c:pt idx="48">
                  <c:v>33.07</c:v>
                </c:pt>
                <c:pt idx="49">
                  <c:v>25.61</c:v>
                </c:pt>
                <c:pt idx="50">
                  <c:v>23.21</c:v>
                </c:pt>
                <c:pt idx="51">
                  <c:v>29.55</c:v>
                </c:pt>
                <c:pt idx="52">
                  <c:v>26.98</c:v>
                </c:pt>
                <c:pt idx="53">
                  <c:v>23.31</c:v>
                </c:pt>
                <c:pt idx="54">
                  <c:v>31.4</c:v>
                </c:pt>
                <c:pt idx="55">
                  <c:v>33.909999999999997</c:v>
                </c:pt>
                <c:pt idx="56">
                  <c:v>31.33</c:v>
                </c:pt>
                <c:pt idx="57">
                  <c:v>29.82</c:v>
                </c:pt>
                <c:pt idx="58">
                  <c:v>28.89</c:v>
                </c:pt>
                <c:pt idx="59">
                  <c:v>37.020000000000003</c:v>
                </c:pt>
                <c:pt idx="60">
                  <c:v>35.520000000000003</c:v>
                </c:pt>
                <c:pt idx="61">
                  <c:v>27.6</c:v>
                </c:pt>
                <c:pt idx="62">
                  <c:v>44.67</c:v>
                </c:pt>
                <c:pt idx="63">
                  <c:v>26.27</c:v>
                </c:pt>
                <c:pt idx="64">
                  <c:v>24.87</c:v>
                </c:pt>
                <c:pt idx="65">
                  <c:v>28.81</c:v>
                </c:pt>
                <c:pt idx="66">
                  <c:v>37.01</c:v>
                </c:pt>
                <c:pt idx="67">
                  <c:v>39.11</c:v>
                </c:pt>
                <c:pt idx="68">
                  <c:v>26.38</c:v>
                </c:pt>
                <c:pt idx="69">
                  <c:v>33.369999999999997</c:v>
                </c:pt>
                <c:pt idx="70">
                  <c:v>32.47</c:v>
                </c:pt>
                <c:pt idx="71">
                  <c:v>34.46</c:v>
                </c:pt>
                <c:pt idx="72">
                  <c:v>32.65</c:v>
                </c:pt>
                <c:pt idx="73">
                  <c:v>32.51</c:v>
                </c:pt>
                <c:pt idx="74">
                  <c:v>37.049999999999997</c:v>
                </c:pt>
                <c:pt idx="75">
                  <c:v>26.64</c:v>
                </c:pt>
                <c:pt idx="76">
                  <c:v>31.95</c:v>
                </c:pt>
                <c:pt idx="77">
                  <c:v>26.85</c:v>
                </c:pt>
                <c:pt idx="78">
                  <c:v>26.6</c:v>
                </c:pt>
                <c:pt idx="79">
                  <c:v>32.630000000000003</c:v>
                </c:pt>
                <c:pt idx="80">
                  <c:v>29.48</c:v>
                </c:pt>
                <c:pt idx="81">
                  <c:v>26.63</c:v>
                </c:pt>
                <c:pt idx="82">
                  <c:v>30.89</c:v>
                </c:pt>
                <c:pt idx="83">
                  <c:v>30.68</c:v>
                </c:pt>
                <c:pt idx="84">
                  <c:v>29.2</c:v>
                </c:pt>
                <c:pt idx="85">
                  <c:v>22.7</c:v>
                </c:pt>
                <c:pt idx="86">
                  <c:v>30.06</c:v>
                </c:pt>
                <c:pt idx="87">
                  <c:v>31.25</c:v>
                </c:pt>
                <c:pt idx="88">
                  <c:v>29.42</c:v>
                </c:pt>
                <c:pt idx="89">
                  <c:v>36.71</c:v>
                </c:pt>
                <c:pt idx="90">
                  <c:v>22.47</c:v>
                </c:pt>
                <c:pt idx="91">
                  <c:v>38.1</c:v>
                </c:pt>
                <c:pt idx="92">
                  <c:v>42.82</c:v>
                </c:pt>
                <c:pt idx="93">
                  <c:v>24.35</c:v>
                </c:pt>
                <c:pt idx="94">
                  <c:v>30.44</c:v>
                </c:pt>
                <c:pt idx="95">
                  <c:v>33.869999999999997</c:v>
                </c:pt>
                <c:pt idx="96">
                  <c:v>32.29</c:v>
                </c:pt>
                <c:pt idx="97">
                  <c:v>20.54</c:v>
                </c:pt>
                <c:pt idx="98">
                  <c:v>29.52</c:v>
                </c:pt>
                <c:pt idx="99">
                  <c:v>38</c:v>
                </c:pt>
                <c:pt idx="100">
                  <c:v>39.369999999999997</c:v>
                </c:pt>
                <c:pt idx="101">
                  <c:v>34.479999999999997</c:v>
                </c:pt>
                <c:pt idx="102">
                  <c:v>26.64</c:v>
                </c:pt>
                <c:pt idx="103">
                  <c:v>31.39</c:v>
                </c:pt>
                <c:pt idx="104">
                  <c:v>34.82</c:v>
                </c:pt>
                <c:pt idx="105">
                  <c:v>40.69</c:v>
                </c:pt>
                <c:pt idx="106">
                  <c:v>29.2</c:v>
                </c:pt>
                <c:pt idx="107">
                  <c:v>24.76</c:v>
                </c:pt>
                <c:pt idx="108">
                  <c:v>34.630000000000003</c:v>
                </c:pt>
                <c:pt idx="109">
                  <c:v>27.52</c:v>
                </c:pt>
                <c:pt idx="110">
                  <c:v>21.46</c:v>
                </c:pt>
                <c:pt idx="111">
                  <c:v>18.71</c:v>
                </c:pt>
                <c:pt idx="112">
                  <c:v>27.67</c:v>
                </c:pt>
                <c:pt idx="113">
                  <c:v>32.31</c:v>
                </c:pt>
                <c:pt idx="114">
                  <c:v>24.3</c:v>
                </c:pt>
                <c:pt idx="115">
                  <c:v>28.78</c:v>
                </c:pt>
                <c:pt idx="116">
                  <c:v>27.78</c:v>
                </c:pt>
                <c:pt idx="117">
                  <c:v>29.35</c:v>
                </c:pt>
                <c:pt idx="118">
                  <c:v>35</c:v>
                </c:pt>
                <c:pt idx="119">
                  <c:v>26.93</c:v>
                </c:pt>
                <c:pt idx="120">
                  <c:v>28.72</c:v>
                </c:pt>
                <c:pt idx="121">
                  <c:v>31.13</c:v>
                </c:pt>
                <c:pt idx="122">
                  <c:v>32.880000000000003</c:v>
                </c:pt>
                <c:pt idx="123">
                  <c:v>39.75</c:v>
                </c:pt>
                <c:pt idx="124">
                  <c:v>26.44</c:v>
                </c:pt>
                <c:pt idx="125">
                  <c:v>30.61</c:v>
                </c:pt>
                <c:pt idx="126">
                  <c:v>37.65</c:v>
                </c:pt>
                <c:pt idx="127">
                  <c:v>31.01</c:v>
                </c:pt>
                <c:pt idx="128">
                  <c:v>26.22</c:v>
                </c:pt>
                <c:pt idx="129">
                  <c:v>25.35</c:v>
                </c:pt>
                <c:pt idx="130">
                  <c:v>24.35</c:v>
                </c:pt>
                <c:pt idx="131">
                  <c:v>27.75</c:v>
                </c:pt>
                <c:pt idx="132">
                  <c:v>31.94</c:v>
                </c:pt>
                <c:pt idx="133">
                  <c:v>34.4</c:v>
                </c:pt>
                <c:pt idx="134">
                  <c:v>33.200000000000003</c:v>
                </c:pt>
                <c:pt idx="135">
                  <c:v>28.4</c:v>
                </c:pt>
                <c:pt idx="136">
                  <c:v>30.93</c:v>
                </c:pt>
                <c:pt idx="137">
                  <c:v>32.42</c:v>
                </c:pt>
                <c:pt idx="138">
                  <c:v>30.52</c:v>
                </c:pt>
                <c:pt idx="139">
                  <c:v>28.29</c:v>
                </c:pt>
                <c:pt idx="140">
                  <c:v>34.090000000000003</c:v>
                </c:pt>
                <c:pt idx="141">
                  <c:v>39.840000000000003</c:v>
                </c:pt>
                <c:pt idx="142">
                  <c:v>29.55</c:v>
                </c:pt>
                <c:pt idx="143">
                  <c:v>37.39</c:v>
                </c:pt>
                <c:pt idx="144">
                  <c:v>29.02</c:v>
                </c:pt>
                <c:pt idx="145">
                  <c:v>24.06</c:v>
                </c:pt>
                <c:pt idx="146">
                  <c:v>29.78</c:v>
                </c:pt>
                <c:pt idx="147">
                  <c:v>26.16</c:v>
                </c:pt>
                <c:pt idx="148">
                  <c:v>23.61</c:v>
                </c:pt>
                <c:pt idx="149">
                  <c:v>28.56</c:v>
                </c:pt>
                <c:pt idx="150">
                  <c:v>35.86</c:v>
                </c:pt>
                <c:pt idx="151">
                  <c:v>26.17</c:v>
                </c:pt>
                <c:pt idx="152">
                  <c:v>27.62</c:v>
                </c:pt>
                <c:pt idx="153">
                  <c:v>30.88</c:v>
                </c:pt>
                <c:pt idx="154">
                  <c:v>26.41</c:v>
                </c:pt>
                <c:pt idx="155">
                  <c:v>32.67</c:v>
                </c:pt>
                <c:pt idx="156">
                  <c:v>34.29</c:v>
                </c:pt>
                <c:pt idx="157">
                  <c:v>58.19</c:v>
                </c:pt>
                <c:pt idx="158">
                  <c:v>31.4</c:v>
                </c:pt>
                <c:pt idx="159">
                  <c:v>25.83</c:v>
                </c:pt>
                <c:pt idx="160">
                  <c:v>35.65</c:v>
                </c:pt>
                <c:pt idx="161">
                  <c:v>34.74</c:v>
                </c:pt>
                <c:pt idx="162">
                  <c:v>33.74</c:v>
                </c:pt>
                <c:pt idx="163">
                  <c:v>28.88</c:v>
                </c:pt>
                <c:pt idx="164">
                  <c:v>29.9</c:v>
                </c:pt>
                <c:pt idx="165">
                  <c:v>29.5</c:v>
                </c:pt>
                <c:pt idx="166">
                  <c:v>34.57</c:v>
                </c:pt>
                <c:pt idx="167">
                  <c:v>33.130000000000003</c:v>
                </c:pt>
                <c:pt idx="168">
                  <c:v>35.22</c:v>
                </c:pt>
                <c:pt idx="169">
                  <c:v>30.82</c:v>
                </c:pt>
                <c:pt idx="170">
                  <c:v>23.29</c:v>
                </c:pt>
                <c:pt idx="171">
                  <c:v>29.24</c:v>
                </c:pt>
                <c:pt idx="172">
                  <c:v>23.4</c:v>
                </c:pt>
                <c:pt idx="173">
                  <c:v>31.88</c:v>
                </c:pt>
                <c:pt idx="174">
                  <c:v>21.97</c:v>
                </c:pt>
                <c:pt idx="175">
                  <c:v>26.15</c:v>
                </c:pt>
                <c:pt idx="176">
                  <c:v>25.44</c:v>
                </c:pt>
                <c:pt idx="177">
                  <c:v>30.22</c:v>
                </c:pt>
                <c:pt idx="178">
                  <c:v>24.43</c:v>
                </c:pt>
                <c:pt idx="179">
                  <c:v>41.75</c:v>
                </c:pt>
                <c:pt idx="180">
                  <c:v>36.67</c:v>
                </c:pt>
                <c:pt idx="181">
                  <c:v>31.06</c:v>
                </c:pt>
                <c:pt idx="182">
                  <c:v>26.91</c:v>
                </c:pt>
                <c:pt idx="183">
                  <c:v>46.64</c:v>
                </c:pt>
                <c:pt idx="184">
                  <c:v>31.54</c:v>
                </c:pt>
                <c:pt idx="185">
                  <c:v>32.03</c:v>
                </c:pt>
                <c:pt idx="186">
                  <c:v>29.47</c:v>
                </c:pt>
                <c:pt idx="187">
                  <c:v>25.22</c:v>
                </c:pt>
                <c:pt idx="188">
                  <c:v>22.08</c:v>
                </c:pt>
                <c:pt idx="189">
                  <c:v>35.33</c:v>
                </c:pt>
                <c:pt idx="190">
                  <c:v>22.13</c:v>
                </c:pt>
                <c:pt idx="191">
                  <c:v>29.4</c:v>
                </c:pt>
                <c:pt idx="192">
                  <c:v>28.49</c:v>
                </c:pt>
                <c:pt idx="193">
                  <c:v>24.96</c:v>
                </c:pt>
                <c:pt idx="194">
                  <c:v>30.28</c:v>
                </c:pt>
                <c:pt idx="195">
                  <c:v>34.54</c:v>
                </c:pt>
                <c:pt idx="196">
                  <c:v>32.47</c:v>
                </c:pt>
                <c:pt idx="197">
                  <c:v>30.72</c:v>
                </c:pt>
                <c:pt idx="198">
                  <c:v>26.1</c:v>
                </c:pt>
                <c:pt idx="199">
                  <c:v>33.18</c:v>
                </c:pt>
                <c:pt idx="200">
                  <c:v>26.39</c:v>
                </c:pt>
                <c:pt idx="201">
                  <c:v>21.4</c:v>
                </c:pt>
                <c:pt idx="202">
                  <c:v>30.53</c:v>
                </c:pt>
                <c:pt idx="203">
                  <c:v>29.94</c:v>
                </c:pt>
                <c:pt idx="204">
                  <c:v>28.05</c:v>
                </c:pt>
                <c:pt idx="205">
                  <c:v>23.43</c:v>
                </c:pt>
                <c:pt idx="206">
                  <c:v>34.76</c:v>
                </c:pt>
                <c:pt idx="207">
                  <c:v>29.61</c:v>
                </c:pt>
                <c:pt idx="208">
                  <c:v>26.13</c:v>
                </c:pt>
                <c:pt idx="209">
                  <c:v>37.270000000000003</c:v>
                </c:pt>
                <c:pt idx="210">
                  <c:v>29.66</c:v>
                </c:pt>
                <c:pt idx="211">
                  <c:v>29.61</c:v>
                </c:pt>
                <c:pt idx="212">
                  <c:v>38.56</c:v>
                </c:pt>
                <c:pt idx="213">
                  <c:v>29.2</c:v>
                </c:pt>
                <c:pt idx="214">
                  <c:v>28.31</c:v>
                </c:pt>
                <c:pt idx="215">
                  <c:v>32.840000000000003</c:v>
                </c:pt>
                <c:pt idx="216">
                  <c:v>34.65</c:v>
                </c:pt>
                <c:pt idx="217">
                  <c:v>32.25</c:v>
                </c:pt>
                <c:pt idx="218">
                  <c:v>31.43</c:v>
                </c:pt>
                <c:pt idx="219">
                  <c:v>26.57</c:v>
                </c:pt>
                <c:pt idx="220">
                  <c:v>55.39</c:v>
                </c:pt>
                <c:pt idx="221">
                  <c:v>33.17</c:v>
                </c:pt>
                <c:pt idx="222">
                  <c:v>28.28</c:v>
                </c:pt>
                <c:pt idx="223">
                  <c:v>32.78</c:v>
                </c:pt>
                <c:pt idx="224">
                  <c:v>37.06</c:v>
                </c:pt>
                <c:pt idx="225">
                  <c:v>29.11</c:v>
                </c:pt>
                <c:pt idx="226">
                  <c:v>26.72</c:v>
                </c:pt>
                <c:pt idx="227">
                  <c:v>29.1</c:v>
                </c:pt>
                <c:pt idx="228">
                  <c:v>26.47</c:v>
                </c:pt>
                <c:pt idx="229">
                  <c:v>33.229999999999997</c:v>
                </c:pt>
                <c:pt idx="230">
                  <c:v>25.5</c:v>
                </c:pt>
                <c:pt idx="231">
                  <c:v>26.72</c:v>
                </c:pt>
                <c:pt idx="232">
                  <c:v>28.23</c:v>
                </c:pt>
                <c:pt idx="233">
                  <c:v>26.84</c:v>
                </c:pt>
                <c:pt idx="234">
                  <c:v>30.36</c:v>
                </c:pt>
                <c:pt idx="235">
                  <c:v>30.01</c:v>
                </c:pt>
                <c:pt idx="236">
                  <c:v>30.64</c:v>
                </c:pt>
                <c:pt idx="237">
                  <c:v>33.979999999999997</c:v>
                </c:pt>
                <c:pt idx="238">
                  <c:v>33.6</c:v>
                </c:pt>
                <c:pt idx="239">
                  <c:v>25.39</c:v>
                </c:pt>
                <c:pt idx="240">
                  <c:v>25.9</c:v>
                </c:pt>
                <c:pt idx="241">
                  <c:v>33.15</c:v>
                </c:pt>
                <c:pt idx="242">
                  <c:v>21.36</c:v>
                </c:pt>
                <c:pt idx="243">
                  <c:v>34.83</c:v>
                </c:pt>
                <c:pt idx="244">
                  <c:v>35.729999999999997</c:v>
                </c:pt>
                <c:pt idx="245">
                  <c:v>37.86</c:v>
                </c:pt>
                <c:pt idx="246">
                  <c:v>26.1</c:v>
                </c:pt>
                <c:pt idx="247">
                  <c:v>29.25</c:v>
                </c:pt>
                <c:pt idx="248">
                  <c:v>31.78</c:v>
                </c:pt>
                <c:pt idx="249">
                  <c:v>27.06</c:v>
                </c:pt>
                <c:pt idx="250">
                  <c:v>36.5</c:v>
                </c:pt>
                <c:pt idx="251">
                  <c:v>31.1</c:v>
                </c:pt>
                <c:pt idx="252">
                  <c:v>21.98</c:v>
                </c:pt>
                <c:pt idx="253">
                  <c:v>30.67</c:v>
                </c:pt>
                <c:pt idx="254">
                  <c:v>30.51</c:v>
                </c:pt>
                <c:pt idx="255">
                  <c:v>30.06</c:v>
                </c:pt>
                <c:pt idx="257">
                  <c:v>31.95</c:v>
                </c:pt>
                <c:pt idx="258">
                  <c:v>32.54</c:v>
                </c:pt>
                <c:pt idx="259">
                  <c:v>29.46</c:v>
                </c:pt>
                <c:pt idx="260">
                  <c:v>35.06</c:v>
                </c:pt>
                <c:pt idx="261">
                  <c:v>29.38</c:v>
                </c:pt>
                <c:pt idx="262">
                  <c:v>42.14</c:v>
                </c:pt>
                <c:pt idx="263">
                  <c:v>34.07</c:v>
                </c:pt>
                <c:pt idx="264">
                  <c:v>32.950000000000003</c:v>
                </c:pt>
                <c:pt idx="265">
                  <c:v>38.14</c:v>
                </c:pt>
                <c:pt idx="266">
                  <c:v>25.25</c:v>
                </c:pt>
                <c:pt idx="267">
                  <c:v>39.450000000000003</c:v>
                </c:pt>
                <c:pt idx="268">
                  <c:v>33.409999999999997</c:v>
                </c:pt>
                <c:pt idx="269">
                  <c:v>34.53</c:v>
                </c:pt>
                <c:pt idx="270">
                  <c:v>24.66</c:v>
                </c:pt>
                <c:pt idx="271">
                  <c:v>24.34</c:v>
                </c:pt>
                <c:pt idx="272">
                  <c:v>31.44</c:v>
                </c:pt>
                <c:pt idx="273">
                  <c:v>35.17</c:v>
                </c:pt>
                <c:pt idx="274">
                  <c:v>21.46</c:v>
                </c:pt>
                <c:pt idx="275">
                  <c:v>51.27</c:v>
                </c:pt>
                <c:pt idx="276">
                  <c:v>41.45</c:v>
                </c:pt>
                <c:pt idx="277">
                  <c:v>34.1</c:v>
                </c:pt>
                <c:pt idx="278">
                  <c:v>46.4</c:v>
                </c:pt>
                <c:pt idx="279">
                  <c:v>35.06</c:v>
                </c:pt>
                <c:pt idx="280">
                  <c:v>39.25</c:v>
                </c:pt>
                <c:pt idx="281">
                  <c:v>32.44</c:v>
                </c:pt>
                <c:pt idx="282">
                  <c:v>27.77</c:v>
                </c:pt>
                <c:pt idx="283">
                  <c:v>31.83</c:v>
                </c:pt>
                <c:pt idx="284">
                  <c:v>23.05</c:v>
                </c:pt>
                <c:pt idx="285">
                  <c:v>44.93</c:v>
                </c:pt>
                <c:pt idx="286">
                  <c:v>28.23</c:v>
                </c:pt>
                <c:pt idx="287">
                  <c:v>27.77</c:v>
                </c:pt>
                <c:pt idx="288">
                  <c:v>29.07</c:v>
                </c:pt>
                <c:pt idx="289">
                  <c:v>27.21</c:v>
                </c:pt>
                <c:pt idx="290">
                  <c:v>22.68</c:v>
                </c:pt>
                <c:pt idx="291">
                  <c:v>26.31</c:v>
                </c:pt>
                <c:pt idx="292">
                  <c:v>26.34</c:v>
                </c:pt>
                <c:pt idx="293">
                  <c:v>31.03</c:v>
                </c:pt>
                <c:pt idx="294">
                  <c:v>41.78</c:v>
                </c:pt>
                <c:pt idx="295">
                  <c:v>27.31</c:v>
                </c:pt>
                <c:pt idx="296">
                  <c:v>37.049999999999997</c:v>
                </c:pt>
                <c:pt idx="297">
                  <c:v>26.47</c:v>
                </c:pt>
                <c:pt idx="298">
                  <c:v>37.92</c:v>
                </c:pt>
                <c:pt idx="299">
                  <c:v>36.69</c:v>
                </c:pt>
                <c:pt idx="300">
                  <c:v>31.96</c:v>
                </c:pt>
                <c:pt idx="301">
                  <c:v>34.08</c:v>
                </c:pt>
                <c:pt idx="302">
                  <c:v>32.71</c:v>
                </c:pt>
                <c:pt idx="303">
                  <c:v>26.19</c:v>
                </c:pt>
                <c:pt idx="304">
                  <c:v>30.89</c:v>
                </c:pt>
                <c:pt idx="305">
                  <c:v>29</c:v>
                </c:pt>
                <c:pt idx="306">
                  <c:v>42.91</c:v>
                </c:pt>
                <c:pt idx="307">
                  <c:v>37.1</c:v>
                </c:pt>
                <c:pt idx="308">
                  <c:v>27.01</c:v>
                </c:pt>
                <c:pt idx="309">
                  <c:v>30.32</c:v>
                </c:pt>
                <c:pt idx="310">
                  <c:v>32.450000000000003</c:v>
                </c:pt>
                <c:pt idx="311">
                  <c:v>31.17</c:v>
                </c:pt>
                <c:pt idx="312">
                  <c:v>34.909999999999997</c:v>
                </c:pt>
                <c:pt idx="313">
                  <c:v>30.41</c:v>
                </c:pt>
                <c:pt idx="314">
                  <c:v>23.49</c:v>
                </c:pt>
                <c:pt idx="315">
                  <c:v>34.1</c:v>
                </c:pt>
                <c:pt idx="316">
                  <c:v>37.869999999999997</c:v>
                </c:pt>
                <c:pt idx="317">
                  <c:v>28.16</c:v>
                </c:pt>
                <c:pt idx="318">
                  <c:v>34.22</c:v>
                </c:pt>
                <c:pt idx="319">
                  <c:v>27.96</c:v>
                </c:pt>
                <c:pt idx="320">
                  <c:v>34.04</c:v>
                </c:pt>
                <c:pt idx="321">
                  <c:v>26.77</c:v>
                </c:pt>
                <c:pt idx="322">
                  <c:v>30.1</c:v>
                </c:pt>
                <c:pt idx="323">
                  <c:v>31.63</c:v>
                </c:pt>
                <c:pt idx="324">
                  <c:v>31.43</c:v>
                </c:pt>
                <c:pt idx="325">
                  <c:v>29.94</c:v>
                </c:pt>
                <c:pt idx="326">
                  <c:v>25.36</c:v>
                </c:pt>
                <c:pt idx="327">
                  <c:v>24.24</c:v>
                </c:pt>
                <c:pt idx="328">
                  <c:v>35.590000000000003</c:v>
                </c:pt>
                <c:pt idx="329">
                  <c:v>30.78</c:v>
                </c:pt>
                <c:pt idx="330">
                  <c:v>31.14</c:v>
                </c:pt>
                <c:pt idx="331">
                  <c:v>26.68</c:v>
                </c:pt>
                <c:pt idx="332">
                  <c:v>28.08</c:v>
                </c:pt>
                <c:pt idx="333">
                  <c:v>28.58</c:v>
                </c:pt>
                <c:pt idx="334">
                  <c:v>30.18</c:v>
                </c:pt>
                <c:pt idx="335">
                  <c:v>37.01</c:v>
                </c:pt>
                <c:pt idx="336">
                  <c:v>29.13</c:v>
                </c:pt>
                <c:pt idx="337">
                  <c:v>30.2</c:v>
                </c:pt>
                <c:pt idx="338">
                  <c:v>27.26</c:v>
                </c:pt>
                <c:pt idx="339">
                  <c:v>31.44</c:v>
                </c:pt>
                <c:pt idx="340">
                  <c:v>31.64</c:v>
                </c:pt>
                <c:pt idx="341">
                  <c:v>33.74</c:v>
                </c:pt>
                <c:pt idx="342">
                  <c:v>28.33</c:v>
                </c:pt>
                <c:pt idx="343">
                  <c:v>37.46</c:v>
                </c:pt>
                <c:pt idx="344">
                  <c:v>34.82</c:v>
                </c:pt>
                <c:pt idx="345">
                  <c:v>28.99</c:v>
                </c:pt>
                <c:pt idx="346">
                  <c:v>28.64</c:v>
                </c:pt>
                <c:pt idx="347">
                  <c:v>25.69</c:v>
                </c:pt>
                <c:pt idx="348">
                  <c:v>34.57</c:v>
                </c:pt>
                <c:pt idx="349">
                  <c:v>37.340000000000003</c:v>
                </c:pt>
                <c:pt idx="350">
                  <c:v>27.17</c:v>
                </c:pt>
                <c:pt idx="351">
                  <c:v>31.41</c:v>
                </c:pt>
                <c:pt idx="352">
                  <c:v>28.5</c:v>
                </c:pt>
                <c:pt idx="353">
                  <c:v>39.85</c:v>
                </c:pt>
                <c:pt idx="354">
                  <c:v>28.36</c:v>
                </c:pt>
                <c:pt idx="355">
                  <c:v>25.45</c:v>
                </c:pt>
                <c:pt idx="356">
                  <c:v>28.53</c:v>
                </c:pt>
                <c:pt idx="357">
                  <c:v>23.56</c:v>
                </c:pt>
                <c:pt idx="358">
                  <c:v>32.700000000000003</c:v>
                </c:pt>
                <c:pt idx="359">
                  <c:v>27.01</c:v>
                </c:pt>
                <c:pt idx="360">
                  <c:v>36.19</c:v>
                </c:pt>
                <c:pt idx="361">
                  <c:v>43.89</c:v>
                </c:pt>
                <c:pt idx="362">
                  <c:v>30.59</c:v>
                </c:pt>
                <c:pt idx="363">
                  <c:v>35.700000000000003</c:v>
                </c:pt>
                <c:pt idx="364">
                  <c:v>33.020000000000003</c:v>
                </c:pt>
                <c:pt idx="365">
                  <c:v>43.62</c:v>
                </c:pt>
                <c:pt idx="366">
                  <c:v>31.35</c:v>
                </c:pt>
                <c:pt idx="367">
                  <c:v>22.93</c:v>
                </c:pt>
                <c:pt idx="368">
                  <c:v>33.72</c:v>
                </c:pt>
                <c:pt idx="369">
                  <c:v>30.1</c:v>
                </c:pt>
                <c:pt idx="370">
                  <c:v>27.58</c:v>
                </c:pt>
                <c:pt idx="371">
                  <c:v>45.7</c:v>
                </c:pt>
                <c:pt idx="372">
                  <c:v>59.38</c:v>
                </c:pt>
                <c:pt idx="373">
                  <c:v>40.21</c:v>
                </c:pt>
                <c:pt idx="374">
                  <c:v>41.66</c:v>
                </c:pt>
                <c:pt idx="375">
                  <c:v>25.29</c:v>
                </c:pt>
                <c:pt idx="376">
                  <c:v>38.200000000000003</c:v>
                </c:pt>
                <c:pt idx="377">
                  <c:v>21.27</c:v>
                </c:pt>
                <c:pt idx="378">
                  <c:v>20.329999999999998</c:v>
                </c:pt>
                <c:pt idx="379">
                  <c:v>33.799999999999997</c:v>
                </c:pt>
                <c:pt idx="380">
                  <c:v>41.81</c:v>
                </c:pt>
                <c:pt idx="381">
                  <c:v>29.41</c:v>
                </c:pt>
                <c:pt idx="382">
                  <c:v>28.95</c:v>
                </c:pt>
                <c:pt idx="383">
                  <c:v>29.41</c:v>
                </c:pt>
                <c:pt idx="384">
                  <c:v>35.619999999999997</c:v>
                </c:pt>
                <c:pt idx="385">
                  <c:v>43.5</c:v>
                </c:pt>
                <c:pt idx="386">
                  <c:v>27.83</c:v>
                </c:pt>
                <c:pt idx="387">
                  <c:v>17.59</c:v>
                </c:pt>
                <c:pt idx="388">
                  <c:v>29.24</c:v>
                </c:pt>
                <c:pt idx="389">
                  <c:v>29.81</c:v>
                </c:pt>
                <c:pt idx="390">
                  <c:v>27.12</c:v>
                </c:pt>
                <c:pt idx="391">
                  <c:v>30.92</c:v>
                </c:pt>
                <c:pt idx="392">
                  <c:v>21.61</c:v>
                </c:pt>
                <c:pt idx="393">
                  <c:v>22.92</c:v>
                </c:pt>
                <c:pt idx="394">
                  <c:v>28.05</c:v>
                </c:pt>
                <c:pt idx="395">
                  <c:v>25.7</c:v>
                </c:pt>
                <c:pt idx="396">
                  <c:v>27.24</c:v>
                </c:pt>
                <c:pt idx="397">
                  <c:v>34.53</c:v>
                </c:pt>
                <c:pt idx="398">
                  <c:v>32.46</c:v>
                </c:pt>
                <c:pt idx="399">
                  <c:v>32.78</c:v>
                </c:pt>
                <c:pt idx="400">
                  <c:v>28.12</c:v>
                </c:pt>
                <c:pt idx="401">
                  <c:v>26.93</c:v>
                </c:pt>
                <c:pt idx="402">
                  <c:v>34.19</c:v>
                </c:pt>
                <c:pt idx="403">
                  <c:v>31.94</c:v>
                </c:pt>
                <c:pt idx="404">
                  <c:v>32.33</c:v>
                </c:pt>
                <c:pt idx="405">
                  <c:v>28.65</c:v>
                </c:pt>
                <c:pt idx="406">
                  <c:v>27.55</c:v>
                </c:pt>
                <c:pt idx="407">
                  <c:v>21.73</c:v>
                </c:pt>
                <c:pt idx="408">
                  <c:v>35.380000000000003</c:v>
                </c:pt>
                <c:pt idx="409">
                  <c:v>27.7</c:v>
                </c:pt>
                <c:pt idx="410">
                  <c:v>22.51</c:v>
                </c:pt>
                <c:pt idx="411">
                  <c:v>27.24</c:v>
                </c:pt>
                <c:pt idx="412">
                  <c:v>38.119999999999997</c:v>
                </c:pt>
                <c:pt idx="413">
                  <c:v>33.31</c:v>
                </c:pt>
                <c:pt idx="414">
                  <c:v>26.18</c:v>
                </c:pt>
                <c:pt idx="415">
                  <c:v>34.17</c:v>
                </c:pt>
                <c:pt idx="416">
                  <c:v>32.32</c:v>
                </c:pt>
                <c:pt idx="417">
                  <c:v>33.57</c:v>
                </c:pt>
                <c:pt idx="418">
                  <c:v>25.57</c:v>
                </c:pt>
                <c:pt idx="419">
                  <c:v>34.49</c:v>
                </c:pt>
                <c:pt idx="420">
                  <c:v>34.42</c:v>
                </c:pt>
                <c:pt idx="421">
                  <c:v>51.73</c:v>
                </c:pt>
                <c:pt idx="422">
                  <c:v>33.200000000000003</c:v>
                </c:pt>
                <c:pt idx="423">
                  <c:v>32.42</c:v>
                </c:pt>
                <c:pt idx="424">
                  <c:v>31.23</c:v>
                </c:pt>
                <c:pt idx="425">
                  <c:v>34.380000000000003</c:v>
                </c:pt>
                <c:pt idx="426">
                  <c:v>26.49</c:v>
                </c:pt>
                <c:pt idx="427">
                  <c:v>27.78</c:v>
                </c:pt>
                <c:pt idx="428">
                  <c:v>25.18</c:v>
                </c:pt>
                <c:pt idx="429">
                  <c:v>26.28</c:v>
                </c:pt>
                <c:pt idx="430">
                  <c:v>30.12</c:v>
                </c:pt>
                <c:pt idx="431">
                  <c:v>34.06</c:v>
                </c:pt>
                <c:pt idx="432">
                  <c:v>24</c:v>
                </c:pt>
                <c:pt idx="433">
                  <c:v>30.16</c:v>
                </c:pt>
                <c:pt idx="434">
                  <c:v>28.38</c:v>
                </c:pt>
                <c:pt idx="435">
                  <c:v>49.07</c:v>
                </c:pt>
                <c:pt idx="436">
                  <c:v>24.24</c:v>
                </c:pt>
                <c:pt idx="437">
                  <c:v>26.71</c:v>
                </c:pt>
                <c:pt idx="438">
                  <c:v>30.62</c:v>
                </c:pt>
                <c:pt idx="439">
                  <c:v>38.229999999999997</c:v>
                </c:pt>
                <c:pt idx="440">
                  <c:v>31.17</c:v>
                </c:pt>
                <c:pt idx="441">
                  <c:v>31.93</c:v>
                </c:pt>
                <c:pt idx="442">
                  <c:v>33.450000000000003</c:v>
                </c:pt>
                <c:pt idx="443">
                  <c:v>30.29</c:v>
                </c:pt>
                <c:pt idx="444">
                  <c:v>36.69</c:v>
                </c:pt>
                <c:pt idx="445">
                  <c:v>46.76</c:v>
                </c:pt>
                <c:pt idx="446">
                  <c:v>29.07</c:v>
                </c:pt>
                <c:pt idx="447">
                  <c:v>43.71</c:v>
                </c:pt>
                <c:pt idx="448">
                  <c:v>35.28</c:v>
                </c:pt>
                <c:pt idx="449">
                  <c:v>28.41</c:v>
                </c:pt>
                <c:pt idx="450">
                  <c:v>36.89</c:v>
                </c:pt>
                <c:pt idx="451">
                  <c:v>31.49</c:v>
                </c:pt>
                <c:pt idx="452">
                  <c:v>39.71</c:v>
                </c:pt>
                <c:pt idx="453">
                  <c:v>30.59</c:v>
                </c:pt>
                <c:pt idx="454">
                  <c:v>34.200000000000003</c:v>
                </c:pt>
                <c:pt idx="455">
                  <c:v>29.22</c:v>
                </c:pt>
                <c:pt idx="456">
                  <c:v>25.04</c:v>
                </c:pt>
                <c:pt idx="457">
                  <c:v>26.82</c:v>
                </c:pt>
                <c:pt idx="458">
                  <c:v>34.090000000000003</c:v>
                </c:pt>
                <c:pt idx="459">
                  <c:v>33.409999999999997</c:v>
                </c:pt>
                <c:pt idx="460">
                  <c:v>36.31</c:v>
                </c:pt>
              </c:numCache>
            </c:numRef>
          </c:xVal>
          <c:yVal>
            <c:numRef>
              <c:f>'[SJ database FTO methylation analysis2.xlsx]age,lym'!$K$470:$K$930</c:f>
              <c:numCache>
                <c:formatCode>0.0</c:formatCode>
                <c:ptCount val="461"/>
                <c:pt idx="0">
                  <c:v>34.173103584868294</c:v>
                </c:pt>
                <c:pt idx="1">
                  <c:v>45.332976731746456</c:v>
                </c:pt>
                <c:pt idx="2">
                  <c:v>38.977676306443421</c:v>
                </c:pt>
                <c:pt idx="3">
                  <c:v>18.998057865644142</c:v>
                </c:pt>
                <c:pt idx="4">
                  <c:v>40.234308676212578</c:v>
                </c:pt>
                <c:pt idx="5">
                  <c:v>43.141153081510943</c:v>
                </c:pt>
                <c:pt idx="6">
                  <c:v>14.32406822488945</c:v>
                </c:pt>
                <c:pt idx="7">
                  <c:v>50.242846094354213</c:v>
                </c:pt>
                <c:pt idx="8">
                  <c:v>30.768032403801215</c:v>
                </c:pt>
                <c:pt idx="9">
                  <c:v>29.304623904373607</c:v>
                </c:pt>
                <c:pt idx="10">
                  <c:v>40.359616085530313</c:v>
                </c:pt>
                <c:pt idx="11">
                  <c:v>38.05967348470633</c:v>
                </c:pt>
                <c:pt idx="12">
                  <c:v>52.442501425584489</c:v>
                </c:pt>
                <c:pt idx="13">
                  <c:v>31.844802342606151</c:v>
                </c:pt>
                <c:pt idx="14">
                  <c:v>24.874256973022405</c:v>
                </c:pt>
                <c:pt idx="15">
                  <c:v>35.68651705248277</c:v>
                </c:pt>
                <c:pt idx="16">
                  <c:v>35.428530682649416</c:v>
                </c:pt>
                <c:pt idx="17">
                  <c:v>44.386202207099899</c:v>
                </c:pt>
                <c:pt idx="18">
                  <c:v>25.758172508861755</c:v>
                </c:pt>
                <c:pt idx="19">
                  <c:v>34.285949370560324</c:v>
                </c:pt>
                <c:pt idx="20">
                  <c:v>28.934974171984198</c:v>
                </c:pt>
                <c:pt idx="21">
                  <c:v>34.677019659672887</c:v>
                </c:pt>
                <c:pt idx="22">
                  <c:v>20.819606267577342</c:v>
                </c:pt>
                <c:pt idx="23">
                  <c:v>31.544610860975833</c:v>
                </c:pt>
                <c:pt idx="24">
                  <c:v>31.87917154063167</c:v>
                </c:pt>
                <c:pt idx="25">
                  <c:v>46.92458161269289</c:v>
                </c:pt>
                <c:pt idx="26">
                  <c:v>44.491488810161584</c:v>
                </c:pt>
                <c:pt idx="27">
                  <c:v>29.792088158064651</c:v>
                </c:pt>
                <c:pt idx="28">
                  <c:v>21.914281387248224</c:v>
                </c:pt>
                <c:pt idx="29">
                  <c:v>53.20916521506097</c:v>
                </c:pt>
                <c:pt idx="30">
                  <c:v>40.074331518400783</c:v>
                </c:pt>
                <c:pt idx="31">
                  <c:v>37.417872285335136</c:v>
                </c:pt>
                <c:pt idx="32">
                  <c:v>38.769912438020889</c:v>
                </c:pt>
                <c:pt idx="33">
                  <c:v>40.68627450980393</c:v>
                </c:pt>
                <c:pt idx="34">
                  <c:v>30.827360928282388</c:v>
                </c:pt>
                <c:pt idx="35">
                  <c:v>31.511496419148134</c:v>
                </c:pt>
                <c:pt idx="36">
                  <c:v>32.221006564551423</c:v>
                </c:pt>
                <c:pt idx="37">
                  <c:v>19.552906110283157</c:v>
                </c:pt>
                <c:pt idx="38">
                  <c:v>30.844628225744696</c:v>
                </c:pt>
                <c:pt idx="39">
                  <c:v>37.865087621029048</c:v>
                </c:pt>
                <c:pt idx="40">
                  <c:v>35.721469278291266</c:v>
                </c:pt>
                <c:pt idx="41">
                  <c:v>39.808661359818892</c:v>
                </c:pt>
                <c:pt idx="42">
                  <c:v>32.196927217674101</c:v>
                </c:pt>
                <c:pt idx="43">
                  <c:v>36.677602568172993</c:v>
                </c:pt>
                <c:pt idx="44">
                  <c:v>37.946458827516096</c:v>
                </c:pt>
                <c:pt idx="45">
                  <c:v>32.276243480695861</c:v>
                </c:pt>
                <c:pt idx="46">
                  <c:v>38.065996356029423</c:v>
                </c:pt>
                <c:pt idx="47">
                  <c:v>20.578043205780435</c:v>
                </c:pt>
                <c:pt idx="48">
                  <c:v>39.27654609101517</c:v>
                </c:pt>
                <c:pt idx="49">
                  <c:v>55.945263717284448</c:v>
                </c:pt>
                <c:pt idx="50">
                  <c:v>40.036563071297991</c:v>
                </c:pt>
                <c:pt idx="51">
                  <c:v>40.160732224578638</c:v>
                </c:pt>
                <c:pt idx="52">
                  <c:v>21.904018728053057</c:v>
                </c:pt>
                <c:pt idx="53">
                  <c:v>30.585361837591591</c:v>
                </c:pt>
                <c:pt idx="54">
                  <c:v>29.097472924187723</c:v>
                </c:pt>
                <c:pt idx="55">
                  <c:v>30.796711085908701</c:v>
                </c:pt>
                <c:pt idx="56">
                  <c:v>24.380105017502917</c:v>
                </c:pt>
                <c:pt idx="57">
                  <c:v>40.085703155434359</c:v>
                </c:pt>
                <c:pt idx="58">
                  <c:v>26.973244147157192</c:v>
                </c:pt>
                <c:pt idx="59">
                  <c:v>41.182693324870414</c:v>
                </c:pt>
                <c:pt idx="60">
                  <c:v>29.562127226251583</c:v>
                </c:pt>
                <c:pt idx="61">
                  <c:v>30.013279411768483</c:v>
                </c:pt>
                <c:pt idx="62">
                  <c:v>26.013234077750205</c:v>
                </c:pt>
                <c:pt idx="63">
                  <c:v>29.443034916032374</c:v>
                </c:pt>
                <c:pt idx="64">
                  <c:v>28.412562629842359</c:v>
                </c:pt>
                <c:pt idx="65">
                  <c:v>30.904651030722931</c:v>
                </c:pt>
                <c:pt idx="66">
                  <c:v>27.667625638234451</c:v>
                </c:pt>
                <c:pt idx="67">
                  <c:v>27.60555398129782</c:v>
                </c:pt>
                <c:pt idx="68">
                  <c:v>38.466693472724842</c:v>
                </c:pt>
                <c:pt idx="69">
                  <c:v>35.099241983856366</c:v>
                </c:pt>
                <c:pt idx="70">
                  <c:v>27.356441664494834</c:v>
                </c:pt>
                <c:pt idx="71">
                  <c:v>37.498906099588687</c:v>
                </c:pt>
                <c:pt idx="72">
                  <c:v>32.44661876369566</c:v>
                </c:pt>
                <c:pt idx="73">
                  <c:v>38.496743531068468</c:v>
                </c:pt>
                <c:pt idx="74">
                  <c:v>37.535145267104028</c:v>
                </c:pt>
                <c:pt idx="75">
                  <c:v>23.908452713886192</c:v>
                </c:pt>
                <c:pt idx="76">
                  <c:v>50.95621784292787</c:v>
                </c:pt>
                <c:pt idx="77">
                  <c:v>26.970286971980023</c:v>
                </c:pt>
                <c:pt idx="78">
                  <c:v>40.218813176358651</c:v>
                </c:pt>
                <c:pt idx="79">
                  <c:v>31.844888366627497</c:v>
                </c:pt>
                <c:pt idx="80">
                  <c:v>32.398972202756362</c:v>
                </c:pt>
                <c:pt idx="81">
                  <c:v>34.572636001661088</c:v>
                </c:pt>
                <c:pt idx="82">
                  <c:v>25.551367391130004</c:v>
                </c:pt>
                <c:pt idx="83">
                  <c:v>17.429165009061578</c:v>
                </c:pt>
                <c:pt idx="84">
                  <c:v>33.062377636241976</c:v>
                </c:pt>
                <c:pt idx="85">
                  <c:v>25.591068301225921</c:v>
                </c:pt>
                <c:pt idx="86">
                  <c:v>20.326489818015244</c:v>
                </c:pt>
                <c:pt idx="87">
                  <c:v>29.092103102938765</c:v>
                </c:pt>
                <c:pt idx="88">
                  <c:v>33.910698231944863</c:v>
                </c:pt>
                <c:pt idx="89">
                  <c:v>24.831727412372576</c:v>
                </c:pt>
                <c:pt idx="90">
                  <c:v>37.661843107387661</c:v>
                </c:pt>
                <c:pt idx="91">
                  <c:v>23.094688221709006</c:v>
                </c:pt>
                <c:pt idx="92">
                  <c:v>16.179598078807139</c:v>
                </c:pt>
                <c:pt idx="93">
                  <c:v>14.156998998881102</c:v>
                </c:pt>
                <c:pt idx="94">
                  <c:v>31.47539022785719</c:v>
                </c:pt>
                <c:pt idx="95">
                  <c:v>26.01998129829224</c:v>
                </c:pt>
                <c:pt idx="96">
                  <c:v>25.165489112265142</c:v>
                </c:pt>
                <c:pt idx="97">
                  <c:v>23.159960745829245</c:v>
                </c:pt>
                <c:pt idx="98">
                  <c:v>30.776092774308655</c:v>
                </c:pt>
                <c:pt idx="99">
                  <c:v>26.810592364139104</c:v>
                </c:pt>
                <c:pt idx="100">
                  <c:v>27.347686669720566</c:v>
                </c:pt>
                <c:pt idx="101">
                  <c:v>17.408269872238659</c:v>
                </c:pt>
                <c:pt idx="102">
                  <c:v>28.98205785426584</c:v>
                </c:pt>
                <c:pt idx="103">
                  <c:v>31.376404494382026</c:v>
                </c:pt>
                <c:pt idx="104">
                  <c:v>30.34027211242401</c:v>
                </c:pt>
                <c:pt idx="105">
                  <c:v>21.073266356285227</c:v>
                </c:pt>
                <c:pt idx="106">
                  <c:v>22.667413841412163</c:v>
                </c:pt>
                <c:pt idx="107">
                  <c:v>33.498969181159808</c:v>
                </c:pt>
                <c:pt idx="108">
                  <c:v>32.837513340448233</c:v>
                </c:pt>
                <c:pt idx="109">
                  <c:v>32.208480565371026</c:v>
                </c:pt>
                <c:pt idx="110">
                  <c:v>21.948763843830406</c:v>
                </c:pt>
                <c:pt idx="111">
                  <c:v>16.532782495600951</c:v>
                </c:pt>
                <c:pt idx="112">
                  <c:v>27.127134189360795</c:v>
                </c:pt>
                <c:pt idx="113">
                  <c:v>26.753683250293264</c:v>
                </c:pt>
                <c:pt idx="114">
                  <c:v>28.171433878157504</c:v>
                </c:pt>
                <c:pt idx="115">
                  <c:v>30.915714522271902</c:v>
                </c:pt>
                <c:pt idx="116">
                  <c:v>30.904246738473077</c:v>
                </c:pt>
                <c:pt idx="117">
                  <c:v>25.388525450749945</c:v>
                </c:pt>
                <c:pt idx="118">
                  <c:v>21.829394883067714</c:v>
                </c:pt>
                <c:pt idx="119">
                  <c:v>28.419920824984118</c:v>
                </c:pt>
                <c:pt idx="120">
                  <c:v>21.998833604469134</c:v>
                </c:pt>
                <c:pt idx="121">
                  <c:v>24.688338330440271</c:v>
                </c:pt>
                <c:pt idx="122">
                  <c:v>26.274263684045369</c:v>
                </c:pt>
                <c:pt idx="123">
                  <c:v>22.223631367575567</c:v>
                </c:pt>
                <c:pt idx="124">
                  <c:v>25.986984815618225</c:v>
                </c:pt>
                <c:pt idx="125">
                  <c:v>30.435593694618042</c:v>
                </c:pt>
                <c:pt idx="126">
                  <c:v>21.602929210740438</c:v>
                </c:pt>
                <c:pt idx="127">
                  <c:v>40.981436540704095</c:v>
                </c:pt>
                <c:pt idx="128">
                  <c:v>32.497766906781123</c:v>
                </c:pt>
                <c:pt idx="129">
                  <c:v>27.759336099585063</c:v>
                </c:pt>
                <c:pt idx="130">
                  <c:v>18.293401413982721</c:v>
                </c:pt>
                <c:pt idx="131">
                  <c:v>16.356589147286826</c:v>
                </c:pt>
                <c:pt idx="132">
                  <c:v>22.432418977448101</c:v>
                </c:pt>
                <c:pt idx="133">
                  <c:v>21.455915040750806</c:v>
                </c:pt>
                <c:pt idx="134">
                  <c:v>19.261309496801125</c:v>
                </c:pt>
                <c:pt idx="135">
                  <c:v>24.341782737837761</c:v>
                </c:pt>
                <c:pt idx="136">
                  <c:v>23.934839278806315</c:v>
                </c:pt>
                <c:pt idx="137">
                  <c:v>22.623974442750306</c:v>
                </c:pt>
                <c:pt idx="138">
                  <c:v>43.120518948446573</c:v>
                </c:pt>
                <c:pt idx="139">
                  <c:v>24.448485806910732</c:v>
                </c:pt>
                <c:pt idx="140">
                  <c:v>23.829595062471778</c:v>
                </c:pt>
                <c:pt idx="141">
                  <c:v>18.019754276078054</c:v>
                </c:pt>
                <c:pt idx="142">
                  <c:v>18.080079582193484</c:v>
                </c:pt>
                <c:pt idx="143">
                  <c:v>21.596500820120287</c:v>
                </c:pt>
                <c:pt idx="144">
                  <c:v>14.977417640807648</c:v>
                </c:pt>
                <c:pt idx="145">
                  <c:v>21.360888513988474</c:v>
                </c:pt>
                <c:pt idx="146">
                  <c:v>42.876743654241935</c:v>
                </c:pt>
                <c:pt idx="147">
                  <c:v>28.093191585614115</c:v>
                </c:pt>
                <c:pt idx="148">
                  <c:v>22.659603616768653</c:v>
                </c:pt>
                <c:pt idx="149">
                  <c:v>26.543566344987457</c:v>
                </c:pt>
                <c:pt idx="150">
                  <c:v>21.081864283989376</c:v>
                </c:pt>
                <c:pt idx="151">
                  <c:v>25.134776478394294</c:v>
                </c:pt>
                <c:pt idx="152">
                  <c:v>27.690711822591048</c:v>
                </c:pt>
                <c:pt idx="153">
                  <c:v>25.445176439893025</c:v>
                </c:pt>
                <c:pt idx="154">
                  <c:v>11.35270979020979</c:v>
                </c:pt>
                <c:pt idx="155">
                  <c:v>18.480667688639073</c:v>
                </c:pt>
                <c:pt idx="156">
                  <c:v>24.211377729846319</c:v>
                </c:pt>
                <c:pt idx="157">
                  <c:v>22.81128569015036</c:v>
                </c:pt>
                <c:pt idx="158">
                  <c:v>14.057273394794811</c:v>
                </c:pt>
                <c:pt idx="159">
                  <c:v>18.715277777777779</c:v>
                </c:pt>
                <c:pt idx="160">
                  <c:v>20.7926664869237</c:v>
                </c:pt>
                <c:pt idx="161">
                  <c:v>18.353909465020578</c:v>
                </c:pt>
                <c:pt idx="162">
                  <c:v>21.069324875396465</c:v>
                </c:pt>
                <c:pt idx="163">
                  <c:v>21.208608071878846</c:v>
                </c:pt>
                <c:pt idx="164">
                  <c:v>26.758444293989317</c:v>
                </c:pt>
                <c:pt idx="165">
                  <c:v>17.731716147719045</c:v>
                </c:pt>
                <c:pt idx="166">
                  <c:v>47.796934865900376</c:v>
                </c:pt>
                <c:pt idx="167">
                  <c:v>31.97719908377568</c:v>
                </c:pt>
                <c:pt idx="168">
                  <c:v>44.30103617524086</c:v>
                </c:pt>
                <c:pt idx="169">
                  <c:v>32.386442561466872</c:v>
                </c:pt>
                <c:pt idx="170">
                  <c:v>31.838260278627253</c:v>
                </c:pt>
                <c:pt idx="171">
                  <c:v>24.398541919805592</c:v>
                </c:pt>
                <c:pt idx="172">
                  <c:v>21.001378043178686</c:v>
                </c:pt>
                <c:pt idx="173">
                  <c:v>31.071206027304136</c:v>
                </c:pt>
                <c:pt idx="174">
                  <c:v>23.513666352497644</c:v>
                </c:pt>
                <c:pt idx="175">
                  <c:v>30.929274355569181</c:v>
                </c:pt>
                <c:pt idx="176">
                  <c:v>19.340025630072617</c:v>
                </c:pt>
                <c:pt idx="177">
                  <c:v>26.928305991117554</c:v>
                </c:pt>
                <c:pt idx="178">
                  <c:v>25.711387268577226</c:v>
                </c:pt>
                <c:pt idx="179">
                  <c:v>21.801173299508481</c:v>
                </c:pt>
                <c:pt idx="180">
                  <c:v>29.129444761474979</c:v>
                </c:pt>
                <c:pt idx="181">
                  <c:v>25.39465991034886</c:v>
                </c:pt>
                <c:pt idx="182">
                  <c:v>45.350469813154767</c:v>
                </c:pt>
                <c:pt idx="183">
                  <c:v>37.065088757396452</c:v>
                </c:pt>
                <c:pt idx="184">
                  <c:v>21.942373564376386</c:v>
                </c:pt>
                <c:pt idx="185">
                  <c:v>43.700652248541026</c:v>
                </c:pt>
                <c:pt idx="186">
                  <c:v>41.944349020955002</c:v>
                </c:pt>
                <c:pt idx="187">
                  <c:v>26.527135556096372</c:v>
                </c:pt>
                <c:pt idx="188">
                  <c:v>35.742491324638024</c:v>
                </c:pt>
                <c:pt idx="189">
                  <c:v>24.571428571428573</c:v>
                </c:pt>
                <c:pt idx="190">
                  <c:v>16.419567993780888</c:v>
                </c:pt>
                <c:pt idx="191">
                  <c:v>30.817531081250788</c:v>
                </c:pt>
                <c:pt idx="192">
                  <c:v>24.778725937686051</c:v>
                </c:pt>
                <c:pt idx="193">
                  <c:v>11.627906976744185</c:v>
                </c:pt>
                <c:pt idx="194">
                  <c:v>28.864376831372866</c:v>
                </c:pt>
                <c:pt idx="195">
                  <c:v>28.942315719175223</c:v>
                </c:pt>
                <c:pt idx="196">
                  <c:v>20.883078247935178</c:v>
                </c:pt>
                <c:pt idx="197">
                  <c:v>51.741960650462012</c:v>
                </c:pt>
                <c:pt idx="198">
                  <c:v>28.411425028097511</c:v>
                </c:pt>
                <c:pt idx="199">
                  <c:v>41.766717601688136</c:v>
                </c:pt>
                <c:pt idx="200">
                  <c:v>40.864339598516807</c:v>
                </c:pt>
                <c:pt idx="201">
                  <c:v>37.256033073742913</c:v>
                </c:pt>
                <c:pt idx="202">
                  <c:v>37.751422389614554</c:v>
                </c:pt>
                <c:pt idx="203">
                  <c:v>35.776036741861404</c:v>
                </c:pt>
                <c:pt idx="204">
                  <c:v>46.214145733119544</c:v>
                </c:pt>
                <c:pt idx="205">
                  <c:v>37.857726901062961</c:v>
                </c:pt>
                <c:pt idx="206">
                  <c:v>42.973484848484851</c:v>
                </c:pt>
                <c:pt idx="207">
                  <c:v>34.861455401070806</c:v>
                </c:pt>
                <c:pt idx="208">
                  <c:v>30.218653911855146</c:v>
                </c:pt>
                <c:pt idx="209">
                  <c:v>31.073046074437666</c:v>
                </c:pt>
                <c:pt idx="210">
                  <c:v>30.17995431500362</c:v>
                </c:pt>
                <c:pt idx="211">
                  <c:v>24.998821032775286</c:v>
                </c:pt>
                <c:pt idx="212">
                  <c:v>42.214389670298978</c:v>
                </c:pt>
                <c:pt idx="213">
                  <c:v>39.797613653526653</c:v>
                </c:pt>
                <c:pt idx="214">
                  <c:v>36.680327868852459</c:v>
                </c:pt>
                <c:pt idx="215">
                  <c:v>36.894908452470531</c:v>
                </c:pt>
                <c:pt idx="216">
                  <c:v>12.74157053303164</c:v>
                </c:pt>
                <c:pt idx="217">
                  <c:v>30.047740066028553</c:v>
                </c:pt>
                <c:pt idx="218">
                  <c:v>32.97899266008605</c:v>
                </c:pt>
                <c:pt idx="219">
                  <c:v>33.712362412444278</c:v>
                </c:pt>
                <c:pt idx="220">
                  <c:v>26.464386058549259</c:v>
                </c:pt>
                <c:pt idx="221">
                  <c:v>31.976471813023792</c:v>
                </c:pt>
                <c:pt idx="222">
                  <c:v>40.232320556963941</c:v>
                </c:pt>
                <c:pt idx="223">
                  <c:v>29.649868447682657</c:v>
                </c:pt>
                <c:pt idx="224">
                  <c:v>36.249430449781954</c:v>
                </c:pt>
                <c:pt idx="225">
                  <c:v>22.869087732434796</c:v>
                </c:pt>
                <c:pt idx="226">
                  <c:v>33.587841244687752</c:v>
                </c:pt>
                <c:pt idx="227">
                  <c:v>20.463137996219281</c:v>
                </c:pt>
                <c:pt idx="228">
                  <c:v>36.174404659928044</c:v>
                </c:pt>
                <c:pt idx="229">
                  <c:v>28.907508862391239</c:v>
                </c:pt>
                <c:pt idx="230">
                  <c:v>28.556836422004956</c:v>
                </c:pt>
                <c:pt idx="231">
                  <c:v>40.552315367858895</c:v>
                </c:pt>
                <c:pt idx="232">
                  <c:v>28.343313373253491</c:v>
                </c:pt>
                <c:pt idx="233">
                  <c:v>36.868812910739543</c:v>
                </c:pt>
                <c:pt idx="234">
                  <c:v>28.571818752901976</c:v>
                </c:pt>
                <c:pt idx="235">
                  <c:v>46.941035879798306</c:v>
                </c:pt>
                <c:pt idx="236">
                  <c:v>22.063999631921604</c:v>
                </c:pt>
                <c:pt idx="237">
                  <c:v>35.139010155783282</c:v>
                </c:pt>
                <c:pt idx="238">
                  <c:v>32.253789447527538</c:v>
                </c:pt>
                <c:pt idx="239">
                  <c:v>35.663837616475753</c:v>
                </c:pt>
                <c:pt idx="240">
                  <c:v>34.612172009562485</c:v>
                </c:pt>
                <c:pt idx="241">
                  <c:v>45.47968885047537</c:v>
                </c:pt>
                <c:pt idx="242">
                  <c:v>40.249585545964663</c:v>
                </c:pt>
                <c:pt idx="243">
                  <c:v>38.813334938019011</c:v>
                </c:pt>
                <c:pt idx="244">
                  <c:v>31.190929617755067</c:v>
                </c:pt>
                <c:pt idx="245">
                  <c:v>36.304753540454492</c:v>
                </c:pt>
                <c:pt idx="246">
                  <c:v>31.515910141338733</c:v>
                </c:pt>
                <c:pt idx="247">
                  <c:v>47.645211930926216</c:v>
                </c:pt>
                <c:pt idx="248">
                  <c:v>42.262948207171313</c:v>
                </c:pt>
                <c:pt idx="249">
                  <c:v>43.28107502799552</c:v>
                </c:pt>
                <c:pt idx="250">
                  <c:v>50.441348505796022</c:v>
                </c:pt>
                <c:pt idx="251">
                  <c:v>27.802998110418653</c:v>
                </c:pt>
                <c:pt idx="252">
                  <c:v>34.027364663890545</c:v>
                </c:pt>
                <c:pt idx="253">
                  <c:v>22.803738317757013</c:v>
                </c:pt>
                <c:pt idx="254">
                  <c:v>26.096140731137744</c:v>
                </c:pt>
                <c:pt idx="255">
                  <c:v>29.950828960088984</c:v>
                </c:pt>
                <c:pt idx="256">
                  <c:v>31.274615109201577</c:v>
                </c:pt>
                <c:pt idx="257">
                  <c:v>29.216179827899083</c:v>
                </c:pt>
                <c:pt idx="258">
                  <c:v>25.787615426398698</c:v>
                </c:pt>
                <c:pt idx="259">
                  <c:v>33.449401523394997</c:v>
                </c:pt>
                <c:pt idx="260">
                  <c:v>29.394362559573423</c:v>
                </c:pt>
                <c:pt idx="261">
                  <c:v>33.255203450215639</c:v>
                </c:pt>
                <c:pt idx="262">
                  <c:v>32.751993322643706</c:v>
                </c:pt>
                <c:pt idx="263">
                  <c:v>28.03901950975488</c:v>
                </c:pt>
                <c:pt idx="264">
                  <c:v>32.621533177997712</c:v>
                </c:pt>
                <c:pt idx="265">
                  <c:v>33.019341873901027</c:v>
                </c:pt>
                <c:pt idx="266">
                  <c:v>20.859828158441641</c:v>
                </c:pt>
                <c:pt idx="267">
                  <c:v>34.724790841039187</c:v>
                </c:pt>
                <c:pt idx="268">
                  <c:v>30.796554867622</c:v>
                </c:pt>
                <c:pt idx="269">
                  <c:v>37.131958517105737</c:v>
                </c:pt>
                <c:pt idx="270">
                  <c:v>24.96264930232444</c:v>
                </c:pt>
                <c:pt idx="271">
                  <c:v>43.338437978560492</c:v>
                </c:pt>
                <c:pt idx="272">
                  <c:v>21.062845200776234</c:v>
                </c:pt>
                <c:pt idx="273">
                  <c:v>21.014925373134332</c:v>
                </c:pt>
                <c:pt idx="274">
                  <c:v>18.518518518518515</c:v>
                </c:pt>
                <c:pt idx="275">
                  <c:v>16.166051876573569</c:v>
                </c:pt>
                <c:pt idx="276">
                  <c:v>37.932126876014728</c:v>
                </c:pt>
                <c:pt idx="277">
                  <c:v>41.754822650902305</c:v>
                </c:pt>
                <c:pt idx="278">
                  <c:v>37.347458763577848</c:v>
                </c:pt>
                <c:pt idx="279">
                  <c:v>40.093625940311043</c:v>
                </c:pt>
                <c:pt idx="280">
                  <c:v>29.232907653548782</c:v>
                </c:pt>
                <c:pt idx="281">
                  <c:v>33.410106407480768</c:v>
                </c:pt>
                <c:pt idx="282">
                  <c:v>26.871368738952491</c:v>
                </c:pt>
                <c:pt idx="283">
                  <c:v>33.195439047925376</c:v>
                </c:pt>
                <c:pt idx="284">
                  <c:v>29.413277938594469</c:v>
                </c:pt>
                <c:pt idx="285">
                  <c:v>29.998737298847061</c:v>
                </c:pt>
                <c:pt idx="286">
                  <c:v>28.259495209842918</c:v>
                </c:pt>
                <c:pt idx="287">
                  <c:v>27.457443668208207</c:v>
                </c:pt>
                <c:pt idx="288">
                  <c:v>23.730927933979459</c:v>
                </c:pt>
                <c:pt idx="289">
                  <c:v>31.334683071172712</c:v>
                </c:pt>
                <c:pt idx="290">
                  <c:v>18.034194148365405</c:v>
                </c:pt>
                <c:pt idx="291">
                  <c:v>28.854645132612234</c:v>
                </c:pt>
                <c:pt idx="292">
                  <c:v>43.650508677438658</c:v>
                </c:pt>
                <c:pt idx="293">
                  <c:v>23.729642832180055</c:v>
                </c:pt>
                <c:pt idx="294">
                  <c:v>24.082485465116278</c:v>
                </c:pt>
                <c:pt idx="295">
                  <c:v>29.574514991181658</c:v>
                </c:pt>
                <c:pt idx="296">
                  <c:v>48.951317014402271</c:v>
                </c:pt>
                <c:pt idx="297">
                  <c:v>37.100266908395028</c:v>
                </c:pt>
                <c:pt idx="298">
                  <c:v>27.392938939544528</c:v>
                </c:pt>
                <c:pt idx="299">
                  <c:v>33.830066996431022</c:v>
                </c:pt>
                <c:pt idx="300">
                  <c:v>29.256080188890039</c:v>
                </c:pt>
                <c:pt idx="301">
                  <c:v>18.36643606337871</c:v>
                </c:pt>
                <c:pt idx="302">
                  <c:v>33.824140592531023</c:v>
                </c:pt>
                <c:pt idx="303">
                  <c:v>32.896049098580747</c:v>
                </c:pt>
                <c:pt idx="304">
                  <c:v>43.740733812936924</c:v>
                </c:pt>
                <c:pt idx="305">
                  <c:v>23.380027112516949</c:v>
                </c:pt>
                <c:pt idx="306">
                  <c:v>23.283582089552237</c:v>
                </c:pt>
                <c:pt idx="307">
                  <c:v>22.0008172487561</c:v>
                </c:pt>
                <c:pt idx="308">
                  <c:v>18.031497997592197</c:v>
                </c:pt>
                <c:pt idx="309">
                  <c:v>28.989225243714728</c:v>
                </c:pt>
                <c:pt idx="310">
                  <c:v>16.801510205250793</c:v>
                </c:pt>
                <c:pt idx="311">
                  <c:v>32.321092278719391</c:v>
                </c:pt>
                <c:pt idx="312">
                  <c:v>35.825140164134233</c:v>
                </c:pt>
                <c:pt idx="313">
                  <c:v>31.003701284563462</c:v>
                </c:pt>
                <c:pt idx="314">
                  <c:v>41.371201157742398</c:v>
                </c:pt>
                <c:pt idx="315">
                  <c:v>27.165133255582909</c:v>
                </c:pt>
                <c:pt idx="316">
                  <c:v>28.547223701408726</c:v>
                </c:pt>
                <c:pt idx="317">
                  <c:v>30.512430238457632</c:v>
                </c:pt>
                <c:pt idx="318">
                  <c:v>27.439061855101503</c:v>
                </c:pt>
                <c:pt idx="319">
                  <c:v>21.967495425680767</c:v>
                </c:pt>
                <c:pt idx="320">
                  <c:v>18.981987380591491</c:v>
                </c:pt>
                <c:pt idx="321">
                  <c:v>38.574110890214271</c:v>
                </c:pt>
                <c:pt idx="322">
                  <c:v>29.529124520404604</c:v>
                </c:pt>
                <c:pt idx="323">
                  <c:v>34.447603307033354</c:v>
                </c:pt>
                <c:pt idx="324">
                  <c:v>32.381210234195208</c:v>
                </c:pt>
                <c:pt idx="325">
                  <c:v>29.847302626059239</c:v>
                </c:pt>
                <c:pt idx="326">
                  <c:v>22.086263329448919</c:v>
                </c:pt>
                <c:pt idx="327">
                  <c:v>31.791221826809021</c:v>
                </c:pt>
                <c:pt idx="328">
                  <c:v>33.573902537253325</c:v>
                </c:pt>
                <c:pt idx="329">
                  <c:v>29.061784922475706</c:v>
                </c:pt>
                <c:pt idx="330">
                  <c:v>28.318987477542706</c:v>
                </c:pt>
                <c:pt idx="331">
                  <c:v>27.852412488174078</c:v>
                </c:pt>
                <c:pt idx="332">
                  <c:v>25.882396975708353</c:v>
                </c:pt>
                <c:pt idx="333">
                  <c:v>26.355508161758678</c:v>
                </c:pt>
                <c:pt idx="334">
                  <c:v>38.394425931535899</c:v>
                </c:pt>
                <c:pt idx="335">
                  <c:v>27.924217462932454</c:v>
                </c:pt>
                <c:pt idx="336">
                  <c:v>33.936723432972094</c:v>
                </c:pt>
                <c:pt idx="337">
                  <c:v>51.686650679456434</c:v>
                </c:pt>
                <c:pt idx="338">
                  <c:v>20.214590387406005</c:v>
                </c:pt>
                <c:pt idx="339">
                  <c:v>32.057805821290451</c:v>
                </c:pt>
                <c:pt idx="340">
                  <c:v>28.729347438488055</c:v>
                </c:pt>
                <c:pt idx="341">
                  <c:v>20.214729072303307</c:v>
                </c:pt>
                <c:pt idx="342">
                  <c:v>30.557546681949507</c:v>
                </c:pt>
                <c:pt idx="343">
                  <c:v>42.069847888925743</c:v>
                </c:pt>
                <c:pt idx="344">
                  <c:v>29.403450159015712</c:v>
                </c:pt>
                <c:pt idx="345">
                  <c:v>25.384979240027331</c:v>
                </c:pt>
                <c:pt idx="346">
                  <c:v>22.080518130572102</c:v>
                </c:pt>
                <c:pt idx="347">
                  <c:v>28.187618941005258</c:v>
                </c:pt>
                <c:pt idx="348">
                  <c:v>23.338424875563135</c:v>
                </c:pt>
                <c:pt idx="349">
                  <c:v>26.79371346139245</c:v>
                </c:pt>
                <c:pt idx="350">
                  <c:v>27.554804069888167</c:v>
                </c:pt>
                <c:pt idx="351">
                  <c:v>30.332373724155978</c:v>
                </c:pt>
                <c:pt idx="352">
                  <c:v>28.17243097192339</c:v>
                </c:pt>
                <c:pt idx="353">
                  <c:v>26.549543218552351</c:v>
                </c:pt>
                <c:pt idx="354">
                  <c:v>26.979960627933973</c:v>
                </c:pt>
                <c:pt idx="355">
                  <c:v>20.566430653894212</c:v>
                </c:pt>
                <c:pt idx="356">
                  <c:v>21.919634355360884</c:v>
                </c:pt>
                <c:pt idx="357">
                  <c:v>15.34255387584432</c:v>
                </c:pt>
                <c:pt idx="358">
                  <c:v>28.998410174880764</c:v>
                </c:pt>
                <c:pt idx="359">
                  <c:v>21.757271815446337</c:v>
                </c:pt>
                <c:pt idx="360">
                  <c:v>30.670175768399282</c:v>
                </c:pt>
                <c:pt idx="361">
                  <c:v>20.99519860323003</c:v>
                </c:pt>
                <c:pt idx="362">
                  <c:v>19.68033253174049</c:v>
                </c:pt>
                <c:pt idx="363">
                  <c:v>22.646813827571844</c:v>
                </c:pt>
                <c:pt idx="364">
                  <c:v>24.695863746958633</c:v>
                </c:pt>
                <c:pt idx="365">
                  <c:v>30.441474147814525</c:v>
                </c:pt>
                <c:pt idx="366">
                  <c:v>20.343563733293841</c:v>
                </c:pt>
                <c:pt idx="367">
                  <c:v>15.73644770807749</c:v>
                </c:pt>
                <c:pt idx="368">
                  <c:v>23.495499140285222</c:v>
                </c:pt>
                <c:pt idx="369">
                  <c:v>23.924601256645719</c:v>
                </c:pt>
                <c:pt idx="370">
                  <c:v>29.535993501878359</c:v>
                </c:pt>
                <c:pt idx="371">
                  <c:v>23.414110050157745</c:v>
                </c:pt>
                <c:pt idx="372">
                  <c:v>18.853518148713736</c:v>
                </c:pt>
                <c:pt idx="373">
                  <c:v>24.349345803221389</c:v>
                </c:pt>
                <c:pt idx="374">
                  <c:v>33.318704467655579</c:v>
                </c:pt>
                <c:pt idx="375">
                  <c:v>24.821570182394925</c:v>
                </c:pt>
                <c:pt idx="376">
                  <c:v>26.210254941277569</c:v>
                </c:pt>
                <c:pt idx="377">
                  <c:v>24.971573389692871</c:v>
                </c:pt>
                <c:pt idx="378">
                  <c:v>20.217560097275076</c:v>
                </c:pt>
                <c:pt idx="379">
                  <c:v>33.165076768664235</c:v>
                </c:pt>
                <c:pt idx="380">
                  <c:v>26.181880694516074</c:v>
                </c:pt>
                <c:pt idx="381">
                  <c:v>21.95121951219512</c:v>
                </c:pt>
                <c:pt idx="382">
                  <c:v>22.68049724211739</c:v>
                </c:pt>
                <c:pt idx="383">
                  <c:v>20.077819736844162</c:v>
                </c:pt>
                <c:pt idx="384">
                  <c:v>15.248065543923529</c:v>
                </c:pt>
                <c:pt idx="385">
                  <c:v>30.741052442646257</c:v>
                </c:pt>
                <c:pt idx="386">
                  <c:v>21.137047532793829</c:v>
                </c:pt>
                <c:pt idx="387">
                  <c:v>18.769335704367737</c:v>
                </c:pt>
                <c:pt idx="388">
                  <c:v>21.890205677781427</c:v>
                </c:pt>
                <c:pt idx="389">
                  <c:v>16.018834473950086</c:v>
                </c:pt>
                <c:pt idx="390">
                  <c:v>23.583635422061111</c:v>
                </c:pt>
                <c:pt idx="391">
                  <c:v>27.457244878782188</c:v>
                </c:pt>
                <c:pt idx="392">
                  <c:v>19.492235324441012</c:v>
                </c:pt>
                <c:pt idx="393">
                  <c:v>28.393341076267905</c:v>
                </c:pt>
                <c:pt idx="394">
                  <c:v>28.978523410077933</c:v>
                </c:pt>
                <c:pt idx="395">
                  <c:v>38.132001211020281</c:v>
                </c:pt>
                <c:pt idx="396">
                  <c:v>22.014364912472352</c:v>
                </c:pt>
                <c:pt idx="397">
                  <c:v>17.593809315228501</c:v>
                </c:pt>
                <c:pt idx="398">
                  <c:v>20.171878730007158</c:v>
                </c:pt>
                <c:pt idx="399">
                  <c:v>26.150225534418514</c:v>
                </c:pt>
                <c:pt idx="400">
                  <c:v>18.258982795681025</c:v>
                </c:pt>
                <c:pt idx="401">
                  <c:v>25.290503133175147</c:v>
                </c:pt>
                <c:pt idx="402">
                  <c:v>20.175344809152143</c:v>
                </c:pt>
                <c:pt idx="403">
                  <c:v>46.046110751993105</c:v>
                </c:pt>
                <c:pt idx="404">
                  <c:v>13.176612417118749</c:v>
                </c:pt>
                <c:pt idx="405">
                  <c:v>12.989938429193572</c:v>
                </c:pt>
                <c:pt idx="406">
                  <c:v>25.149377522044539</c:v>
                </c:pt>
                <c:pt idx="407">
                  <c:v>19.817700242600083</c:v>
                </c:pt>
                <c:pt idx="408">
                  <c:v>20.944934287140242</c:v>
                </c:pt>
                <c:pt idx="409">
                  <c:v>16.29951364144711</c:v>
                </c:pt>
                <c:pt idx="410">
                  <c:v>22.091137000442412</c:v>
                </c:pt>
                <c:pt idx="411">
                  <c:v>23.894668400520157</c:v>
                </c:pt>
                <c:pt idx="412">
                  <c:v>19.15125484791179</c:v>
                </c:pt>
                <c:pt idx="413">
                  <c:v>21.638237759286632</c:v>
                </c:pt>
                <c:pt idx="414">
                  <c:v>25.811871811321904</c:v>
                </c:pt>
                <c:pt idx="415">
                  <c:v>16.372237415921354</c:v>
                </c:pt>
                <c:pt idx="416">
                  <c:v>18.894622939903446</c:v>
                </c:pt>
                <c:pt idx="417">
                  <c:v>20.917518421678153</c:v>
                </c:pt>
                <c:pt idx="418">
                  <c:v>22.748035812168826</c:v>
                </c:pt>
                <c:pt idx="419">
                  <c:v>20.318471337579624</c:v>
                </c:pt>
                <c:pt idx="420">
                  <c:v>20.575426921759554</c:v>
                </c:pt>
                <c:pt idx="421">
                  <c:v>16.825483256193845</c:v>
                </c:pt>
                <c:pt idx="422">
                  <c:v>17.761686721328932</c:v>
                </c:pt>
                <c:pt idx="423">
                  <c:v>19.656316909077603</c:v>
                </c:pt>
                <c:pt idx="424">
                  <c:v>30.360772357723576</c:v>
                </c:pt>
                <c:pt idx="425">
                  <c:v>19.201396465197469</c:v>
                </c:pt>
                <c:pt idx="426">
                  <c:v>20.823468862583631</c:v>
                </c:pt>
                <c:pt idx="427">
                  <c:v>14.553642384105963</c:v>
                </c:pt>
                <c:pt idx="428">
                  <c:v>19.518407038666361</c:v>
                </c:pt>
                <c:pt idx="429">
                  <c:v>21.393558159594388</c:v>
                </c:pt>
                <c:pt idx="430">
                  <c:v>28.11091854419411</c:v>
                </c:pt>
                <c:pt idx="431">
                  <c:v>23.119584055459267</c:v>
                </c:pt>
                <c:pt idx="432">
                  <c:v>19.160197876189933</c:v>
                </c:pt>
                <c:pt idx="433">
                  <c:v>14.948498225569113</c:v>
                </c:pt>
                <c:pt idx="434">
                  <c:v>16.503789047766006</c:v>
                </c:pt>
                <c:pt idx="435">
                  <c:v>17.055843475222733</c:v>
                </c:pt>
                <c:pt idx="436">
                  <c:v>15.748491337356432</c:v>
                </c:pt>
                <c:pt idx="437">
                  <c:v>10.502451626509201</c:v>
                </c:pt>
                <c:pt idx="438">
                  <c:v>17.640822315807121</c:v>
                </c:pt>
                <c:pt idx="439">
                  <c:v>29.665809768637533</c:v>
                </c:pt>
                <c:pt idx="440">
                  <c:v>36.29219503482765</c:v>
                </c:pt>
                <c:pt idx="441">
                  <c:v>24.883572276504427</c:v>
                </c:pt>
                <c:pt idx="442">
                  <c:v>34.300798158480752</c:v>
                </c:pt>
                <c:pt idx="443">
                  <c:v>38.237097746506159</c:v>
                </c:pt>
                <c:pt idx="444">
                  <c:v>18.315695902769093</c:v>
                </c:pt>
                <c:pt idx="445">
                  <c:v>26.11353740103025</c:v>
                </c:pt>
                <c:pt idx="446">
                  <c:v>31.881285258768695</c:v>
                </c:pt>
                <c:pt idx="447">
                  <c:v>34.639608117564734</c:v>
                </c:pt>
                <c:pt idx="448">
                  <c:v>24.716223698781839</c:v>
                </c:pt>
                <c:pt idx="449">
                  <c:v>17.100592245365078</c:v>
                </c:pt>
                <c:pt idx="450">
                  <c:v>47.589229805886042</c:v>
                </c:pt>
                <c:pt idx="451">
                  <c:v>29.670100498935838</c:v>
                </c:pt>
                <c:pt idx="452">
                  <c:v>23.725629898309474</c:v>
                </c:pt>
                <c:pt idx="453">
                  <c:v>30.924076715802819</c:v>
                </c:pt>
                <c:pt idx="454">
                  <c:v>43.595349299413705</c:v>
                </c:pt>
                <c:pt idx="455">
                  <c:v>21.09010420522776</c:v>
                </c:pt>
                <c:pt idx="456">
                  <c:v>24.431089218403446</c:v>
                </c:pt>
                <c:pt idx="457">
                  <c:v>8.4998450545353155</c:v>
                </c:pt>
                <c:pt idx="458">
                  <c:v>9.0514900102939571</c:v>
                </c:pt>
                <c:pt idx="459">
                  <c:v>16.388645010242904</c:v>
                </c:pt>
                <c:pt idx="460">
                  <c:v>9.728663870913987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997760"/>
        <c:axId val="83154432"/>
      </c:scatterChart>
      <c:valAx>
        <c:axId val="809977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BMI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3154432"/>
        <c:crosses val="autoZero"/>
        <c:crossBetween val="midCat"/>
      </c:valAx>
      <c:valAx>
        <c:axId val="831544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rtl="0">
                  <a:defRPr/>
                </a:pPr>
                <a:r>
                  <a:rPr lang="en-US"/>
                  <a:t>% Methylation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8099776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e-IL" smtClean="0"/>
              <a:t>לחץ כדי לערוך סגנון כותרת משנה של תבנית בסיס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A982A-06DA-45A0-AB3B-6CF686834ED1}" type="datetimeFigureOut">
              <a:rPr lang="he-IL" smtClean="0"/>
              <a:t>ט'/חשון/תשע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8B589-6AA4-45B2-874A-3B128FCF280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97125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A982A-06DA-45A0-AB3B-6CF686834ED1}" type="datetimeFigureOut">
              <a:rPr lang="he-IL" smtClean="0"/>
              <a:t>ט'/חשון/תשע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8B589-6AA4-45B2-874A-3B128FCF280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46423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A982A-06DA-45A0-AB3B-6CF686834ED1}" type="datetimeFigureOut">
              <a:rPr lang="he-IL" smtClean="0"/>
              <a:t>ט'/חשון/תשע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8B589-6AA4-45B2-874A-3B128FCF280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7538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A982A-06DA-45A0-AB3B-6CF686834ED1}" type="datetimeFigureOut">
              <a:rPr lang="he-IL" smtClean="0"/>
              <a:t>ט'/חשון/תשע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8B589-6AA4-45B2-874A-3B128FCF280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88518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A982A-06DA-45A0-AB3B-6CF686834ED1}" type="datetimeFigureOut">
              <a:rPr lang="he-IL" smtClean="0"/>
              <a:t>ט'/חשון/תשע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8B589-6AA4-45B2-874A-3B128FCF280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751041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A982A-06DA-45A0-AB3B-6CF686834ED1}" type="datetimeFigureOut">
              <a:rPr lang="he-IL" smtClean="0"/>
              <a:t>ט'/חשון/תשע"ה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8B589-6AA4-45B2-874A-3B128FCF280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53698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A982A-06DA-45A0-AB3B-6CF686834ED1}" type="datetimeFigureOut">
              <a:rPr lang="he-IL" smtClean="0"/>
              <a:t>ט'/חשון/תשע"ה</a:t>
            </a:fld>
            <a:endParaRPr lang="he-IL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8B589-6AA4-45B2-874A-3B128FCF280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156543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A982A-06DA-45A0-AB3B-6CF686834ED1}" type="datetimeFigureOut">
              <a:rPr lang="he-IL" smtClean="0"/>
              <a:t>ט'/חשון/תשע"ה</a:t>
            </a:fld>
            <a:endParaRPr lang="he-IL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8B589-6AA4-45B2-874A-3B128FCF280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49718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A982A-06DA-45A0-AB3B-6CF686834ED1}" type="datetimeFigureOut">
              <a:rPr lang="he-IL" smtClean="0"/>
              <a:t>ט'/חשון/תשע"ה</a:t>
            </a:fld>
            <a:endParaRPr lang="he-IL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8B589-6AA4-45B2-874A-3B128FCF280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66608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A982A-06DA-45A0-AB3B-6CF686834ED1}" type="datetimeFigureOut">
              <a:rPr lang="he-IL" smtClean="0"/>
              <a:t>ט'/חשון/תשע"ה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8B589-6AA4-45B2-874A-3B128FCF280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21634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A982A-06DA-45A0-AB3B-6CF686834ED1}" type="datetimeFigureOut">
              <a:rPr lang="he-IL" smtClean="0"/>
              <a:t>ט'/חשון/תשע"ה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F8B589-6AA4-45B2-874A-3B128FCF280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53863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1A982A-06DA-45A0-AB3B-6CF686834ED1}" type="datetimeFigureOut">
              <a:rPr lang="he-IL" smtClean="0"/>
              <a:t>ט'/חשון/תשע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8B589-6AA4-45B2-874A-3B128FCF280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21078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תרשים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6530366"/>
              </p:ext>
            </p:extLst>
          </p:nvPr>
        </p:nvGraphicFramePr>
        <p:xfrm>
          <a:off x="267890" y="667939"/>
          <a:ext cx="386953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תרשים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9831460"/>
              </p:ext>
            </p:extLst>
          </p:nvPr>
        </p:nvGraphicFramePr>
        <p:xfrm>
          <a:off x="5006578" y="667939"/>
          <a:ext cx="386953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תרשים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2659389"/>
              </p:ext>
            </p:extLst>
          </p:nvPr>
        </p:nvGraphicFramePr>
        <p:xfrm>
          <a:off x="5006578" y="3664744"/>
          <a:ext cx="386953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843808" y="1023119"/>
            <a:ext cx="11521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/>
            <a:r>
              <a:rPr lang="en-US" sz="1200" dirty="0" smtClean="0"/>
              <a:t>r= -0.041</a:t>
            </a:r>
          </a:p>
          <a:p>
            <a:pPr algn="ctr" rtl="0"/>
            <a:r>
              <a:rPr lang="en-US" sz="1200" dirty="0" smtClean="0"/>
              <a:t>n= 928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740352" y="1023119"/>
            <a:ext cx="11521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/>
            <a:r>
              <a:rPr lang="en-US" sz="1200" dirty="0" smtClean="0"/>
              <a:t>r= -0.024</a:t>
            </a:r>
          </a:p>
          <a:p>
            <a:pPr algn="ctr" rtl="0"/>
            <a:r>
              <a:rPr lang="en-US" sz="1200" dirty="0" smtClean="0"/>
              <a:t>n= 468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740352" y="4149080"/>
            <a:ext cx="11521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/>
            <a:r>
              <a:rPr lang="en-US" sz="1200" dirty="0" smtClean="0"/>
              <a:t>r= 0.022</a:t>
            </a:r>
          </a:p>
          <a:p>
            <a:pPr algn="ctr" rtl="0"/>
            <a:r>
              <a:rPr lang="en-US" sz="1200" dirty="0" smtClean="0"/>
              <a:t>n= 460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95536" y="260648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dirty="0" smtClean="0"/>
              <a:t>A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5148064" y="334770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dirty="0" smtClean="0"/>
              <a:t>C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5148064" y="260648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dirty="0" smtClean="0"/>
              <a:t>B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47450595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</TotalTime>
  <Words>49</Words>
  <Application>Microsoft Office PowerPoint</Application>
  <PresentationFormat>‫הצגה על המסך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1</vt:i4>
      </vt:variant>
    </vt:vector>
  </HeadingPairs>
  <TitlesOfParts>
    <vt:vector size="2" baseType="lpstr">
      <vt:lpstr>ערכת נושא Office</vt:lpstr>
      <vt:lpstr>מצגת של PowerPoint</vt:lpstr>
    </vt:vector>
  </TitlesOfParts>
  <Company>MOA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</dc:title>
  <dc:creator>גדעון טופורוב[Gidon Toperoff]</dc:creator>
  <cp:lastModifiedBy>Efrat Degani Toperoff</cp:lastModifiedBy>
  <cp:revision>7</cp:revision>
  <dcterms:created xsi:type="dcterms:W3CDTF">2014-10-19T09:11:20Z</dcterms:created>
  <dcterms:modified xsi:type="dcterms:W3CDTF">2014-11-02T00:00:54Z</dcterms:modified>
</cp:coreProperties>
</file>